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0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2021" autoAdjust="0"/>
  </p:normalViewPr>
  <p:slideViewPr>
    <p:cSldViewPr snapToGrid="0">
      <p:cViewPr varScale="1">
        <p:scale>
          <a:sx n="93" d="100"/>
          <a:sy n="93" d="100"/>
        </p:scale>
        <p:origin x="121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rashanth Anamthathmakula" userId="acd106aa-3bb0-4d16-b474-a7fd34266ac2" providerId="ADAL" clId="{17583561-CD62-4C58-B47B-1822B513A6A2}"/>
    <pc:docChg chg="custSel addSld modSld">
      <pc:chgData name="Prashanth Anamthathmakula" userId="acd106aa-3bb0-4d16-b474-a7fd34266ac2" providerId="ADAL" clId="{17583561-CD62-4C58-B47B-1822B513A6A2}" dt="2022-10-15T21:08:35.420" v="14" actId="1076"/>
      <pc:docMkLst>
        <pc:docMk/>
      </pc:docMkLst>
      <pc:sldChg chg="addSp delSp modSp new mod">
        <pc:chgData name="Prashanth Anamthathmakula" userId="acd106aa-3bb0-4d16-b474-a7fd34266ac2" providerId="ADAL" clId="{17583561-CD62-4C58-B47B-1822B513A6A2}" dt="2022-10-15T21:07:11.755" v="5" actId="1076"/>
        <pc:sldMkLst>
          <pc:docMk/>
          <pc:sldMk cId="2091280263" sldId="269"/>
        </pc:sldMkLst>
        <pc:spChg chg="del">
          <ac:chgData name="Prashanth Anamthathmakula" userId="acd106aa-3bb0-4d16-b474-a7fd34266ac2" providerId="ADAL" clId="{17583561-CD62-4C58-B47B-1822B513A6A2}" dt="2022-10-15T21:06:08.805" v="1" actId="478"/>
          <ac:spMkLst>
            <pc:docMk/>
            <pc:sldMk cId="2091280263" sldId="269"/>
            <ac:spMk id="2" creationId="{759CD018-04C3-FBA8-5F26-737A90538CA1}"/>
          </ac:spMkLst>
        </pc:spChg>
        <pc:spChg chg="del">
          <ac:chgData name="Prashanth Anamthathmakula" userId="acd106aa-3bb0-4d16-b474-a7fd34266ac2" providerId="ADAL" clId="{17583561-CD62-4C58-B47B-1822B513A6A2}" dt="2022-10-15T21:06:08.805" v="1" actId="478"/>
          <ac:spMkLst>
            <pc:docMk/>
            <pc:sldMk cId="2091280263" sldId="269"/>
            <ac:spMk id="3" creationId="{710AA6E5-2542-E2B4-84E0-9ACDE1D17B2A}"/>
          </ac:spMkLst>
        </pc:spChg>
        <pc:graphicFrameChg chg="add mod">
          <ac:chgData name="Prashanth Anamthathmakula" userId="acd106aa-3bb0-4d16-b474-a7fd34266ac2" providerId="ADAL" clId="{17583561-CD62-4C58-B47B-1822B513A6A2}" dt="2022-10-15T21:06:49.778" v="3" actId="1076"/>
          <ac:graphicFrameMkLst>
            <pc:docMk/>
            <pc:sldMk cId="2091280263" sldId="269"/>
            <ac:graphicFrameMk id="4" creationId="{D0BB2CFA-E1B3-A2D6-E638-B665102FA76F}"/>
          </ac:graphicFrameMkLst>
        </pc:graphicFrameChg>
        <pc:graphicFrameChg chg="add mod">
          <ac:chgData name="Prashanth Anamthathmakula" userId="acd106aa-3bb0-4d16-b474-a7fd34266ac2" providerId="ADAL" clId="{17583561-CD62-4C58-B47B-1822B513A6A2}" dt="2022-10-15T21:07:11.755" v="5" actId="1076"/>
          <ac:graphicFrameMkLst>
            <pc:docMk/>
            <pc:sldMk cId="2091280263" sldId="269"/>
            <ac:graphicFrameMk id="5" creationId="{48D3C878-6B67-B443-A6AE-929BE144F38C}"/>
          </ac:graphicFrameMkLst>
        </pc:graphicFrameChg>
      </pc:sldChg>
      <pc:sldChg chg="addSp delSp modSp new mod">
        <pc:chgData name="Prashanth Anamthathmakula" userId="acd106aa-3bb0-4d16-b474-a7fd34266ac2" providerId="ADAL" clId="{17583561-CD62-4C58-B47B-1822B513A6A2}" dt="2022-10-15T21:08:35.420" v="14" actId="1076"/>
        <pc:sldMkLst>
          <pc:docMk/>
          <pc:sldMk cId="2457040634" sldId="270"/>
        </pc:sldMkLst>
        <pc:spChg chg="del">
          <ac:chgData name="Prashanth Anamthathmakula" userId="acd106aa-3bb0-4d16-b474-a7fd34266ac2" providerId="ADAL" clId="{17583561-CD62-4C58-B47B-1822B513A6A2}" dt="2022-10-15T21:07:19.575" v="7" actId="478"/>
          <ac:spMkLst>
            <pc:docMk/>
            <pc:sldMk cId="2457040634" sldId="270"/>
            <ac:spMk id="2" creationId="{CB2DD1C4-F831-6D21-B37E-4D0E7584BD4A}"/>
          </ac:spMkLst>
        </pc:spChg>
        <pc:spChg chg="del">
          <ac:chgData name="Prashanth Anamthathmakula" userId="acd106aa-3bb0-4d16-b474-a7fd34266ac2" providerId="ADAL" clId="{17583561-CD62-4C58-B47B-1822B513A6A2}" dt="2022-10-15T21:07:19.575" v="7" actId="478"/>
          <ac:spMkLst>
            <pc:docMk/>
            <pc:sldMk cId="2457040634" sldId="270"/>
            <ac:spMk id="3" creationId="{7BA7FCD0-2FCF-88E2-5CFB-CFFA4D5CC9A4}"/>
          </ac:spMkLst>
        </pc:spChg>
        <pc:graphicFrameChg chg="add mod">
          <ac:chgData name="Prashanth Anamthathmakula" userId="acd106aa-3bb0-4d16-b474-a7fd34266ac2" providerId="ADAL" clId="{17583561-CD62-4C58-B47B-1822B513A6A2}" dt="2022-10-15T21:07:45.800" v="10" actId="1076"/>
          <ac:graphicFrameMkLst>
            <pc:docMk/>
            <pc:sldMk cId="2457040634" sldId="270"/>
            <ac:graphicFrameMk id="4" creationId="{DE4C1C8A-3266-8388-2E18-98651CEB3DCE}"/>
          </ac:graphicFrameMkLst>
        </pc:graphicFrameChg>
        <pc:graphicFrameChg chg="add mod">
          <ac:chgData name="Prashanth Anamthathmakula" userId="acd106aa-3bb0-4d16-b474-a7fd34266ac2" providerId="ADAL" clId="{17583561-CD62-4C58-B47B-1822B513A6A2}" dt="2022-10-15T21:08:22.730" v="12" actId="1076"/>
          <ac:graphicFrameMkLst>
            <pc:docMk/>
            <pc:sldMk cId="2457040634" sldId="270"/>
            <ac:graphicFrameMk id="5" creationId="{1A1BA385-C8A1-922A-7DE8-A62AE62B72AD}"/>
          </ac:graphicFrameMkLst>
        </pc:graphicFrameChg>
        <pc:graphicFrameChg chg="add mod">
          <ac:chgData name="Prashanth Anamthathmakula" userId="acd106aa-3bb0-4d16-b474-a7fd34266ac2" providerId="ADAL" clId="{17583561-CD62-4C58-B47B-1822B513A6A2}" dt="2022-10-15T21:08:35.420" v="14" actId="1076"/>
          <ac:graphicFrameMkLst>
            <pc:docMk/>
            <pc:sldMk cId="2457040634" sldId="270"/>
            <ac:graphicFrameMk id="6" creationId="{4797E222-C376-5B7A-957A-BE7531DE761E}"/>
          </ac:graphicFrameMkLst>
        </pc:graphicFrameChg>
      </pc:sldChg>
    </pc:docChg>
  </pc:docChgLst>
  <pc:docChgLst>
    <pc:chgData name="Anamthathmakula, Prashanth" userId="acd106aa-3bb0-4d16-b474-a7fd34266ac2" providerId="ADAL" clId="{83F406D0-0BBA-410C-86B9-97F0EBEB5934}"/>
    <pc:docChg chg="modSld">
      <pc:chgData name="Anamthathmakula, Prashanth" userId="acd106aa-3bb0-4d16-b474-a7fd34266ac2" providerId="ADAL" clId="{83F406D0-0BBA-410C-86B9-97F0EBEB5934}" dt="2023-06-26T22:13:40.462" v="5" actId="20577"/>
      <pc:docMkLst>
        <pc:docMk/>
      </pc:docMkLst>
      <pc:sldChg chg="modSp mod">
        <pc:chgData name="Anamthathmakula, Prashanth" userId="acd106aa-3bb0-4d16-b474-a7fd34266ac2" providerId="ADAL" clId="{83F406D0-0BBA-410C-86B9-97F0EBEB5934}" dt="2023-06-26T22:13:40.462" v="5" actId="20577"/>
        <pc:sldMkLst>
          <pc:docMk/>
          <pc:sldMk cId="3468106434" sldId="269"/>
        </pc:sldMkLst>
        <pc:spChg chg="mod">
          <ac:chgData name="Anamthathmakula, Prashanth" userId="acd106aa-3bb0-4d16-b474-a7fd34266ac2" providerId="ADAL" clId="{83F406D0-0BBA-410C-86B9-97F0EBEB5934}" dt="2023-06-26T22:13:33.489" v="1" actId="20577"/>
          <ac:spMkLst>
            <pc:docMk/>
            <pc:sldMk cId="3468106434" sldId="269"/>
            <ac:spMk id="17" creationId="{8726A9C5-3B60-E86F-D876-F36805179BA2}"/>
          </ac:spMkLst>
        </pc:spChg>
        <pc:spChg chg="mod">
          <ac:chgData name="Anamthathmakula, Prashanth" userId="acd106aa-3bb0-4d16-b474-a7fd34266ac2" providerId="ADAL" clId="{83F406D0-0BBA-410C-86B9-97F0EBEB5934}" dt="2023-06-26T22:13:37.314" v="3" actId="20577"/>
          <ac:spMkLst>
            <pc:docMk/>
            <pc:sldMk cId="3468106434" sldId="269"/>
            <ac:spMk id="18" creationId="{308EA9E2-544C-B5AA-8C0F-B87AD48B3204}"/>
          </ac:spMkLst>
        </pc:spChg>
        <pc:spChg chg="mod">
          <ac:chgData name="Anamthathmakula, Prashanth" userId="acd106aa-3bb0-4d16-b474-a7fd34266ac2" providerId="ADAL" clId="{83F406D0-0BBA-410C-86B9-97F0EBEB5934}" dt="2023-06-26T22:13:40.462" v="5" actId="20577"/>
          <ac:spMkLst>
            <pc:docMk/>
            <pc:sldMk cId="3468106434" sldId="269"/>
            <ac:spMk id="19" creationId="{89A1E381-E72D-DA1C-DB02-CC245893D8CB}"/>
          </ac:spMkLst>
        </pc:spChg>
      </pc:sldChg>
    </pc:docChg>
  </pc:docChgLst>
  <pc:docChgLst>
    <pc:chgData name="Anamthathmakula, Prashanth" userId="acd106aa-3bb0-4d16-b474-a7fd34266ac2" providerId="ADAL" clId="{5D8F2388-33FC-4CCA-B777-E844BBB0E33D}"/>
    <pc:docChg chg="modSld">
      <pc:chgData name="Anamthathmakula, Prashanth" userId="acd106aa-3bb0-4d16-b474-a7fd34266ac2" providerId="ADAL" clId="{5D8F2388-33FC-4CCA-B777-E844BBB0E33D}" dt="2023-08-17T23:54:29.552" v="13" actId="20577"/>
      <pc:docMkLst>
        <pc:docMk/>
      </pc:docMkLst>
      <pc:sldChg chg="modSp mod">
        <pc:chgData name="Anamthathmakula, Prashanth" userId="acd106aa-3bb0-4d16-b474-a7fd34266ac2" providerId="ADAL" clId="{5D8F2388-33FC-4CCA-B777-E844BBB0E33D}" dt="2023-08-17T23:53:59.437" v="8" actId="113"/>
        <pc:sldMkLst>
          <pc:docMk/>
          <pc:sldMk cId="3826982628" sldId="258"/>
        </pc:sldMkLst>
        <pc:spChg chg="mod">
          <ac:chgData name="Anamthathmakula, Prashanth" userId="acd106aa-3bb0-4d16-b474-a7fd34266ac2" providerId="ADAL" clId="{5D8F2388-33FC-4CCA-B777-E844BBB0E33D}" dt="2023-08-17T23:53:59.437" v="8" actId="113"/>
          <ac:spMkLst>
            <pc:docMk/>
            <pc:sldMk cId="3826982628" sldId="258"/>
            <ac:spMk id="3" creationId="{62E255CA-A1A2-1255-C72C-2F5E18C7EF88}"/>
          </ac:spMkLst>
        </pc:spChg>
      </pc:sldChg>
      <pc:sldChg chg="modSp mod">
        <pc:chgData name="Anamthathmakula, Prashanth" userId="acd106aa-3bb0-4d16-b474-a7fd34266ac2" providerId="ADAL" clId="{5D8F2388-33FC-4CCA-B777-E844BBB0E33D}" dt="2023-08-17T23:54:29.552" v="13" actId="20577"/>
        <pc:sldMkLst>
          <pc:docMk/>
          <pc:sldMk cId="3357358326" sldId="270"/>
        </pc:sldMkLst>
        <pc:spChg chg="mod">
          <ac:chgData name="Anamthathmakula, Prashanth" userId="acd106aa-3bb0-4d16-b474-a7fd34266ac2" providerId="ADAL" clId="{5D8F2388-33FC-4CCA-B777-E844BBB0E33D}" dt="2023-08-17T23:54:29.552" v="13" actId="20577"/>
          <ac:spMkLst>
            <pc:docMk/>
            <pc:sldMk cId="3357358326" sldId="270"/>
            <ac:spMk id="3" creationId="{FF66B33E-FFD9-B10B-B198-E013648FAFE6}"/>
          </ac:spMkLst>
        </pc:spChg>
      </pc:sldChg>
    </pc:docChg>
  </pc:docChgLst>
  <pc:docChgLst>
    <pc:chgData name="Anamthathmakula, Prashanth" userId="acd106aa-3bb0-4d16-b474-a7fd34266ac2" providerId="ADAL" clId="{24AA5EA0-019C-4F21-85E1-DABB8C92714C}"/>
    <pc:docChg chg="undo redo custSel addSld delSld modSld sldOrd">
      <pc:chgData name="Anamthathmakula, Prashanth" userId="acd106aa-3bb0-4d16-b474-a7fd34266ac2" providerId="ADAL" clId="{24AA5EA0-019C-4F21-85E1-DABB8C92714C}" dt="2022-02-01T18:16:04.738" v="4736" actId="14100"/>
      <pc:docMkLst>
        <pc:docMk/>
      </pc:docMkLst>
      <pc:sldChg chg="addSp delSp modSp mod">
        <pc:chgData name="Anamthathmakula, Prashanth" userId="acd106aa-3bb0-4d16-b474-a7fd34266ac2" providerId="ADAL" clId="{24AA5EA0-019C-4F21-85E1-DABB8C92714C}" dt="2022-01-31T19:37:23.247" v="3677" actId="6549"/>
        <pc:sldMkLst>
          <pc:docMk/>
          <pc:sldMk cId="4198977331" sldId="256"/>
        </pc:sldMkLst>
        <pc:spChg chg="add mod">
          <ac:chgData name="Anamthathmakula, Prashanth" userId="acd106aa-3bb0-4d16-b474-a7fd34266ac2" providerId="ADAL" clId="{24AA5EA0-019C-4F21-85E1-DABB8C92714C}" dt="2022-01-31T19:37:23.247" v="3677" actId="6549"/>
          <ac:spMkLst>
            <pc:docMk/>
            <pc:sldMk cId="4198977331" sldId="256"/>
            <ac:spMk id="3" creationId="{9D4B022A-486F-42AE-99FC-4D33EF04DF6A}"/>
          </ac:spMkLst>
        </pc:spChg>
        <pc:spChg chg="add mod">
          <ac:chgData name="Anamthathmakula, Prashanth" userId="acd106aa-3bb0-4d16-b474-a7fd34266ac2" providerId="ADAL" clId="{24AA5EA0-019C-4F21-85E1-DABB8C92714C}" dt="2022-01-31T15:56:39.475" v="2390" actId="1076"/>
          <ac:spMkLst>
            <pc:docMk/>
            <pc:sldMk cId="4198977331" sldId="256"/>
            <ac:spMk id="4" creationId="{03D2601F-D199-42E8-92CF-537F09F6DDF2}"/>
          </ac:spMkLst>
        </pc:spChg>
        <pc:picChg chg="add mod modCrop">
          <ac:chgData name="Anamthathmakula, Prashanth" userId="acd106aa-3bb0-4d16-b474-a7fd34266ac2" providerId="ADAL" clId="{24AA5EA0-019C-4F21-85E1-DABB8C92714C}" dt="2022-01-31T15:53:43.802" v="2327" actId="1076"/>
          <ac:picMkLst>
            <pc:docMk/>
            <pc:sldMk cId="4198977331" sldId="256"/>
            <ac:picMk id="2" creationId="{9842D826-EDDA-4F91-9AF0-F35066D13617}"/>
          </ac:picMkLst>
        </pc:picChg>
        <pc:picChg chg="add del mod">
          <ac:chgData name="Anamthathmakula, Prashanth" userId="acd106aa-3bb0-4d16-b474-a7fd34266ac2" providerId="ADAL" clId="{24AA5EA0-019C-4F21-85E1-DABB8C92714C}" dt="2022-01-31T15:53:48.314" v="2328" actId="478"/>
          <ac:picMkLst>
            <pc:docMk/>
            <pc:sldMk cId="4198977331" sldId="256"/>
            <ac:picMk id="1026" creationId="{22CED94E-F2EA-45F2-88FA-C65A8F3A6454}"/>
          </ac:picMkLst>
        </pc:picChg>
      </pc:sldChg>
      <pc:sldChg chg="del">
        <pc:chgData name="Anamthathmakula, Prashanth" userId="acd106aa-3bb0-4d16-b474-a7fd34266ac2" providerId="ADAL" clId="{24AA5EA0-019C-4F21-85E1-DABB8C92714C}" dt="2022-01-30T16:11:07.194" v="6" actId="47"/>
        <pc:sldMkLst>
          <pc:docMk/>
          <pc:sldMk cId="531830581" sldId="257"/>
        </pc:sldMkLst>
      </pc:sldChg>
      <pc:sldChg chg="addSp delSp modSp add mod modAnim">
        <pc:chgData name="Anamthathmakula, Prashanth" userId="acd106aa-3bb0-4d16-b474-a7fd34266ac2" providerId="ADAL" clId="{24AA5EA0-019C-4F21-85E1-DABB8C92714C}" dt="2022-01-31T19:44:59.044" v="3695" actId="14100"/>
        <pc:sldMkLst>
          <pc:docMk/>
          <pc:sldMk cId="2111742621" sldId="258"/>
        </pc:sldMkLst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2" creationId="{A7B14A54-065E-457F-9B34-0D9E91528766}"/>
          </ac:spMkLst>
        </pc:spChg>
        <pc:spChg chg="add del mod">
          <ac:chgData name="Anamthathmakula, Prashanth" userId="acd106aa-3bb0-4d16-b474-a7fd34266ac2" providerId="ADAL" clId="{24AA5EA0-019C-4F21-85E1-DABB8C92714C}" dt="2022-01-30T18:52:30.379" v="220" actId="478"/>
          <ac:spMkLst>
            <pc:docMk/>
            <pc:sldMk cId="2111742621" sldId="258"/>
            <ac:spMk id="23" creationId="{D7B55AC1-8D5D-42BB-9C5C-A6873A96A812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4" creationId="{D138B3FA-9200-4F9F-A1CF-BFEEA3FA7E87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5" creationId="{D56F740E-59EE-4F20-9588-161102EE92C5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6" creationId="{023F3340-538C-4A09-BBC0-C01D61C404BE}"/>
          </ac:spMkLst>
        </pc:spChg>
        <pc:spChg chg="add mod ord">
          <ac:chgData name="Anamthathmakula, Prashanth" userId="acd106aa-3bb0-4d16-b474-a7fd34266ac2" providerId="ADAL" clId="{24AA5EA0-019C-4F21-85E1-DABB8C92714C}" dt="2022-01-30T23:07:51.937" v="1629" actId="1076"/>
          <ac:spMkLst>
            <pc:docMk/>
            <pc:sldMk cId="2111742621" sldId="258"/>
            <ac:spMk id="27" creationId="{A390A641-BA7C-4CE0-94EF-5729069DEB9D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8" creationId="{3F093D78-836F-4C60-A980-A985A5F24636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29" creationId="{5C1AFF33-A827-4DB6-A274-DCF3E2E50F0F}"/>
          </ac:spMkLst>
        </pc:spChg>
        <pc:spChg chg="add mod or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0" creationId="{42E5163D-FF34-4123-88FF-FDC9016A9CD4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1" creationId="{09101D47-BD16-4E0B-8F30-97B1B99ACA1B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2" creationId="{3636C643-94B8-4C34-99CF-253441208569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3" creationId="{662591CC-8952-4BD9-B100-FE06EFDCAFE3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4" creationId="{26CBD004-0186-41D6-9EBF-E7E94A479F53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5" creationId="{D8EB419E-C2F1-490F-9BCB-53AF73E68B22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6" creationId="{8848C951-7C2C-47D4-9240-B64E7506D2C1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37" creationId="{3BB6EBE6-2CBA-44B5-A25C-175AEA1989C0}"/>
          </ac:spMkLst>
        </pc:spChg>
        <pc:spChg chg="add mod">
          <ac:chgData name="Anamthathmakula, Prashanth" userId="acd106aa-3bb0-4d16-b474-a7fd34266ac2" providerId="ADAL" clId="{24AA5EA0-019C-4F21-85E1-DABB8C92714C}" dt="2022-01-31T19:44:59.044" v="3695" actId="14100"/>
          <ac:spMkLst>
            <pc:docMk/>
            <pc:sldMk cId="2111742621" sldId="258"/>
            <ac:spMk id="38" creationId="{AA7EE9CC-07E5-4101-A39A-F419AE92038A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56" creationId="{838EB74D-E25E-4CA8-9B8D-6EF9787AB8DA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57" creationId="{1E471A2E-23E3-4455-B5EF-22AAE892CFCF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58" creationId="{BCC30D43-8AE5-498E-AFC2-E9366A118530}"/>
          </ac:spMkLst>
        </pc:spChg>
        <pc:spChg chg="add mod">
          <ac:chgData name="Anamthathmakula, Prashanth" userId="acd106aa-3bb0-4d16-b474-a7fd34266ac2" providerId="ADAL" clId="{24AA5EA0-019C-4F21-85E1-DABB8C92714C}" dt="2022-01-30T19:49:14.117" v="1130" actId="1037"/>
          <ac:spMkLst>
            <pc:docMk/>
            <pc:sldMk cId="2111742621" sldId="258"/>
            <ac:spMk id="59" creationId="{92523712-B816-457A-84A4-9DC0687168D0}"/>
          </ac:spMkLst>
        </pc:spChg>
        <pc:spChg chg="add mod">
          <ac:chgData name="Anamthathmakula, Prashanth" userId="acd106aa-3bb0-4d16-b474-a7fd34266ac2" providerId="ADAL" clId="{24AA5EA0-019C-4F21-85E1-DABB8C92714C}" dt="2022-01-30T19:54:40.404" v="1212" actId="1076"/>
          <ac:spMkLst>
            <pc:docMk/>
            <pc:sldMk cId="2111742621" sldId="258"/>
            <ac:spMk id="60" creationId="{183318D6-4AD4-41CC-B02E-4BDD6B1C5D1B}"/>
          </ac:spMkLst>
        </pc:sp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3" creationId="{9D4CB597-BC42-4E7C-91D7-863ED537450A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5" creationId="{833403CE-45E6-4BD0-ABD2-43B4E8768435}"/>
          </ac:picMkLst>
        </pc:picChg>
        <pc:picChg chg="add del mod">
          <ac:chgData name="Anamthathmakula, Prashanth" userId="acd106aa-3bb0-4d16-b474-a7fd34266ac2" providerId="ADAL" clId="{24AA5EA0-019C-4F21-85E1-DABB8C92714C}" dt="2022-01-30T16:59:10.530" v="170" actId="21"/>
          <ac:picMkLst>
            <pc:docMk/>
            <pc:sldMk cId="2111742621" sldId="258"/>
            <ac:picMk id="7" creationId="{FC43F083-9B5A-4B90-B5A9-CB917B74229C}"/>
          </ac:picMkLst>
        </pc:picChg>
        <pc:picChg chg="add del mod">
          <ac:chgData name="Anamthathmakula, Prashanth" userId="acd106aa-3bb0-4d16-b474-a7fd34266ac2" providerId="ADAL" clId="{24AA5EA0-019C-4F21-85E1-DABB8C92714C}" dt="2022-01-30T16:59:10.530" v="170" actId="21"/>
          <ac:picMkLst>
            <pc:docMk/>
            <pc:sldMk cId="2111742621" sldId="258"/>
            <ac:picMk id="9" creationId="{683B1BCE-BB97-4395-8CEB-DD9B2B0C219C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11" creationId="{07DD7EAF-80BA-4F92-A29B-B5F265F1025F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13" creationId="{14F49E18-610C-4096-BAC1-1416B7924DB1}"/>
          </ac:picMkLst>
        </pc:picChg>
        <pc:picChg chg="add del mod">
          <ac:chgData name="Anamthathmakula, Prashanth" userId="acd106aa-3bb0-4d16-b474-a7fd34266ac2" providerId="ADAL" clId="{24AA5EA0-019C-4F21-85E1-DABB8C92714C}" dt="2022-01-30T19:04:55.801" v="518" actId="478"/>
          <ac:picMkLst>
            <pc:docMk/>
            <pc:sldMk cId="2111742621" sldId="258"/>
            <ac:picMk id="15" creationId="{DF2F8D5F-4BE9-43F0-8316-7C2FCCF12797}"/>
          </ac:picMkLst>
        </pc:picChg>
        <pc:picChg chg="add del mod">
          <ac:chgData name="Anamthathmakula, Prashanth" userId="acd106aa-3bb0-4d16-b474-a7fd34266ac2" providerId="ADAL" clId="{24AA5EA0-019C-4F21-85E1-DABB8C92714C}" dt="2022-01-30T19:04:55.801" v="518" actId="478"/>
          <ac:picMkLst>
            <pc:docMk/>
            <pc:sldMk cId="2111742621" sldId="258"/>
            <ac:picMk id="17" creationId="{91F1BEEC-E3E5-45F5-ACC0-97F90E78160C}"/>
          </ac:picMkLst>
        </pc:picChg>
        <pc:picChg chg="add del mod">
          <ac:chgData name="Anamthathmakula, Prashanth" userId="acd106aa-3bb0-4d16-b474-a7fd34266ac2" providerId="ADAL" clId="{24AA5EA0-019C-4F21-85E1-DABB8C92714C}" dt="2022-01-30T19:04:55.801" v="518" actId="478"/>
          <ac:picMkLst>
            <pc:docMk/>
            <pc:sldMk cId="2111742621" sldId="258"/>
            <ac:picMk id="19" creationId="{B2F47124-A154-428D-B584-6E16CA2C4D19}"/>
          </ac:picMkLst>
        </pc:picChg>
        <pc:picChg chg="add del mod">
          <ac:chgData name="Anamthathmakula, Prashanth" userId="acd106aa-3bb0-4d16-b474-a7fd34266ac2" providerId="ADAL" clId="{24AA5EA0-019C-4F21-85E1-DABB8C92714C}" dt="2022-01-30T19:04:55.801" v="518" actId="478"/>
          <ac:picMkLst>
            <pc:docMk/>
            <pc:sldMk cId="2111742621" sldId="258"/>
            <ac:picMk id="21" creationId="{8A599DEF-09A2-4DD3-A5AB-9F924C1E6B2B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39" creationId="{2C85C7EA-EA70-4155-9162-9DDC8A797700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41" creationId="{2583A1B2-41DE-492F-94A7-3AB69F3FB24D}"/>
          </ac:picMkLst>
        </pc:picChg>
        <pc:picChg chg="add del mod">
          <ac:chgData name="Anamthathmakula, Prashanth" userId="acd106aa-3bb0-4d16-b474-a7fd34266ac2" providerId="ADAL" clId="{24AA5EA0-019C-4F21-85E1-DABB8C92714C}" dt="2022-01-30T19:04:33.433" v="514" actId="478"/>
          <ac:picMkLst>
            <pc:docMk/>
            <pc:sldMk cId="2111742621" sldId="258"/>
            <ac:picMk id="43" creationId="{EC258F35-C9C8-4C8D-A7D4-F9A178065D02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45" creationId="{11DA4DE0-B12D-430E-88EA-B945E256B51C}"/>
          </ac:picMkLst>
        </pc:picChg>
        <pc:picChg chg="add mod or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47" creationId="{EE6FA3E5-5FB1-400E-89C2-FF00B6CF38B9}"/>
          </ac:picMkLst>
        </pc:picChg>
        <pc:picChg chg="add mo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49" creationId="{BB74BA34-C502-4240-82B7-1BAEA0A6CEBE}"/>
          </ac:picMkLst>
        </pc:picChg>
        <pc:picChg chg="add mo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51" creationId="{87AE3CF1-9B8B-4780-93DC-028FE81F87CF}"/>
          </ac:picMkLst>
        </pc:picChg>
        <pc:picChg chg="add mo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53" creationId="{964D2C5D-26D9-4D8B-A1A1-785F9397C29F}"/>
          </ac:picMkLst>
        </pc:picChg>
        <pc:picChg chg="add mod">
          <ac:chgData name="Anamthathmakula, Prashanth" userId="acd106aa-3bb0-4d16-b474-a7fd34266ac2" providerId="ADAL" clId="{24AA5EA0-019C-4F21-85E1-DABB8C92714C}" dt="2022-01-30T19:49:14.117" v="1130" actId="1037"/>
          <ac:picMkLst>
            <pc:docMk/>
            <pc:sldMk cId="2111742621" sldId="258"/>
            <ac:picMk id="55" creationId="{28B05218-DE2E-4C5D-AADC-D24E948CBEC7}"/>
          </ac:picMkLst>
        </pc:picChg>
      </pc:sldChg>
      <pc:sldChg chg="addSp modSp add del mod">
        <pc:chgData name="Anamthathmakula, Prashanth" userId="acd106aa-3bb0-4d16-b474-a7fd34266ac2" providerId="ADAL" clId="{24AA5EA0-019C-4F21-85E1-DABB8C92714C}" dt="2022-01-30T19:00:34.020" v="486" actId="47"/>
        <pc:sldMkLst>
          <pc:docMk/>
          <pc:sldMk cId="3244232595" sldId="259"/>
        </pc:sldMkLst>
        <pc:picChg chg="add mod">
          <ac:chgData name="Anamthathmakula, Prashanth" userId="acd106aa-3bb0-4d16-b474-a7fd34266ac2" providerId="ADAL" clId="{24AA5EA0-019C-4F21-85E1-DABB8C92714C}" dt="2022-01-30T16:59:27.491" v="173" actId="1076"/>
          <ac:picMkLst>
            <pc:docMk/>
            <pc:sldMk cId="3244232595" sldId="259"/>
            <ac:picMk id="2" creationId="{B46CB304-8989-4F81-9553-45B7340C7F86}"/>
          </ac:picMkLst>
        </pc:picChg>
        <pc:picChg chg="add mod">
          <ac:chgData name="Anamthathmakula, Prashanth" userId="acd106aa-3bb0-4d16-b474-a7fd34266ac2" providerId="ADAL" clId="{24AA5EA0-019C-4F21-85E1-DABB8C92714C}" dt="2022-01-30T16:59:27.491" v="173" actId="1076"/>
          <ac:picMkLst>
            <pc:docMk/>
            <pc:sldMk cId="3244232595" sldId="259"/>
            <ac:picMk id="3" creationId="{A1A7041D-D404-4A7A-BBBF-194361803D67}"/>
          </ac:picMkLst>
        </pc:picChg>
        <pc:picChg chg="add mod">
          <ac:chgData name="Anamthathmakula, Prashanth" userId="acd106aa-3bb0-4d16-b474-a7fd34266ac2" providerId="ADAL" clId="{24AA5EA0-019C-4F21-85E1-DABB8C92714C}" dt="2022-01-30T17:00:36.795" v="186" actId="1076"/>
          <ac:picMkLst>
            <pc:docMk/>
            <pc:sldMk cId="3244232595" sldId="259"/>
            <ac:picMk id="5" creationId="{98C46C5B-B47F-4D36-8DA2-FEE73871ABFE}"/>
          </ac:picMkLst>
        </pc:picChg>
        <pc:picChg chg="add mod">
          <ac:chgData name="Anamthathmakula, Prashanth" userId="acd106aa-3bb0-4d16-b474-a7fd34266ac2" providerId="ADAL" clId="{24AA5EA0-019C-4F21-85E1-DABB8C92714C}" dt="2022-01-30T17:00:54.996" v="191" actId="1076"/>
          <ac:picMkLst>
            <pc:docMk/>
            <pc:sldMk cId="3244232595" sldId="259"/>
            <ac:picMk id="7" creationId="{AE569519-DAA5-4E69-BE13-4B306DF8F23F}"/>
          </ac:picMkLst>
        </pc:picChg>
      </pc:sldChg>
      <pc:sldChg chg="addSp delSp modSp add del mod modAnim">
        <pc:chgData name="Anamthathmakula, Prashanth" userId="acd106aa-3bb0-4d16-b474-a7fd34266ac2" providerId="ADAL" clId="{24AA5EA0-019C-4F21-85E1-DABB8C92714C}" dt="2022-01-30T20:06:58.731" v="1324" actId="47"/>
        <pc:sldMkLst>
          <pc:docMk/>
          <pc:sldMk cId="4235092914" sldId="260"/>
        </pc:sldMkLst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7" creationId="{CFC4095F-154E-4A31-8C0A-06C6B2C345F1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8" creationId="{F88F143E-2EE9-4F88-8617-89A2FF291879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9" creationId="{76CDA92A-B237-4591-9F96-CCCEDDBFEBB6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13" creationId="{396301ED-A594-4467-8323-41AC71FF3DFD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14" creationId="{EE435A3B-49F3-4E6C-963F-8977F38A0380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16" creationId="{71890582-6B6F-48F3-A3BA-3C9DE85FC78D}"/>
          </ac:spMkLst>
        </pc:spChg>
        <pc:spChg chg="mod topLvl">
          <ac:chgData name="Anamthathmakula, Prashanth" userId="acd106aa-3bb0-4d16-b474-a7fd34266ac2" providerId="ADAL" clId="{24AA5EA0-019C-4F21-85E1-DABB8C92714C}" dt="2022-01-30T19:59:04.904" v="1243" actId="165"/>
          <ac:spMkLst>
            <pc:docMk/>
            <pc:sldMk cId="4235092914" sldId="260"/>
            <ac:spMk id="19" creationId="{560CBCCC-AB50-4BB3-B649-9D2C6A5049C0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2" creationId="{E6EA9471-F0CA-4C21-8216-CEE742A81AE0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3" creationId="{65501241-8CC2-469E-AB04-6245B1A6467C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4" creationId="{131B05CD-D154-47C9-8D2C-1B85AE731DA7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5" creationId="{F3D3C6C9-F900-4120-A3FB-9888F0D07E47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6" creationId="{BBAEB2D3-A9EB-4DFC-AB50-99880E0EBA59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7" creationId="{82D7C655-6403-421F-933B-8AD954523ED3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8" creationId="{E6F58E0D-835D-4DF4-AA93-A54520E463C1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29" creationId="{3720C92C-706F-4F98-B45F-49CF33EC0228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2" creationId="{CAC5F763-F4B2-4C83-8BEC-D7AD903129F1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3" creationId="{9F4F1F89-32AC-4443-9511-A0223CCDF763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4" creationId="{19A72D14-0D74-4D87-9561-2A268F995FAF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5" creationId="{EA183168-91A1-4AA4-BA87-3F9B81B8DA67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6" creationId="{03FC4638-BF9F-4144-903F-B359B57B2FF6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7" creationId="{1D2523B1-E078-4535-8F70-44B3E30A9C1D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38" creationId="{5BED18E9-6969-48D6-B152-D7A0C65352BB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40" creationId="{DA9CB754-60B2-49BD-8969-E9B803DDAE5E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41" creationId="{81B136A2-0677-4BB7-A289-9B9EBF7E19BC}"/>
          </ac:spMkLst>
        </pc:spChg>
        <pc:spChg chg="mod">
          <ac:chgData name="Anamthathmakula, Prashanth" userId="acd106aa-3bb0-4d16-b474-a7fd34266ac2" providerId="ADAL" clId="{24AA5EA0-019C-4F21-85E1-DABB8C92714C}" dt="2022-01-30T16:13:46.352" v="33"/>
          <ac:spMkLst>
            <pc:docMk/>
            <pc:sldMk cId="4235092914" sldId="260"/>
            <ac:spMk id="43" creationId="{CC585326-8179-4686-986A-2C66C0A20BF5}"/>
          </ac:spMkLst>
        </pc:spChg>
        <pc:spChg chg="add mod">
          <ac:chgData name="Anamthathmakula, Prashanth" userId="acd106aa-3bb0-4d16-b474-a7fd34266ac2" providerId="ADAL" clId="{24AA5EA0-019C-4F21-85E1-DABB8C92714C}" dt="2022-01-30T16:15:51.719" v="42" actId="1076"/>
          <ac:spMkLst>
            <pc:docMk/>
            <pc:sldMk cId="4235092914" sldId="260"/>
            <ac:spMk id="44" creationId="{338D29B4-02E2-4D20-A731-4A2684B40490}"/>
          </ac:spMkLst>
        </pc:spChg>
        <pc:spChg chg="add mod">
          <ac:chgData name="Anamthathmakula, Prashanth" userId="acd106aa-3bb0-4d16-b474-a7fd34266ac2" providerId="ADAL" clId="{24AA5EA0-019C-4F21-85E1-DABB8C92714C}" dt="2022-01-30T16:16:04.758" v="59" actId="1036"/>
          <ac:spMkLst>
            <pc:docMk/>
            <pc:sldMk cId="4235092914" sldId="260"/>
            <ac:spMk id="45" creationId="{A455588E-6894-402B-95FB-0A33A6356546}"/>
          </ac:spMkLst>
        </pc:spChg>
        <pc:spChg chg="add mod">
          <ac:chgData name="Anamthathmakula, Prashanth" userId="acd106aa-3bb0-4d16-b474-a7fd34266ac2" providerId="ADAL" clId="{24AA5EA0-019C-4F21-85E1-DABB8C92714C}" dt="2022-01-30T16:16:12.956" v="91" actId="1038"/>
          <ac:spMkLst>
            <pc:docMk/>
            <pc:sldMk cId="4235092914" sldId="260"/>
            <ac:spMk id="46" creationId="{C78A37DB-D90C-45F2-A79A-9DB335D7E916}"/>
          </ac:spMkLst>
        </pc:spChg>
        <pc:spChg chg="add del mod">
          <ac:chgData name="Anamthathmakula, Prashanth" userId="acd106aa-3bb0-4d16-b474-a7fd34266ac2" providerId="ADAL" clId="{24AA5EA0-019C-4F21-85E1-DABB8C92714C}" dt="2022-01-30T16:14:28.793" v="35" actId="21"/>
          <ac:spMkLst>
            <pc:docMk/>
            <pc:sldMk cId="4235092914" sldId="260"/>
            <ac:spMk id="48" creationId="{17E3A124-101F-464E-BF84-80489B39270A}"/>
          </ac:spMkLst>
        </pc:spChg>
        <pc:spChg chg="add mod">
          <ac:chgData name="Anamthathmakula, Prashanth" userId="acd106aa-3bb0-4d16-b474-a7fd34266ac2" providerId="ADAL" clId="{24AA5EA0-019C-4F21-85E1-DABB8C92714C}" dt="2022-01-30T16:16:37.794" v="131" actId="1036"/>
          <ac:spMkLst>
            <pc:docMk/>
            <pc:sldMk cId="4235092914" sldId="260"/>
            <ac:spMk id="50" creationId="{84469AD4-9C55-4B5E-9176-749D1FD8EFD0}"/>
          </ac:spMkLst>
        </pc:spChg>
        <pc:spChg chg="add del mod ord">
          <ac:chgData name="Anamthathmakula, Prashanth" userId="acd106aa-3bb0-4d16-b474-a7fd34266ac2" providerId="ADAL" clId="{24AA5EA0-019C-4F21-85E1-DABB8C92714C}" dt="2022-01-30T20:06:20.691" v="1320" actId="21"/>
          <ac:spMkLst>
            <pc:docMk/>
            <pc:sldMk cId="4235092914" sldId="260"/>
            <ac:spMk id="51" creationId="{ECBEB36A-7CC2-49C8-B48E-B946BFB0A784}"/>
          </ac:spMkLst>
        </pc:spChg>
        <pc:spChg chg="add del mod">
          <ac:chgData name="Anamthathmakula, Prashanth" userId="acd106aa-3bb0-4d16-b474-a7fd34266ac2" providerId="ADAL" clId="{24AA5EA0-019C-4F21-85E1-DABB8C92714C}" dt="2022-01-30T20:06:20.691" v="1320" actId="21"/>
          <ac:spMkLst>
            <pc:docMk/>
            <pc:sldMk cId="4235092914" sldId="260"/>
            <ac:spMk id="52" creationId="{FD91621E-8A30-4C14-B91C-F206F35BE4DF}"/>
          </ac:spMkLst>
        </pc:spChg>
        <pc:spChg chg="add mod">
          <ac:chgData name="Anamthathmakula, Prashanth" userId="acd106aa-3bb0-4d16-b474-a7fd34266ac2" providerId="ADAL" clId="{24AA5EA0-019C-4F21-85E1-DABB8C92714C}" dt="2022-01-30T20:06:23.165" v="1321"/>
          <ac:spMkLst>
            <pc:docMk/>
            <pc:sldMk cId="4235092914" sldId="260"/>
            <ac:spMk id="53" creationId="{121B9C35-82C9-4961-987B-3449BCC04312}"/>
          </ac:spMkLst>
        </pc:spChg>
        <pc:spChg chg="add mod">
          <ac:chgData name="Anamthathmakula, Prashanth" userId="acd106aa-3bb0-4d16-b474-a7fd34266ac2" providerId="ADAL" clId="{24AA5EA0-019C-4F21-85E1-DABB8C92714C}" dt="2022-01-30T20:06:23.165" v="1321"/>
          <ac:spMkLst>
            <pc:docMk/>
            <pc:sldMk cId="4235092914" sldId="260"/>
            <ac:spMk id="54" creationId="{AD4C6099-F842-4E79-B0A9-339CF1218B71}"/>
          </ac:spMkLst>
        </pc:spChg>
        <pc:grpChg chg="add del mod">
          <ac:chgData name="Anamthathmakula, Prashanth" userId="acd106aa-3bb0-4d16-b474-a7fd34266ac2" providerId="ADAL" clId="{24AA5EA0-019C-4F21-85E1-DABB8C92714C}" dt="2022-01-30T19:59:04.904" v="1243" actId="165"/>
          <ac:grpSpMkLst>
            <pc:docMk/>
            <pc:sldMk cId="4235092914" sldId="260"/>
            <ac:grpSpMk id="6" creationId="{B9FBB5F1-4942-4961-A5E0-7D19C9C59438}"/>
          </ac:grpSpMkLst>
        </pc:grpChg>
        <pc:grpChg chg="add mod">
          <ac:chgData name="Anamthathmakula, Prashanth" userId="acd106aa-3bb0-4d16-b474-a7fd34266ac2" providerId="ADAL" clId="{24AA5EA0-019C-4F21-85E1-DABB8C92714C}" dt="2022-01-30T16:14:43.846" v="36" actId="1076"/>
          <ac:grpSpMkLst>
            <pc:docMk/>
            <pc:sldMk cId="4235092914" sldId="260"/>
            <ac:grpSpMk id="20" creationId="{A1DEF820-A1B9-4511-815B-E5AC8710D3D9}"/>
          </ac:grpSpMkLst>
        </pc:grpChg>
        <pc:graphicFrameChg chg="add del mod">
          <ac:chgData name="Anamthathmakula, Prashanth" userId="acd106aa-3bb0-4d16-b474-a7fd34266ac2" providerId="ADAL" clId="{24AA5EA0-019C-4F21-85E1-DABB8C92714C}" dt="2022-01-30T16:12:15.582" v="18"/>
          <ac:graphicFrameMkLst>
            <pc:docMk/>
            <pc:sldMk cId="4235092914" sldId="260"/>
            <ac:graphicFrameMk id="3" creationId="{1F3166D6-EFEE-417E-9D70-7BC06AE9E6FD}"/>
          </ac:graphicFrameMkLst>
        </pc:graphicFrameChg>
        <pc:graphicFrameChg chg="add del mod">
          <ac:chgData name="Anamthathmakula, Prashanth" userId="acd106aa-3bb0-4d16-b474-a7fd34266ac2" providerId="ADAL" clId="{24AA5EA0-019C-4F21-85E1-DABB8C92714C}" dt="2022-01-30T16:13:01.353" v="32" actId="478"/>
          <ac:graphicFrameMkLst>
            <pc:docMk/>
            <pc:sldMk cId="4235092914" sldId="260"/>
            <ac:graphicFrameMk id="5" creationId="{A848A450-520E-42B5-B9F8-83845877EBFE}"/>
          </ac:graphicFrameMkLst>
        </pc:graphicFrameChg>
        <pc:graphicFrameChg chg="add del mod">
          <ac:chgData name="Anamthathmakula, Prashanth" userId="acd106aa-3bb0-4d16-b474-a7fd34266ac2" providerId="ADAL" clId="{24AA5EA0-019C-4F21-85E1-DABB8C92714C}" dt="2022-01-30T16:14:28.793" v="35" actId="21"/>
          <ac:graphicFrameMkLst>
            <pc:docMk/>
            <pc:sldMk cId="4235092914" sldId="260"/>
            <ac:graphicFrameMk id="47" creationId="{06D09697-77AD-4EC3-982B-8D5DF9284A65}"/>
          </ac:graphicFrameMkLst>
        </pc:graphicFrameChg>
        <pc:graphicFrameChg chg="add mod">
          <ac:chgData name="Anamthathmakula, Prashanth" userId="acd106aa-3bb0-4d16-b474-a7fd34266ac2" providerId="ADAL" clId="{24AA5EA0-019C-4F21-85E1-DABB8C92714C}" dt="2022-01-30T16:16:28.137" v="111" actId="1038"/>
          <ac:graphicFrameMkLst>
            <pc:docMk/>
            <pc:sldMk cId="4235092914" sldId="260"/>
            <ac:graphicFrameMk id="49" creationId="{13D813FE-37FD-469A-A98D-2C4C00EDC283}"/>
          </ac:graphicFrameMkLst>
        </pc:graphicFrameChg>
        <pc:picChg chg="add del mod">
          <ac:chgData name="Anamthathmakula, Prashanth" userId="acd106aa-3bb0-4d16-b474-a7fd34266ac2" providerId="ADAL" clId="{24AA5EA0-019C-4F21-85E1-DABB8C92714C}" dt="2022-01-30T16:12:15.582" v="18"/>
          <ac:picMkLst>
            <pc:docMk/>
            <pc:sldMk cId="4235092914" sldId="260"/>
            <ac:picMk id="2" creationId="{116265AA-FDAE-4B1B-A162-F4205BC12427}"/>
          </ac:picMkLst>
        </pc:picChg>
        <pc:picChg chg="add del mod">
          <ac:chgData name="Anamthathmakula, Prashanth" userId="acd106aa-3bb0-4d16-b474-a7fd34266ac2" providerId="ADAL" clId="{24AA5EA0-019C-4F21-85E1-DABB8C92714C}" dt="2022-01-30T16:12:59.508" v="31" actId="478"/>
          <ac:picMkLst>
            <pc:docMk/>
            <pc:sldMk cId="4235092914" sldId="260"/>
            <ac:picMk id="4" creationId="{5ECC5EEC-A106-4415-907D-55BBA64D7C8B}"/>
          </ac:picMkLst>
        </pc:picChg>
        <pc:picChg chg="mod topLvl">
          <ac:chgData name="Anamthathmakula, Prashanth" userId="acd106aa-3bb0-4d16-b474-a7fd34266ac2" providerId="ADAL" clId="{24AA5EA0-019C-4F21-85E1-DABB8C92714C}" dt="2022-01-30T19:59:04.904" v="1243" actId="165"/>
          <ac:picMkLst>
            <pc:docMk/>
            <pc:sldMk cId="4235092914" sldId="260"/>
            <ac:picMk id="11" creationId="{BF45CA3C-7D47-4E60-BD24-DD472DAEF245}"/>
          </ac:picMkLst>
        </pc:picChg>
        <pc:picChg chg="mod topLvl">
          <ac:chgData name="Anamthathmakula, Prashanth" userId="acd106aa-3bb0-4d16-b474-a7fd34266ac2" providerId="ADAL" clId="{24AA5EA0-019C-4F21-85E1-DABB8C92714C}" dt="2022-01-30T19:59:04.904" v="1243" actId="165"/>
          <ac:picMkLst>
            <pc:docMk/>
            <pc:sldMk cId="4235092914" sldId="260"/>
            <ac:picMk id="12" creationId="{F0C5DBB8-0B24-413F-BB78-1E02CFAA843C}"/>
          </ac:picMkLst>
        </pc:picChg>
        <pc:picChg chg="mod topLvl">
          <ac:chgData name="Anamthathmakula, Prashanth" userId="acd106aa-3bb0-4d16-b474-a7fd34266ac2" providerId="ADAL" clId="{24AA5EA0-019C-4F21-85E1-DABB8C92714C}" dt="2022-01-30T19:59:04.904" v="1243" actId="165"/>
          <ac:picMkLst>
            <pc:docMk/>
            <pc:sldMk cId="4235092914" sldId="260"/>
            <ac:picMk id="15" creationId="{FB298194-7AF5-409C-9BBB-40CEA2DDC929}"/>
          </ac:picMkLst>
        </pc:picChg>
        <pc:cxnChg chg="mod topLvl">
          <ac:chgData name="Anamthathmakula, Prashanth" userId="acd106aa-3bb0-4d16-b474-a7fd34266ac2" providerId="ADAL" clId="{24AA5EA0-019C-4F21-85E1-DABB8C92714C}" dt="2022-01-30T19:59:04.904" v="1243" actId="165"/>
          <ac:cxnSpMkLst>
            <pc:docMk/>
            <pc:sldMk cId="4235092914" sldId="260"/>
            <ac:cxnSpMk id="10" creationId="{5982FAA1-6E5A-4335-92F3-B61CDF2F894D}"/>
          </ac:cxnSpMkLst>
        </pc:cxnChg>
        <pc:cxnChg chg="mod topLvl">
          <ac:chgData name="Anamthathmakula, Prashanth" userId="acd106aa-3bb0-4d16-b474-a7fd34266ac2" providerId="ADAL" clId="{24AA5EA0-019C-4F21-85E1-DABB8C92714C}" dt="2022-01-30T19:59:04.904" v="1243" actId="165"/>
          <ac:cxnSpMkLst>
            <pc:docMk/>
            <pc:sldMk cId="4235092914" sldId="260"/>
            <ac:cxnSpMk id="17" creationId="{13F262DE-60CA-4A5E-851F-F7027F85F917}"/>
          </ac:cxnSpMkLst>
        </pc:cxnChg>
        <pc:cxnChg chg="mod topLvl">
          <ac:chgData name="Anamthathmakula, Prashanth" userId="acd106aa-3bb0-4d16-b474-a7fd34266ac2" providerId="ADAL" clId="{24AA5EA0-019C-4F21-85E1-DABB8C92714C}" dt="2022-01-30T19:59:04.904" v="1243" actId="165"/>
          <ac:cxnSpMkLst>
            <pc:docMk/>
            <pc:sldMk cId="4235092914" sldId="260"/>
            <ac:cxnSpMk id="18" creationId="{21C66827-BB99-417A-B6A0-168D3ADC1C06}"/>
          </ac:cxnSpMkLst>
        </pc:cxnChg>
        <pc:cxnChg chg="mod">
          <ac:chgData name="Anamthathmakula, Prashanth" userId="acd106aa-3bb0-4d16-b474-a7fd34266ac2" providerId="ADAL" clId="{24AA5EA0-019C-4F21-85E1-DABB8C92714C}" dt="2022-01-30T16:13:46.352" v="33"/>
          <ac:cxnSpMkLst>
            <pc:docMk/>
            <pc:sldMk cId="4235092914" sldId="260"/>
            <ac:cxnSpMk id="21" creationId="{C3660C5F-5C24-4C68-AF11-137AB5CF2347}"/>
          </ac:cxnSpMkLst>
        </pc:cxnChg>
        <pc:cxnChg chg="mod">
          <ac:chgData name="Anamthathmakula, Prashanth" userId="acd106aa-3bb0-4d16-b474-a7fd34266ac2" providerId="ADAL" clId="{24AA5EA0-019C-4F21-85E1-DABB8C92714C}" dt="2022-01-30T16:13:46.352" v="33"/>
          <ac:cxnSpMkLst>
            <pc:docMk/>
            <pc:sldMk cId="4235092914" sldId="260"/>
            <ac:cxnSpMk id="30" creationId="{CBB3ECB2-4D84-4BF6-BAF4-2AD473B26005}"/>
          </ac:cxnSpMkLst>
        </pc:cxnChg>
        <pc:cxnChg chg="mod">
          <ac:chgData name="Anamthathmakula, Prashanth" userId="acd106aa-3bb0-4d16-b474-a7fd34266ac2" providerId="ADAL" clId="{24AA5EA0-019C-4F21-85E1-DABB8C92714C}" dt="2022-01-30T16:13:46.352" v="33"/>
          <ac:cxnSpMkLst>
            <pc:docMk/>
            <pc:sldMk cId="4235092914" sldId="260"/>
            <ac:cxnSpMk id="31" creationId="{CA4DCCC5-5A8E-4004-8E5C-9AEA7A4B6014}"/>
          </ac:cxnSpMkLst>
        </pc:cxnChg>
        <pc:cxnChg chg="mod">
          <ac:chgData name="Anamthathmakula, Prashanth" userId="acd106aa-3bb0-4d16-b474-a7fd34266ac2" providerId="ADAL" clId="{24AA5EA0-019C-4F21-85E1-DABB8C92714C}" dt="2022-01-30T16:13:46.352" v="33"/>
          <ac:cxnSpMkLst>
            <pc:docMk/>
            <pc:sldMk cId="4235092914" sldId="260"/>
            <ac:cxnSpMk id="39" creationId="{44AC762E-8348-4602-82F0-1C0FFF130483}"/>
          </ac:cxnSpMkLst>
        </pc:cxnChg>
        <pc:cxnChg chg="mod">
          <ac:chgData name="Anamthathmakula, Prashanth" userId="acd106aa-3bb0-4d16-b474-a7fd34266ac2" providerId="ADAL" clId="{24AA5EA0-019C-4F21-85E1-DABB8C92714C}" dt="2022-01-30T16:13:46.352" v="33"/>
          <ac:cxnSpMkLst>
            <pc:docMk/>
            <pc:sldMk cId="4235092914" sldId="260"/>
            <ac:cxnSpMk id="42" creationId="{6E27CFFD-2EBA-4193-8B44-D1B5681AFC58}"/>
          </ac:cxnSpMkLst>
        </pc:cxnChg>
      </pc:sldChg>
      <pc:sldChg chg="addSp delSp modSp add mod">
        <pc:chgData name="Anamthathmakula, Prashanth" userId="acd106aa-3bb0-4d16-b474-a7fd34266ac2" providerId="ADAL" clId="{24AA5EA0-019C-4F21-85E1-DABB8C92714C}" dt="2022-01-31T20:07:05.784" v="3860" actId="20577"/>
        <pc:sldMkLst>
          <pc:docMk/>
          <pc:sldMk cId="884979180" sldId="261"/>
        </pc:sldMkLst>
        <pc:spChg chg="add mod">
          <ac:chgData name="Anamthathmakula, Prashanth" userId="acd106aa-3bb0-4d16-b474-a7fd34266ac2" providerId="ADAL" clId="{24AA5EA0-019C-4F21-85E1-DABB8C92714C}" dt="2022-01-31T19:48:05.639" v="3717" actId="20577"/>
          <ac:spMkLst>
            <pc:docMk/>
            <pc:sldMk cId="884979180" sldId="261"/>
            <ac:spMk id="2" creationId="{B9A2F2E7-595C-486C-8934-B29ABA7B418E}"/>
          </ac:spMkLst>
        </pc:spChg>
        <pc:spChg chg="add mod">
          <ac:chgData name="Anamthathmakula, Prashanth" userId="acd106aa-3bb0-4d16-b474-a7fd34266ac2" providerId="ADAL" clId="{24AA5EA0-019C-4F21-85E1-DABB8C92714C}" dt="2022-01-31T20:07:05.784" v="3860" actId="20577"/>
          <ac:spMkLst>
            <pc:docMk/>
            <pc:sldMk cId="884979180" sldId="261"/>
            <ac:spMk id="5" creationId="{81A1EAC8-C9E3-4E56-B597-ED357EA10843}"/>
          </ac:spMkLst>
        </pc:spChg>
        <pc:graphicFrameChg chg="add del mod">
          <ac:chgData name="Anamthathmakula, Prashanth" userId="acd106aa-3bb0-4d16-b474-a7fd34266ac2" providerId="ADAL" clId="{24AA5EA0-019C-4F21-85E1-DABB8C92714C}" dt="2022-01-31T00:07:29.449" v="1783" actId="478"/>
          <ac:graphicFrameMkLst>
            <pc:docMk/>
            <pc:sldMk cId="884979180" sldId="261"/>
            <ac:graphicFrameMk id="3" creationId="{2D3BCE43-A105-4820-AA96-67392E0BE86B}"/>
          </ac:graphicFrameMkLst>
        </pc:graphicFrameChg>
        <pc:graphicFrameChg chg="add mod">
          <ac:chgData name="Anamthathmakula, Prashanth" userId="acd106aa-3bb0-4d16-b474-a7fd34266ac2" providerId="ADAL" clId="{24AA5EA0-019C-4F21-85E1-DABB8C92714C}" dt="2022-01-31T00:07:32.093" v="1784" actId="1076"/>
          <ac:graphicFrameMkLst>
            <pc:docMk/>
            <pc:sldMk cId="884979180" sldId="261"/>
            <ac:graphicFrameMk id="6" creationId="{99A9DD07-344A-445E-828A-AF45B28C6876}"/>
          </ac:graphicFrameMkLst>
        </pc:graphicFrameChg>
      </pc:sldChg>
      <pc:sldChg chg="addSp modSp add mod">
        <pc:chgData name="Anamthathmakula, Prashanth" userId="acd106aa-3bb0-4d16-b474-a7fd34266ac2" providerId="ADAL" clId="{24AA5EA0-019C-4F21-85E1-DABB8C92714C}" dt="2022-01-31T20:07:11.683" v="3861" actId="6549"/>
        <pc:sldMkLst>
          <pc:docMk/>
          <pc:sldMk cId="440835545" sldId="262"/>
        </pc:sldMkLst>
        <pc:spChg chg="add mod">
          <ac:chgData name="Anamthathmakula, Prashanth" userId="acd106aa-3bb0-4d16-b474-a7fd34266ac2" providerId="ADAL" clId="{24AA5EA0-019C-4F21-85E1-DABB8C92714C}" dt="2022-01-31T18:12:21.933" v="3095" actId="6549"/>
          <ac:spMkLst>
            <pc:docMk/>
            <pc:sldMk cId="440835545" sldId="262"/>
            <ac:spMk id="3" creationId="{27D501D6-590D-458C-9F77-0FAE0DEF729C}"/>
          </ac:spMkLst>
        </pc:spChg>
        <pc:spChg chg="add mod">
          <ac:chgData name="Anamthathmakula, Prashanth" userId="acd106aa-3bb0-4d16-b474-a7fd34266ac2" providerId="ADAL" clId="{24AA5EA0-019C-4F21-85E1-DABB8C92714C}" dt="2022-01-31T20:07:11.683" v="3861" actId="6549"/>
          <ac:spMkLst>
            <pc:docMk/>
            <pc:sldMk cId="440835545" sldId="262"/>
            <ac:spMk id="4" creationId="{51A371A4-F992-401D-99DC-23D34979F155}"/>
          </ac:spMkLst>
        </pc:spChg>
        <pc:graphicFrameChg chg="add mod">
          <ac:chgData name="Anamthathmakula, Prashanth" userId="acd106aa-3bb0-4d16-b474-a7fd34266ac2" providerId="ADAL" clId="{24AA5EA0-019C-4F21-85E1-DABB8C92714C}" dt="2022-01-31T00:07:36.158" v="1785" actId="1076"/>
          <ac:graphicFrameMkLst>
            <pc:docMk/>
            <pc:sldMk cId="440835545" sldId="262"/>
            <ac:graphicFrameMk id="2" creationId="{ABCDDB41-AB21-499B-80D6-089F7422558C}"/>
          </ac:graphicFrameMkLst>
        </pc:graphicFrameChg>
      </pc:sldChg>
      <pc:sldChg chg="addSp delSp modSp add mod modAnim">
        <pc:chgData name="Anamthathmakula, Prashanth" userId="acd106aa-3bb0-4d16-b474-a7fd34266ac2" providerId="ADAL" clId="{24AA5EA0-019C-4F21-85E1-DABB8C92714C}" dt="2022-02-01T00:17:19.095" v="4567" actId="20577"/>
        <pc:sldMkLst>
          <pc:docMk/>
          <pc:sldMk cId="1412564780" sldId="263"/>
        </pc:sldMkLst>
        <pc:spChg chg="add mod">
          <ac:chgData name="Anamthathmakula, Prashanth" userId="acd106aa-3bb0-4d16-b474-a7fd34266ac2" providerId="ADAL" clId="{24AA5EA0-019C-4F21-85E1-DABB8C92714C}" dt="2022-01-31T20:07:44.396" v="3894" actId="1036"/>
          <ac:spMkLst>
            <pc:docMk/>
            <pc:sldMk cId="1412564780" sldId="263"/>
            <ac:spMk id="2" creationId="{45D21E66-CB3B-4FD5-9476-14470AD4C663}"/>
          </ac:spMkLst>
        </pc:spChg>
        <pc:spChg chg="add mod">
          <ac:chgData name="Anamthathmakula, Prashanth" userId="acd106aa-3bb0-4d16-b474-a7fd34266ac2" providerId="ADAL" clId="{24AA5EA0-019C-4F21-85E1-DABB8C92714C}" dt="2022-01-31T20:07:34.526" v="3886" actId="1036"/>
          <ac:spMkLst>
            <pc:docMk/>
            <pc:sldMk cId="1412564780" sldId="263"/>
            <ac:spMk id="4" creationId="{38D4AE96-DD90-4CFC-8FE6-FB74547675C2}"/>
          </ac:spMkLst>
        </pc:spChg>
        <pc:spChg chg="add mod">
          <ac:chgData name="Anamthathmakula, Prashanth" userId="acd106aa-3bb0-4d16-b474-a7fd34266ac2" providerId="ADAL" clId="{24AA5EA0-019C-4F21-85E1-DABB8C92714C}" dt="2022-02-01T00:17:19.095" v="4567" actId="20577"/>
          <ac:spMkLst>
            <pc:docMk/>
            <pc:sldMk cId="1412564780" sldId="263"/>
            <ac:spMk id="5" creationId="{3C1551CF-09A6-4C89-8C72-B2B982B27272}"/>
          </ac:spMkLst>
        </pc:spChg>
        <pc:spChg chg="add del mod">
          <ac:chgData name="Anamthathmakula, Prashanth" userId="acd106aa-3bb0-4d16-b474-a7fd34266ac2" providerId="ADAL" clId="{24AA5EA0-019C-4F21-85E1-DABB8C92714C}" dt="2022-01-31T19:12:54.979" v="3589" actId="478"/>
          <ac:spMkLst>
            <pc:docMk/>
            <pc:sldMk cId="1412564780" sldId="263"/>
            <ac:spMk id="6" creationId="{3DE1DBA3-1802-4B94-8509-17D272FDE9FE}"/>
          </ac:spMkLst>
        </pc:spChg>
        <pc:spChg chg="add del mod">
          <ac:chgData name="Anamthathmakula, Prashanth" userId="acd106aa-3bb0-4d16-b474-a7fd34266ac2" providerId="ADAL" clId="{24AA5EA0-019C-4F21-85E1-DABB8C92714C}" dt="2022-01-31T19:13:07.365" v="3594"/>
          <ac:spMkLst>
            <pc:docMk/>
            <pc:sldMk cId="1412564780" sldId="263"/>
            <ac:spMk id="8" creationId="{13A98CB0-20DE-41F5-9667-5A59D7494834}"/>
          </ac:spMkLst>
        </pc:spChg>
        <pc:spChg chg="add del mod">
          <ac:chgData name="Anamthathmakula, Prashanth" userId="acd106aa-3bb0-4d16-b474-a7fd34266ac2" providerId="ADAL" clId="{24AA5EA0-019C-4F21-85E1-DABB8C92714C}" dt="2022-01-31T19:13:18.860" v="3599"/>
          <ac:spMkLst>
            <pc:docMk/>
            <pc:sldMk cId="1412564780" sldId="263"/>
            <ac:spMk id="10" creationId="{FE8BD12A-77ED-4A6C-A89A-4F8A7719C279}"/>
          </ac:spMkLst>
        </pc:spChg>
        <pc:spChg chg="add mod">
          <ac:chgData name="Anamthathmakula, Prashanth" userId="acd106aa-3bb0-4d16-b474-a7fd34266ac2" providerId="ADAL" clId="{24AA5EA0-019C-4F21-85E1-DABB8C92714C}" dt="2022-01-31T20:07:34.526" v="3886" actId="1036"/>
          <ac:spMkLst>
            <pc:docMk/>
            <pc:sldMk cId="1412564780" sldId="263"/>
            <ac:spMk id="11" creationId="{4073AE29-E657-4FFF-A04A-D82846581CBE}"/>
          </ac:spMkLst>
        </pc:spChg>
        <pc:spChg chg="add del mod">
          <ac:chgData name="Anamthathmakula, Prashanth" userId="acd106aa-3bb0-4d16-b474-a7fd34266ac2" providerId="ADAL" clId="{24AA5EA0-019C-4F21-85E1-DABB8C92714C}" dt="2022-01-31T19:13:49.314" v="3614"/>
          <ac:spMkLst>
            <pc:docMk/>
            <pc:sldMk cId="1412564780" sldId="263"/>
            <ac:spMk id="13" creationId="{6D3A385F-67FF-4EF0-BC1B-9D77EB148D89}"/>
          </ac:spMkLst>
        </pc:spChg>
        <pc:spChg chg="add del mod">
          <ac:chgData name="Anamthathmakula, Prashanth" userId="acd106aa-3bb0-4d16-b474-a7fd34266ac2" providerId="ADAL" clId="{24AA5EA0-019C-4F21-85E1-DABB8C92714C}" dt="2022-01-31T18:56:48.504" v="3403" actId="478"/>
          <ac:spMkLst>
            <pc:docMk/>
            <pc:sldMk cId="1412564780" sldId="263"/>
            <ac:spMk id="14" creationId="{ACCEDA13-464E-426F-958D-E7A090EE3EEA}"/>
          </ac:spMkLst>
        </pc:spChg>
        <pc:spChg chg="add del mod">
          <ac:chgData name="Anamthathmakula, Prashanth" userId="acd106aa-3bb0-4d16-b474-a7fd34266ac2" providerId="ADAL" clId="{24AA5EA0-019C-4F21-85E1-DABB8C92714C}" dt="2022-01-31T19:05:50.631" v="3538" actId="21"/>
          <ac:spMkLst>
            <pc:docMk/>
            <pc:sldMk cId="1412564780" sldId="263"/>
            <ac:spMk id="15" creationId="{FD6EA0D5-30C1-4C0B-8848-10C29AEC8FC5}"/>
          </ac:spMkLst>
        </pc:spChg>
        <pc:spChg chg="add del mod">
          <ac:chgData name="Anamthathmakula, Prashanth" userId="acd106aa-3bb0-4d16-b474-a7fd34266ac2" providerId="ADAL" clId="{24AA5EA0-019C-4F21-85E1-DABB8C92714C}" dt="2022-01-31T19:14:23.113" v="3619" actId="478"/>
          <ac:spMkLst>
            <pc:docMk/>
            <pc:sldMk cId="1412564780" sldId="263"/>
            <ac:spMk id="16" creationId="{39B5BE27-BFF8-4FB9-B843-EE317317E39D}"/>
          </ac:spMkLst>
        </pc:spChg>
        <pc:spChg chg="add del mod">
          <ac:chgData name="Anamthathmakula, Prashanth" userId="acd106aa-3bb0-4d16-b474-a7fd34266ac2" providerId="ADAL" clId="{24AA5EA0-019C-4F21-85E1-DABB8C92714C}" dt="2022-01-31T19:14:23.114" v="3621"/>
          <ac:spMkLst>
            <pc:docMk/>
            <pc:sldMk cId="1412564780" sldId="263"/>
            <ac:spMk id="18" creationId="{29D0E86F-09B7-4F87-947C-BC79CCD2DA63}"/>
          </ac:spMkLst>
        </pc:spChg>
        <pc:spChg chg="add mod">
          <ac:chgData name="Anamthathmakula, Prashanth" userId="acd106aa-3bb0-4d16-b474-a7fd34266ac2" providerId="ADAL" clId="{24AA5EA0-019C-4F21-85E1-DABB8C92714C}" dt="2022-01-31T19:16:55.742" v="3648" actId="571"/>
          <ac:spMkLst>
            <pc:docMk/>
            <pc:sldMk cId="1412564780" sldId="263"/>
            <ac:spMk id="19" creationId="{D009396C-51EE-4207-AB89-B96E04164C5D}"/>
          </ac:spMkLst>
        </pc:spChg>
        <pc:spChg chg="add mod">
          <ac:chgData name="Anamthathmakula, Prashanth" userId="acd106aa-3bb0-4d16-b474-a7fd34266ac2" providerId="ADAL" clId="{24AA5EA0-019C-4F21-85E1-DABB8C92714C}" dt="2022-01-31T19:16:55.742" v="3648" actId="571"/>
          <ac:spMkLst>
            <pc:docMk/>
            <pc:sldMk cId="1412564780" sldId="263"/>
            <ac:spMk id="20" creationId="{75B57BC7-A325-4AEA-B7C9-B2E0AC8C0619}"/>
          </ac:spMkLst>
        </pc:spChg>
      </pc:sldChg>
      <pc:sldChg chg="addSp delSp modSp add mod ord modAnim">
        <pc:chgData name="Anamthathmakula, Prashanth" userId="acd106aa-3bb0-4d16-b474-a7fd34266ac2" providerId="ADAL" clId="{24AA5EA0-019C-4F21-85E1-DABB8C92714C}" dt="2022-02-01T15:40:45.473" v="4676"/>
        <pc:sldMkLst>
          <pc:docMk/>
          <pc:sldMk cId="2130732338" sldId="264"/>
        </pc:sldMkLst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2" creationId="{A7B14A54-065E-457F-9B34-0D9E91528766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4" creationId="{D138B3FA-9200-4F9F-A1CF-BFEEA3FA7E87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5" creationId="{D56F740E-59EE-4F20-9588-161102EE92C5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6" creationId="{023F3340-538C-4A09-BBC0-C01D61C404BE}"/>
          </ac:spMkLst>
        </pc:spChg>
        <pc:spChg chg="mod ord">
          <ac:chgData name="Anamthathmakula, Prashanth" userId="acd106aa-3bb0-4d16-b474-a7fd34266ac2" providerId="ADAL" clId="{24AA5EA0-019C-4F21-85E1-DABB8C92714C}" dt="2022-01-30T23:07:43.330" v="1628" actId="1076"/>
          <ac:spMkLst>
            <pc:docMk/>
            <pc:sldMk cId="2130732338" sldId="264"/>
            <ac:spMk id="27" creationId="{A390A641-BA7C-4CE0-94EF-5729069DEB9D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8" creationId="{3F093D78-836F-4C60-A980-A985A5F24636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29" creationId="{5C1AFF33-A827-4DB6-A274-DCF3E2E50F0F}"/>
          </ac:spMkLst>
        </pc:spChg>
        <pc:spChg chg="mod or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30" creationId="{42E5163D-FF34-4123-88FF-FDC9016A9CD4}"/>
          </ac:spMkLst>
        </pc:spChg>
        <pc:spChg chg="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31" creationId="{09101D47-BD16-4E0B-8F30-97B1B99ACA1B}"/>
          </ac:spMkLst>
        </pc:spChg>
        <pc:spChg chg="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32" creationId="{3636C643-94B8-4C34-99CF-253441208569}"/>
          </ac:spMkLst>
        </pc:spChg>
        <pc:spChg chg="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33" creationId="{662591CC-8952-4BD9-B100-FE06EFDCAFE3}"/>
          </ac:spMkLst>
        </pc:spChg>
        <pc:spChg chg="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34" creationId="{26CBD004-0186-41D6-9EBF-E7E94A479F53}"/>
          </ac:spMkLst>
        </pc:spChg>
        <pc:spChg chg="add mod">
          <ac:chgData name="Anamthathmakula, Prashanth" userId="acd106aa-3bb0-4d16-b474-a7fd34266ac2" providerId="ADAL" clId="{24AA5EA0-019C-4F21-85E1-DABB8C92714C}" dt="2022-01-31T19:45:30.670" v="3696"/>
          <ac:spMkLst>
            <pc:docMk/>
            <pc:sldMk cId="2130732338" sldId="264"/>
            <ac:spMk id="35" creationId="{90CA3EAE-CDC5-47B3-9280-CC90E45409C5}"/>
          </ac:spMkLst>
        </pc:spChg>
        <pc:spChg chg="del">
          <ac:chgData name="Anamthathmakula, Prashanth" userId="acd106aa-3bb0-4d16-b474-a7fd34266ac2" providerId="ADAL" clId="{24AA5EA0-019C-4F21-85E1-DABB8C92714C}" dt="2022-01-30T19:24:07.135" v="708" actId="478"/>
          <ac:spMkLst>
            <pc:docMk/>
            <pc:sldMk cId="2130732338" sldId="264"/>
            <ac:spMk id="35" creationId="{D8EB419E-C2F1-490F-9BCB-53AF73E68B22}"/>
          </ac:spMkLst>
        </pc:spChg>
        <pc:spChg chg="del">
          <ac:chgData name="Anamthathmakula, Prashanth" userId="acd106aa-3bb0-4d16-b474-a7fd34266ac2" providerId="ADAL" clId="{24AA5EA0-019C-4F21-85E1-DABB8C92714C}" dt="2022-01-30T19:24:07.135" v="708" actId="478"/>
          <ac:spMkLst>
            <pc:docMk/>
            <pc:sldMk cId="2130732338" sldId="264"/>
            <ac:spMk id="36" creationId="{8848C951-7C2C-47D4-9240-B64E7506D2C1}"/>
          </ac:spMkLst>
        </pc:spChg>
        <pc:spChg chg="del">
          <ac:chgData name="Anamthathmakula, Prashanth" userId="acd106aa-3bb0-4d16-b474-a7fd34266ac2" providerId="ADAL" clId="{24AA5EA0-019C-4F21-85E1-DABB8C92714C}" dt="2022-01-30T19:24:07.135" v="708" actId="478"/>
          <ac:spMkLst>
            <pc:docMk/>
            <pc:sldMk cId="2130732338" sldId="264"/>
            <ac:spMk id="37" creationId="{3BB6EBE6-2CBA-44B5-A25C-175AEA1989C0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2" creationId="{39573674-561E-4AF0-AE70-A82568D99103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3" creationId="{19BBFC01-E05C-43B4-ABDE-50A14F3446CA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4" creationId="{2E40BC40-8150-4359-9C73-EAF4473B9D28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5" creationId="{C8836612-AD26-4BB4-95A2-351C9B2C5F06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6" creationId="{1445E117-479C-4532-A3EB-009C97FC9D97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7" creationId="{7DCAB017-4862-47E2-B932-70F3DE5AC5DF}"/>
          </ac:spMkLst>
        </pc:spChg>
        <pc:spChg chg="add mod">
          <ac:chgData name="Anamthathmakula, Prashanth" userId="acd106aa-3bb0-4d16-b474-a7fd34266ac2" providerId="ADAL" clId="{24AA5EA0-019C-4F21-85E1-DABB8C92714C}" dt="2022-01-30T19:55:42.442" v="1234" actId="1036"/>
          <ac:spMkLst>
            <pc:docMk/>
            <pc:sldMk cId="2130732338" sldId="264"/>
            <ac:spMk id="48" creationId="{A2BF4DD9-83C0-40D1-9F5E-502600C76488}"/>
          </ac:spMkLst>
        </pc:spChg>
        <pc:spChg chg="add del mod">
          <ac:chgData name="Anamthathmakula, Prashanth" userId="acd106aa-3bb0-4d16-b474-a7fd34266ac2" providerId="ADAL" clId="{24AA5EA0-019C-4F21-85E1-DABB8C92714C}" dt="2022-01-30T19:55:59.562" v="1236"/>
          <ac:spMkLst>
            <pc:docMk/>
            <pc:sldMk cId="2130732338" sldId="264"/>
            <ac:spMk id="49" creationId="{8BCA1AAD-AE4C-4437-8D4D-794248A18C56}"/>
          </ac:spMkLst>
        </pc:spChg>
        <pc:spChg chg="add mod">
          <ac:chgData name="Anamthathmakula, Prashanth" userId="acd106aa-3bb0-4d16-b474-a7fd34266ac2" providerId="ADAL" clId="{24AA5EA0-019C-4F21-85E1-DABB8C92714C}" dt="2022-01-30T19:56:26.678" v="1239"/>
          <ac:spMkLst>
            <pc:docMk/>
            <pc:sldMk cId="2130732338" sldId="264"/>
            <ac:spMk id="50" creationId="{91F2CA88-5E2C-4459-A9A6-110B7E7E04E0}"/>
          </ac:spMkLst>
        </pc:spChg>
        <pc:picChg chg="del">
          <ac:chgData name="Anamthathmakula, Prashanth" userId="acd106aa-3bb0-4d16-b474-a7fd34266ac2" providerId="ADAL" clId="{24AA5EA0-019C-4F21-85E1-DABB8C92714C}" dt="2022-01-30T19:00:06.341" v="480" actId="478"/>
          <ac:picMkLst>
            <pc:docMk/>
            <pc:sldMk cId="2130732338" sldId="264"/>
            <ac:picMk id="3" creationId="{9D4CB597-BC42-4E7C-91D7-863ED537450A}"/>
          </ac:picMkLst>
        </pc:picChg>
        <pc:picChg chg="add del mod">
          <ac:chgData name="Anamthathmakula, Prashanth" userId="acd106aa-3bb0-4d16-b474-a7fd34266ac2" providerId="ADAL" clId="{24AA5EA0-019C-4F21-85E1-DABB8C92714C}" dt="2022-01-30T19:15:25.693" v="565" actId="478"/>
          <ac:picMkLst>
            <pc:docMk/>
            <pc:sldMk cId="2130732338" sldId="264"/>
            <ac:picMk id="4" creationId="{8448C1E8-714B-47A8-B533-92AE65908E94}"/>
          </ac:picMkLst>
        </pc:picChg>
        <pc:picChg chg="del">
          <ac:chgData name="Anamthathmakula, Prashanth" userId="acd106aa-3bb0-4d16-b474-a7fd34266ac2" providerId="ADAL" clId="{24AA5EA0-019C-4F21-85E1-DABB8C92714C}" dt="2022-01-30T18:59:30.135" v="426" actId="478"/>
          <ac:picMkLst>
            <pc:docMk/>
            <pc:sldMk cId="2130732338" sldId="264"/>
            <ac:picMk id="5" creationId="{833403CE-45E6-4BD0-ABD2-43B4E8768435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7" creationId="{F25F0C71-DCE5-4895-988F-D1E8A5C0C1A5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9" creationId="{504100B5-AC5C-4F67-B32F-35DA9B08162F}"/>
          </ac:picMkLst>
        </pc:picChg>
        <pc:picChg chg="del">
          <ac:chgData name="Anamthathmakula, Prashanth" userId="acd106aa-3bb0-4d16-b474-a7fd34266ac2" providerId="ADAL" clId="{24AA5EA0-019C-4F21-85E1-DABB8C92714C}" dt="2022-01-30T19:00:12.136" v="482" actId="478"/>
          <ac:picMkLst>
            <pc:docMk/>
            <pc:sldMk cId="2130732338" sldId="264"/>
            <ac:picMk id="11" creationId="{07DD7EAF-80BA-4F92-A29B-B5F265F1025F}"/>
          </ac:picMkLst>
        </pc:picChg>
        <pc:picChg chg="add del mod">
          <ac:chgData name="Anamthathmakula, Prashanth" userId="acd106aa-3bb0-4d16-b474-a7fd34266ac2" providerId="ADAL" clId="{24AA5EA0-019C-4F21-85E1-DABB8C92714C}" dt="2022-01-30T19:16:15.572" v="621" actId="478"/>
          <ac:picMkLst>
            <pc:docMk/>
            <pc:sldMk cId="2130732338" sldId="264"/>
            <ac:picMk id="12" creationId="{1D835012-7E9A-470A-922C-356985D1B6C1}"/>
          </ac:picMkLst>
        </pc:picChg>
        <pc:picChg chg="del">
          <ac:chgData name="Anamthathmakula, Prashanth" userId="acd106aa-3bb0-4d16-b474-a7fd34266ac2" providerId="ADAL" clId="{24AA5EA0-019C-4F21-85E1-DABB8C92714C}" dt="2022-01-30T19:00:18.903" v="484" actId="478"/>
          <ac:picMkLst>
            <pc:docMk/>
            <pc:sldMk cId="2130732338" sldId="264"/>
            <ac:picMk id="13" creationId="{14F49E18-610C-4096-BAC1-1416B7924DB1}"/>
          </ac:picMkLst>
        </pc:picChg>
        <pc:picChg chg="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15" creationId="{DF2F8D5F-4BE9-43F0-8316-7C2FCCF12797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16" creationId="{F8B710AE-B168-43AE-8D6B-9F4A4EBD1622}"/>
          </ac:picMkLst>
        </pc:picChg>
        <pc:picChg chg="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17" creationId="{91F1BEEC-E3E5-45F5-ACC0-97F90E78160C}"/>
          </ac:picMkLst>
        </pc:picChg>
        <pc:picChg chg="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19" creationId="{B2F47124-A154-428D-B584-6E16CA2C4D19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20" creationId="{03B85639-C220-465C-BD3E-61181D9A1498}"/>
          </ac:picMkLst>
        </pc:picChg>
        <pc:picChg chg="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21" creationId="{8A599DEF-09A2-4DD3-A5AB-9F924C1E6B2B}"/>
          </ac:picMkLst>
        </pc:picChg>
        <pc:picChg chg="add del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38" creationId="{24111C7D-1F22-4A03-A266-88F2F56FDBD0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39" creationId="{E221B4B0-8859-4863-8F1E-2A23454AB213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40" creationId="{87DF82CB-85BD-4622-BDC3-157EB08388D4}"/>
          </ac:picMkLst>
        </pc:picChg>
        <pc:picChg chg="add mod">
          <ac:chgData name="Anamthathmakula, Prashanth" userId="acd106aa-3bb0-4d16-b474-a7fd34266ac2" providerId="ADAL" clId="{24AA5EA0-019C-4F21-85E1-DABB8C92714C}" dt="2022-01-30T19:55:42.442" v="1234" actId="1036"/>
          <ac:picMkLst>
            <pc:docMk/>
            <pc:sldMk cId="2130732338" sldId="264"/>
            <ac:picMk id="41" creationId="{5125D295-6692-4E1A-A91E-87A1C2DD9CCC}"/>
          </ac:picMkLst>
        </pc:picChg>
      </pc:sldChg>
      <pc:sldChg chg="addSp delSp modSp add mod modAnim">
        <pc:chgData name="Anamthathmakula, Prashanth" userId="acd106aa-3bb0-4d16-b474-a7fd34266ac2" providerId="ADAL" clId="{24AA5EA0-019C-4F21-85E1-DABB8C92714C}" dt="2022-01-31T23:38:29.876" v="4249"/>
        <pc:sldMkLst>
          <pc:docMk/>
          <pc:sldMk cId="3051900559" sldId="265"/>
        </pc:sldMkLst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7" creationId="{CFC4095F-154E-4A31-8C0A-06C6B2C345F1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8" creationId="{F88F143E-2EE9-4F88-8617-89A2FF291879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9" creationId="{76CDA92A-B237-4591-9F96-CCCEDDBFEBB6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13" creationId="{396301ED-A594-4467-8323-41AC71FF3DFD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14" creationId="{EE435A3B-49F3-4E6C-963F-8977F38A0380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16" creationId="{71890582-6B6F-48F3-A3BA-3C9DE85FC78D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19" creationId="{560CBCCC-AB50-4BB3-B649-9D2C6A5049C0}"/>
          </ac:spMkLst>
        </pc:spChg>
        <pc:spChg chg="mod">
          <ac:chgData name="Anamthathmakula, Prashanth" userId="acd106aa-3bb0-4d16-b474-a7fd34266ac2" providerId="ADAL" clId="{24AA5EA0-019C-4F21-85E1-DABB8C92714C}" dt="2022-01-31T20:07:01.799" v="3859" actId="20577"/>
          <ac:spMkLst>
            <pc:docMk/>
            <pc:sldMk cId="3051900559" sldId="265"/>
            <ac:spMk id="44" creationId="{338D29B4-02E2-4D20-A731-4A2684B40490}"/>
          </ac:spMkLst>
        </pc:spChg>
        <pc:spChg chg="mod">
          <ac:chgData name="Anamthathmakula, Prashanth" userId="acd106aa-3bb0-4d16-b474-a7fd34266ac2" providerId="ADAL" clId="{24AA5EA0-019C-4F21-85E1-DABB8C92714C}" dt="2022-01-31T23:24:17.014" v="4010" actId="1035"/>
          <ac:spMkLst>
            <pc:docMk/>
            <pc:sldMk cId="3051900559" sldId="265"/>
            <ac:spMk id="45" creationId="{A455588E-6894-402B-95FB-0A33A6356546}"/>
          </ac:spMkLst>
        </pc:spChg>
        <pc:spChg chg="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46" creationId="{C78A37DB-D90C-45F2-A79A-9DB335D7E916}"/>
          </ac:spMkLst>
        </pc:spChg>
        <pc:spChg chg="add 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47" creationId="{50110AAF-A2E3-46E6-96D5-F56E87616AB5}"/>
          </ac:spMkLst>
        </pc:spChg>
        <pc:spChg chg="add mod">
          <ac:chgData name="Anamthathmakula, Prashanth" userId="acd106aa-3bb0-4d16-b474-a7fd34266ac2" providerId="ADAL" clId="{24AA5EA0-019C-4F21-85E1-DABB8C92714C}" dt="2022-01-31T23:23:45.572" v="3954" actId="1038"/>
          <ac:spMkLst>
            <pc:docMk/>
            <pc:sldMk cId="3051900559" sldId="265"/>
            <ac:spMk id="48" creationId="{0FF19B30-5548-450C-AAD1-03DFFA26AA3C}"/>
          </ac:spMkLst>
        </pc:spChg>
        <pc:spChg chg="add mod">
          <ac:chgData name="Anamthathmakula, Prashanth" userId="acd106aa-3bb0-4d16-b474-a7fd34266ac2" providerId="ADAL" clId="{24AA5EA0-019C-4F21-85E1-DABB8C92714C}" dt="2022-01-31T23:25:06.775" v="4074" actId="1038"/>
          <ac:spMkLst>
            <pc:docMk/>
            <pc:sldMk cId="3051900559" sldId="265"/>
            <ac:spMk id="49" creationId="{1C945CAF-B123-4390-992A-869CA876B7FC}"/>
          </ac:spMkLst>
        </pc:spChg>
        <pc:spChg chg="mod">
          <ac:chgData name="Anamthathmakula, Prashanth" userId="acd106aa-3bb0-4d16-b474-a7fd34266ac2" providerId="ADAL" clId="{24AA5EA0-019C-4F21-85E1-DABB8C92714C}" dt="2022-01-31T23:24:28.205" v="4044" actId="1035"/>
          <ac:spMkLst>
            <pc:docMk/>
            <pc:sldMk cId="3051900559" sldId="265"/>
            <ac:spMk id="50" creationId="{84469AD4-9C55-4B5E-9176-749D1FD8EFD0}"/>
          </ac:spMkLst>
        </pc:spChg>
        <pc:spChg chg="del">
          <ac:chgData name="Anamthathmakula, Prashanth" userId="acd106aa-3bb0-4d16-b474-a7fd34266ac2" providerId="ADAL" clId="{24AA5EA0-019C-4F21-85E1-DABB8C92714C}" dt="2022-01-30T20:05:38.583" v="1316" actId="478"/>
          <ac:spMkLst>
            <pc:docMk/>
            <pc:sldMk cId="3051900559" sldId="265"/>
            <ac:spMk id="51" creationId="{ECBEB36A-7CC2-49C8-B48E-B946BFB0A784}"/>
          </ac:spMkLst>
        </pc:spChg>
        <pc:spChg chg="del">
          <ac:chgData name="Anamthathmakula, Prashanth" userId="acd106aa-3bb0-4d16-b474-a7fd34266ac2" providerId="ADAL" clId="{24AA5EA0-019C-4F21-85E1-DABB8C92714C}" dt="2022-01-30T20:05:40.325" v="1317" actId="478"/>
          <ac:spMkLst>
            <pc:docMk/>
            <pc:sldMk cId="3051900559" sldId="265"/>
            <ac:spMk id="52" creationId="{FD91621E-8A30-4C14-B91C-F206F35BE4DF}"/>
          </ac:spMkLst>
        </pc:spChg>
        <pc:grpChg chg="mod">
          <ac:chgData name="Anamthathmakula, Prashanth" userId="acd106aa-3bb0-4d16-b474-a7fd34266ac2" providerId="ADAL" clId="{24AA5EA0-019C-4F21-85E1-DABB8C92714C}" dt="2022-01-31T23:24:36.246" v="4062" actId="1036"/>
          <ac:grpSpMkLst>
            <pc:docMk/>
            <pc:sldMk cId="3051900559" sldId="265"/>
            <ac:grpSpMk id="20" creationId="{A1DEF820-A1B9-4511-815B-E5AC8710D3D9}"/>
          </ac:grpSpMkLst>
        </pc:grpChg>
        <pc:graphicFrameChg chg="del">
          <ac:chgData name="Anamthathmakula, Prashanth" userId="acd106aa-3bb0-4d16-b474-a7fd34266ac2" providerId="ADAL" clId="{24AA5EA0-019C-4F21-85E1-DABB8C92714C}" dt="2022-01-31T00:08:07.417" v="1789" actId="478"/>
          <ac:graphicFrameMkLst>
            <pc:docMk/>
            <pc:sldMk cId="3051900559" sldId="265"/>
            <ac:graphicFrameMk id="49" creationId="{13D813FE-37FD-469A-A98D-2C4C00EDC283}"/>
          </ac:graphicFrameMkLst>
        </pc:graphicFrameChg>
        <pc:graphicFrameChg chg="add mod">
          <ac:chgData name="Anamthathmakula, Prashanth" userId="acd106aa-3bb0-4d16-b474-a7fd34266ac2" providerId="ADAL" clId="{24AA5EA0-019C-4F21-85E1-DABB8C92714C}" dt="2022-01-31T23:24:28.205" v="4044" actId="1035"/>
          <ac:graphicFrameMkLst>
            <pc:docMk/>
            <pc:sldMk cId="3051900559" sldId="265"/>
            <ac:graphicFrameMk id="53" creationId="{B57265BB-C8C4-48AA-82E3-60439F1838FE}"/>
          </ac:graphicFrameMkLst>
        </pc:graphicFrameChg>
        <pc:picChg chg="add del mod">
          <ac:chgData name="Anamthathmakula, Prashanth" userId="acd106aa-3bb0-4d16-b474-a7fd34266ac2" providerId="ADAL" clId="{24AA5EA0-019C-4F21-85E1-DABB8C92714C}" dt="2022-01-31T23:27:49.282" v="4088" actId="478"/>
          <ac:picMkLst>
            <pc:docMk/>
            <pc:sldMk cId="3051900559" sldId="265"/>
            <ac:picMk id="3" creationId="{E819B03B-DDE0-41E5-BDE5-972866EA84A0}"/>
          </ac:picMkLst>
        </pc:picChg>
        <pc:picChg chg="add mod">
          <ac:chgData name="Anamthathmakula, Prashanth" userId="acd106aa-3bb0-4d16-b474-a7fd34266ac2" providerId="ADAL" clId="{24AA5EA0-019C-4F21-85E1-DABB8C92714C}" dt="2022-01-31T23:32:22.362" v="4199" actId="1076"/>
          <ac:picMkLst>
            <pc:docMk/>
            <pc:sldMk cId="3051900559" sldId="265"/>
            <ac:picMk id="5" creationId="{7F2D0A9E-0B82-45BC-B98C-5883A1EE926C}"/>
          </ac:picMkLst>
        </pc:picChg>
        <pc:picChg chg="mod">
          <ac:chgData name="Anamthathmakula, Prashanth" userId="acd106aa-3bb0-4d16-b474-a7fd34266ac2" providerId="ADAL" clId="{24AA5EA0-019C-4F21-85E1-DABB8C92714C}" dt="2022-01-31T23:23:45.572" v="3954" actId="1038"/>
          <ac:picMkLst>
            <pc:docMk/>
            <pc:sldMk cId="3051900559" sldId="265"/>
            <ac:picMk id="11" creationId="{BF45CA3C-7D47-4E60-BD24-DD472DAEF245}"/>
          </ac:picMkLst>
        </pc:picChg>
        <pc:picChg chg="mod">
          <ac:chgData name="Anamthathmakula, Prashanth" userId="acd106aa-3bb0-4d16-b474-a7fd34266ac2" providerId="ADAL" clId="{24AA5EA0-019C-4F21-85E1-DABB8C92714C}" dt="2022-01-31T23:23:45.572" v="3954" actId="1038"/>
          <ac:picMkLst>
            <pc:docMk/>
            <pc:sldMk cId="3051900559" sldId="265"/>
            <ac:picMk id="12" creationId="{F0C5DBB8-0B24-413F-BB78-1E02CFAA843C}"/>
          </ac:picMkLst>
        </pc:picChg>
        <pc:picChg chg="mod">
          <ac:chgData name="Anamthathmakula, Prashanth" userId="acd106aa-3bb0-4d16-b474-a7fd34266ac2" providerId="ADAL" clId="{24AA5EA0-019C-4F21-85E1-DABB8C92714C}" dt="2022-01-31T23:23:45.572" v="3954" actId="1038"/>
          <ac:picMkLst>
            <pc:docMk/>
            <pc:sldMk cId="3051900559" sldId="265"/>
            <ac:picMk id="15" creationId="{FB298194-7AF5-409C-9BBB-40CEA2DDC929}"/>
          </ac:picMkLst>
        </pc:picChg>
        <pc:picChg chg="add mod">
          <ac:chgData name="Anamthathmakula, Prashanth" userId="acd106aa-3bb0-4d16-b474-a7fd34266ac2" providerId="ADAL" clId="{24AA5EA0-019C-4F21-85E1-DABB8C92714C}" dt="2022-01-31T23:29:27.461" v="4113" actId="1037"/>
          <ac:picMkLst>
            <pc:docMk/>
            <pc:sldMk cId="3051900559" sldId="265"/>
            <ac:picMk id="51" creationId="{FC5E5DE5-23A0-4CD0-A24D-29C1E8EF1EEA}"/>
          </ac:picMkLst>
        </pc:picChg>
        <pc:cxnChg chg="mod">
          <ac:chgData name="Anamthathmakula, Prashanth" userId="acd106aa-3bb0-4d16-b474-a7fd34266ac2" providerId="ADAL" clId="{24AA5EA0-019C-4F21-85E1-DABB8C92714C}" dt="2022-01-31T23:23:45.572" v="3954" actId="1038"/>
          <ac:cxnSpMkLst>
            <pc:docMk/>
            <pc:sldMk cId="3051900559" sldId="265"/>
            <ac:cxnSpMk id="10" creationId="{5982FAA1-6E5A-4335-92F3-B61CDF2F894D}"/>
          </ac:cxnSpMkLst>
        </pc:cxnChg>
        <pc:cxnChg chg="mod">
          <ac:chgData name="Anamthathmakula, Prashanth" userId="acd106aa-3bb0-4d16-b474-a7fd34266ac2" providerId="ADAL" clId="{24AA5EA0-019C-4F21-85E1-DABB8C92714C}" dt="2022-01-31T23:23:45.572" v="3954" actId="1038"/>
          <ac:cxnSpMkLst>
            <pc:docMk/>
            <pc:sldMk cId="3051900559" sldId="265"/>
            <ac:cxnSpMk id="17" creationId="{13F262DE-60CA-4A5E-851F-F7027F85F917}"/>
          </ac:cxnSpMkLst>
        </pc:cxnChg>
        <pc:cxnChg chg="mod">
          <ac:chgData name="Anamthathmakula, Prashanth" userId="acd106aa-3bb0-4d16-b474-a7fd34266ac2" providerId="ADAL" clId="{24AA5EA0-019C-4F21-85E1-DABB8C92714C}" dt="2022-01-31T23:23:45.572" v="3954" actId="1038"/>
          <ac:cxnSpMkLst>
            <pc:docMk/>
            <pc:sldMk cId="3051900559" sldId="265"/>
            <ac:cxnSpMk id="18" creationId="{21C66827-BB99-417A-B6A0-168D3ADC1C06}"/>
          </ac:cxnSpMkLst>
        </pc:cxnChg>
        <pc:cxnChg chg="add mod">
          <ac:chgData name="Anamthathmakula, Prashanth" userId="acd106aa-3bb0-4d16-b474-a7fd34266ac2" providerId="ADAL" clId="{24AA5EA0-019C-4F21-85E1-DABB8C92714C}" dt="2022-01-31T23:33:42.633" v="4208" actId="693"/>
          <ac:cxnSpMkLst>
            <pc:docMk/>
            <pc:sldMk cId="3051900559" sldId="265"/>
            <ac:cxnSpMk id="54" creationId="{F3B923A3-20FD-4803-B354-95499013A562}"/>
          </ac:cxnSpMkLst>
        </pc:cxnChg>
        <pc:cxnChg chg="add mod">
          <ac:chgData name="Anamthathmakula, Prashanth" userId="acd106aa-3bb0-4d16-b474-a7fd34266ac2" providerId="ADAL" clId="{24AA5EA0-019C-4F21-85E1-DABB8C92714C}" dt="2022-01-31T23:33:55.947" v="4209" actId="693"/>
          <ac:cxnSpMkLst>
            <pc:docMk/>
            <pc:sldMk cId="3051900559" sldId="265"/>
            <ac:cxnSpMk id="55" creationId="{EC5B6035-9C91-4567-8E2E-384F15FB2E80}"/>
          </ac:cxnSpMkLst>
        </pc:cxnChg>
        <pc:cxnChg chg="add mod">
          <ac:chgData name="Anamthathmakula, Prashanth" userId="acd106aa-3bb0-4d16-b474-a7fd34266ac2" providerId="ADAL" clId="{24AA5EA0-019C-4F21-85E1-DABB8C92714C}" dt="2022-01-31T23:34:23.803" v="4210" actId="693"/>
          <ac:cxnSpMkLst>
            <pc:docMk/>
            <pc:sldMk cId="3051900559" sldId="265"/>
            <ac:cxnSpMk id="63" creationId="{C1D0D351-3A7F-46FB-A68E-016D3C142EBC}"/>
          </ac:cxnSpMkLst>
        </pc:cxnChg>
        <pc:cxnChg chg="add mod">
          <ac:chgData name="Anamthathmakula, Prashanth" userId="acd106aa-3bb0-4d16-b474-a7fd34266ac2" providerId="ADAL" clId="{24AA5EA0-019C-4F21-85E1-DABB8C92714C}" dt="2022-01-31T23:34:23.803" v="4210" actId="693"/>
          <ac:cxnSpMkLst>
            <pc:docMk/>
            <pc:sldMk cId="3051900559" sldId="265"/>
            <ac:cxnSpMk id="64" creationId="{530D4952-86C0-44B9-9780-9802D3E210C0}"/>
          </ac:cxnSpMkLst>
        </pc:cxnChg>
      </pc:sldChg>
      <pc:sldChg chg="addSp delSp modSp new mod modAnim">
        <pc:chgData name="Anamthathmakula, Prashanth" userId="acd106aa-3bb0-4d16-b474-a7fd34266ac2" providerId="ADAL" clId="{24AA5EA0-019C-4F21-85E1-DABB8C92714C}" dt="2022-01-31T20:15:00.138" v="3920" actId="20577"/>
        <pc:sldMkLst>
          <pc:docMk/>
          <pc:sldMk cId="1376286918" sldId="266"/>
        </pc:sldMkLst>
        <pc:spChg chg="del">
          <ac:chgData name="Anamthathmakula, Prashanth" userId="acd106aa-3bb0-4d16-b474-a7fd34266ac2" providerId="ADAL" clId="{24AA5EA0-019C-4F21-85E1-DABB8C92714C}" dt="2022-01-30T20:07:21.946" v="1326" actId="478"/>
          <ac:spMkLst>
            <pc:docMk/>
            <pc:sldMk cId="1376286918" sldId="266"/>
            <ac:spMk id="2" creationId="{F0986A75-0126-41FA-8645-8331507B2AC5}"/>
          </ac:spMkLst>
        </pc:spChg>
        <pc:spChg chg="add mod">
          <ac:chgData name="Anamthathmakula, Prashanth" userId="acd106aa-3bb0-4d16-b474-a7fd34266ac2" providerId="ADAL" clId="{24AA5EA0-019C-4F21-85E1-DABB8C92714C}" dt="2022-01-31T17:29:12.839" v="2704" actId="20577"/>
          <ac:spMkLst>
            <pc:docMk/>
            <pc:sldMk cId="1376286918" sldId="266"/>
            <ac:spMk id="3" creationId="{7EEBA7FA-3411-4CE4-A5AF-0139EEF0F7D6}"/>
          </ac:spMkLst>
        </pc:spChg>
        <pc:spChg chg="del">
          <ac:chgData name="Anamthathmakula, Prashanth" userId="acd106aa-3bb0-4d16-b474-a7fd34266ac2" providerId="ADAL" clId="{24AA5EA0-019C-4F21-85E1-DABB8C92714C}" dt="2022-01-30T20:07:21.946" v="1326" actId="478"/>
          <ac:spMkLst>
            <pc:docMk/>
            <pc:sldMk cId="1376286918" sldId="266"/>
            <ac:spMk id="3" creationId="{C9BADEA5-E42F-40DC-9739-76F0253B896C}"/>
          </ac:spMkLst>
        </pc:spChg>
        <pc:spChg chg="add del mod">
          <ac:chgData name="Anamthathmakula, Prashanth" userId="acd106aa-3bb0-4d16-b474-a7fd34266ac2" providerId="ADAL" clId="{24AA5EA0-019C-4F21-85E1-DABB8C92714C}" dt="2022-01-31T17:28:53.902" v="2686" actId="478"/>
          <ac:spMkLst>
            <pc:docMk/>
            <pc:sldMk cId="1376286918" sldId="266"/>
            <ac:spMk id="4" creationId="{E7BF97A9-03C8-4510-ABBB-BB95A9449B95}"/>
          </ac:spMkLst>
        </pc:spChg>
        <pc:spChg chg="add mod">
          <ac:chgData name="Anamthathmakula, Prashanth" userId="acd106aa-3bb0-4d16-b474-a7fd34266ac2" providerId="ADAL" clId="{24AA5EA0-019C-4F21-85E1-DABB8C92714C}" dt="2022-01-31T18:07:19.555" v="3083" actId="114"/>
          <ac:spMkLst>
            <pc:docMk/>
            <pc:sldMk cId="1376286918" sldId="266"/>
            <ac:spMk id="5" creationId="{F809B2B3-7492-40AE-AE81-D6647EF0088F}"/>
          </ac:spMkLst>
        </pc:spChg>
        <pc:spChg chg="add mod">
          <ac:chgData name="Anamthathmakula, Prashanth" userId="acd106aa-3bb0-4d16-b474-a7fd34266ac2" providerId="ADAL" clId="{24AA5EA0-019C-4F21-85E1-DABB8C92714C}" dt="2022-01-31T20:14:57.291" v="3919" actId="20577"/>
          <ac:spMkLst>
            <pc:docMk/>
            <pc:sldMk cId="1376286918" sldId="266"/>
            <ac:spMk id="6" creationId="{B59F3C19-DF63-4761-8093-DBE93A663FCF}"/>
          </ac:spMkLst>
        </pc:spChg>
        <pc:spChg chg="add del mod">
          <ac:chgData name="Anamthathmakula, Prashanth" userId="acd106aa-3bb0-4d16-b474-a7fd34266ac2" providerId="ADAL" clId="{24AA5EA0-019C-4F21-85E1-DABB8C92714C}" dt="2022-01-31T18:01:05.346" v="3013" actId="478"/>
          <ac:spMkLst>
            <pc:docMk/>
            <pc:sldMk cId="1376286918" sldId="266"/>
            <ac:spMk id="9" creationId="{73D61961-BE88-4694-A687-2ED61FC63D5D}"/>
          </ac:spMkLst>
        </pc:spChg>
        <pc:picChg chg="add mod">
          <ac:chgData name="Anamthathmakula, Prashanth" userId="acd106aa-3bb0-4d16-b474-a7fd34266ac2" providerId="ADAL" clId="{24AA5EA0-019C-4F21-85E1-DABB8C92714C}" dt="2022-01-31T18:01:11.606" v="3014" actId="1076"/>
          <ac:picMkLst>
            <pc:docMk/>
            <pc:sldMk cId="1376286918" sldId="266"/>
            <ac:picMk id="7" creationId="{BD8C1331-3658-4DCE-88AF-8100FBBF2458}"/>
          </ac:picMkLst>
        </pc:picChg>
      </pc:sldChg>
      <pc:sldChg chg="addSp delSp modSp new mod modAnim">
        <pc:chgData name="Anamthathmakula, Prashanth" userId="acd106aa-3bb0-4d16-b474-a7fd34266ac2" providerId="ADAL" clId="{24AA5EA0-019C-4F21-85E1-DABB8C92714C}" dt="2022-01-31T19:47:27.829" v="3714" actId="6549"/>
        <pc:sldMkLst>
          <pc:docMk/>
          <pc:sldMk cId="114451985" sldId="267"/>
        </pc:sldMkLst>
        <pc:spChg chg="del">
          <ac:chgData name="Anamthathmakula, Prashanth" userId="acd106aa-3bb0-4d16-b474-a7fd34266ac2" providerId="ADAL" clId="{24AA5EA0-019C-4F21-85E1-DABB8C92714C}" dt="2022-01-30T20:07:36.042" v="1328" actId="478"/>
          <ac:spMkLst>
            <pc:docMk/>
            <pc:sldMk cId="114451985" sldId="267"/>
            <ac:spMk id="2" creationId="{AFEF865A-F448-4E84-A4EC-A45530BB9347}"/>
          </ac:spMkLst>
        </pc:spChg>
        <pc:spChg chg="del">
          <ac:chgData name="Anamthathmakula, Prashanth" userId="acd106aa-3bb0-4d16-b474-a7fd34266ac2" providerId="ADAL" clId="{24AA5EA0-019C-4F21-85E1-DABB8C92714C}" dt="2022-01-30T20:07:36.042" v="1328" actId="478"/>
          <ac:spMkLst>
            <pc:docMk/>
            <pc:sldMk cId="114451985" sldId="267"/>
            <ac:spMk id="3" creationId="{4956B8F0-9487-467C-A3D1-888B284790E5}"/>
          </ac:spMkLst>
        </pc:spChg>
        <pc:spChg chg="add mod">
          <ac:chgData name="Anamthathmakula, Prashanth" userId="acd106aa-3bb0-4d16-b474-a7fd34266ac2" providerId="ADAL" clId="{24AA5EA0-019C-4F21-85E1-DABB8C92714C}" dt="2022-01-31T19:47:27.829" v="3714" actId="6549"/>
          <ac:spMkLst>
            <pc:docMk/>
            <pc:sldMk cId="114451985" sldId="267"/>
            <ac:spMk id="24" creationId="{AEC4B2D0-4978-4154-A8B9-C67D61C533EB}"/>
          </ac:spMkLst>
        </pc:spChg>
        <pc:spChg chg="add mod">
          <ac:chgData name="Anamthathmakula, Prashanth" userId="acd106aa-3bb0-4d16-b474-a7fd34266ac2" providerId="ADAL" clId="{24AA5EA0-019C-4F21-85E1-DABB8C92714C}" dt="2022-01-30T23:06:38.850" v="1620" actId="1076"/>
          <ac:spMkLst>
            <pc:docMk/>
            <pc:sldMk cId="114451985" sldId="267"/>
            <ac:spMk id="26" creationId="{5AEE5CD8-5FC9-4143-8694-DB3FFC7B8C4B}"/>
          </ac:spMkLst>
        </pc:spChg>
        <pc:spChg chg="add mod">
          <ac:chgData name="Anamthathmakula, Prashanth" userId="acd106aa-3bb0-4d16-b474-a7fd34266ac2" providerId="ADAL" clId="{24AA5EA0-019C-4F21-85E1-DABB8C92714C}" dt="2022-01-30T23:06:47.753" v="1621" actId="1076"/>
          <ac:spMkLst>
            <pc:docMk/>
            <pc:sldMk cId="114451985" sldId="267"/>
            <ac:spMk id="27" creationId="{C33245C5-0809-4D8F-9EE0-F1A95C0D9A7C}"/>
          </ac:spMkLst>
        </pc:spChg>
        <pc:spChg chg="add mod">
          <ac:chgData name="Anamthathmakula, Prashanth" userId="acd106aa-3bb0-4d16-b474-a7fd34266ac2" providerId="ADAL" clId="{24AA5EA0-019C-4F21-85E1-DABB8C92714C}" dt="2022-01-30T23:07:23.978" v="1626" actId="1076"/>
          <ac:spMkLst>
            <pc:docMk/>
            <pc:sldMk cId="114451985" sldId="267"/>
            <ac:spMk id="28" creationId="{A46743DD-38E5-414D-94DB-1B578F971729}"/>
          </ac:spMkLst>
        </pc:spChg>
        <pc:spChg chg="add mod">
          <ac:chgData name="Anamthathmakula, Prashanth" userId="acd106aa-3bb0-4d16-b474-a7fd34266ac2" providerId="ADAL" clId="{24AA5EA0-019C-4F21-85E1-DABB8C92714C}" dt="2022-01-30T23:07:06.658" v="1623" actId="1076"/>
          <ac:spMkLst>
            <pc:docMk/>
            <pc:sldMk cId="114451985" sldId="267"/>
            <ac:spMk id="29" creationId="{C4EF1A79-043B-4C0C-9388-8D0642C699CE}"/>
          </ac:spMkLst>
        </pc:spChg>
        <pc:spChg chg="add mod">
          <ac:chgData name="Anamthathmakula, Prashanth" userId="acd106aa-3bb0-4d16-b474-a7fd34266ac2" providerId="ADAL" clId="{24AA5EA0-019C-4F21-85E1-DABB8C92714C}" dt="2022-01-30T23:07:15.346" v="1625" actId="1076"/>
          <ac:spMkLst>
            <pc:docMk/>
            <pc:sldMk cId="114451985" sldId="267"/>
            <ac:spMk id="30" creationId="{E8EF5CEB-8B8E-4D6A-ABF8-72C8AE0E1A1E}"/>
          </ac:spMkLst>
        </pc:spChg>
        <pc:spChg chg="add mod">
          <ac:chgData name="Anamthathmakula, Prashanth" userId="acd106aa-3bb0-4d16-b474-a7fd34266ac2" providerId="ADAL" clId="{24AA5EA0-019C-4F21-85E1-DABB8C92714C}" dt="2022-01-30T23:07:29.825" v="1627" actId="1076"/>
          <ac:spMkLst>
            <pc:docMk/>
            <pc:sldMk cId="114451985" sldId="267"/>
            <ac:spMk id="31" creationId="{DC71F2D1-272E-441E-B81F-66D2E3D0D2CA}"/>
          </ac:spMkLst>
        </pc:spChg>
        <pc:spChg chg="add mod">
          <ac:chgData name="Anamthathmakula, Prashanth" userId="acd106aa-3bb0-4d16-b474-a7fd34266ac2" providerId="ADAL" clId="{24AA5EA0-019C-4F21-85E1-DABB8C92714C}" dt="2022-01-30T23:08:05.730" v="1631" actId="1076"/>
          <ac:spMkLst>
            <pc:docMk/>
            <pc:sldMk cId="114451985" sldId="267"/>
            <ac:spMk id="32" creationId="{AE89A4DF-BFDC-4E4F-B693-95CF1708C81B}"/>
          </ac:spMkLst>
        </pc:spChg>
        <pc:spChg chg="add mod">
          <ac:chgData name="Anamthathmakula, Prashanth" userId="acd106aa-3bb0-4d16-b474-a7fd34266ac2" providerId="ADAL" clId="{24AA5EA0-019C-4F21-85E1-DABB8C92714C}" dt="2022-01-30T23:08:25.866" v="1633" actId="1076"/>
          <ac:spMkLst>
            <pc:docMk/>
            <pc:sldMk cId="114451985" sldId="267"/>
            <ac:spMk id="33" creationId="{9B9BCDF8-B233-42F1-B046-ED3767AE9B5A}"/>
          </ac:spMkLst>
        </pc:spChg>
        <pc:spChg chg="add mod">
          <ac:chgData name="Anamthathmakula, Prashanth" userId="acd106aa-3bb0-4d16-b474-a7fd34266ac2" providerId="ADAL" clId="{24AA5EA0-019C-4F21-85E1-DABB8C92714C}" dt="2022-01-30T23:08:25.866" v="1633" actId="1076"/>
          <ac:spMkLst>
            <pc:docMk/>
            <pc:sldMk cId="114451985" sldId="267"/>
            <ac:spMk id="34" creationId="{C34AC070-0793-438A-99B6-EE4A4018CD48}"/>
          </ac:spMkLst>
        </pc:spChg>
        <pc:spChg chg="add mod">
          <ac:chgData name="Anamthathmakula, Prashanth" userId="acd106aa-3bb0-4d16-b474-a7fd34266ac2" providerId="ADAL" clId="{24AA5EA0-019C-4F21-85E1-DABB8C92714C}" dt="2022-01-30T23:08:25.866" v="1633" actId="1076"/>
          <ac:spMkLst>
            <pc:docMk/>
            <pc:sldMk cId="114451985" sldId="267"/>
            <ac:spMk id="35" creationId="{88C3A7F2-3C06-4D17-8495-0F6EBD6B9358}"/>
          </ac:spMkLst>
        </pc:spChg>
        <pc:spChg chg="add mod">
          <ac:chgData name="Anamthathmakula, Prashanth" userId="acd106aa-3bb0-4d16-b474-a7fd34266ac2" providerId="ADAL" clId="{24AA5EA0-019C-4F21-85E1-DABB8C92714C}" dt="2022-01-30T23:08:25.866" v="1633" actId="1076"/>
          <ac:spMkLst>
            <pc:docMk/>
            <pc:sldMk cId="114451985" sldId="267"/>
            <ac:spMk id="36" creationId="{AB41577C-5DD1-4A5F-BFCE-65F560EA18E3}"/>
          </ac:spMkLst>
        </pc:spChg>
        <pc:spChg chg="add mod">
          <ac:chgData name="Anamthathmakula, Prashanth" userId="acd106aa-3bb0-4d16-b474-a7fd34266ac2" providerId="ADAL" clId="{24AA5EA0-019C-4F21-85E1-DABB8C92714C}" dt="2022-01-30T23:08:25.866" v="1633" actId="1076"/>
          <ac:spMkLst>
            <pc:docMk/>
            <pc:sldMk cId="114451985" sldId="267"/>
            <ac:spMk id="37" creationId="{CAE727A9-FB24-460A-89AF-80A18A316929}"/>
          </ac:spMkLst>
        </pc:sp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5" creationId="{12504EB8-B30F-4072-AB02-D83382942A47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7" creationId="{F4F5D47C-CBA4-4E24-B64A-521D2BADF60A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9" creationId="{BD5AB199-F211-43C4-9CB7-FA1EEE528328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11" creationId="{4E4F948B-8B4D-42BB-B916-8EB796FAEEC1}"/>
          </ac:picMkLst>
        </pc:picChg>
        <pc:picChg chg="add del mod">
          <ac:chgData name="Anamthathmakula, Prashanth" userId="acd106aa-3bb0-4d16-b474-a7fd34266ac2" providerId="ADAL" clId="{24AA5EA0-019C-4F21-85E1-DABB8C92714C}" dt="2022-01-30T22:55:24.736" v="1386" actId="478"/>
          <ac:picMkLst>
            <pc:docMk/>
            <pc:sldMk cId="114451985" sldId="267"/>
            <ac:picMk id="13" creationId="{8946B6E9-5C38-4433-8A5B-0F78053A5A01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15" creationId="{BB39A32A-EF60-4099-B1B5-8EE620FF027F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17" creationId="{05CB6F6F-FCAB-40D4-A84C-9D6BF4C5529B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19" creationId="{A884B323-B4E4-4C57-9C91-24A951469D4F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21" creationId="{036D0CB1-7636-4E6F-A17E-8ACCD892932C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23" creationId="{87FACA47-34CD-41F4-B3B4-6EA3B7CB424B}"/>
          </ac:picMkLst>
        </pc:picChg>
        <pc:picChg chg="add mod">
          <ac:chgData name="Anamthathmakula, Prashanth" userId="acd106aa-3bb0-4d16-b474-a7fd34266ac2" providerId="ADAL" clId="{24AA5EA0-019C-4F21-85E1-DABB8C92714C}" dt="2022-01-30T23:06:20.363" v="1617" actId="1036"/>
          <ac:picMkLst>
            <pc:docMk/>
            <pc:sldMk cId="114451985" sldId="267"/>
            <ac:picMk id="25" creationId="{CF6A04BD-9595-4FDE-8D0E-15CD5F67D4BD}"/>
          </ac:picMkLst>
        </pc:picChg>
      </pc:sldChg>
      <pc:sldChg chg="addSp modSp add mod modAnim">
        <pc:chgData name="Anamthathmakula, Prashanth" userId="acd106aa-3bb0-4d16-b474-a7fd34266ac2" providerId="ADAL" clId="{24AA5EA0-019C-4F21-85E1-DABB8C92714C}" dt="2022-02-01T18:16:04.738" v="4736" actId="14100"/>
        <pc:sldMkLst>
          <pc:docMk/>
          <pc:sldMk cId="1426629886" sldId="268"/>
        </pc:sldMkLst>
        <pc:spChg chg="add mod">
          <ac:chgData name="Anamthathmakula, Prashanth" userId="acd106aa-3bb0-4d16-b474-a7fd34266ac2" providerId="ADAL" clId="{24AA5EA0-019C-4F21-85E1-DABB8C92714C}" dt="2022-01-31T16:11:45.191" v="2465" actId="255"/>
          <ac:spMkLst>
            <pc:docMk/>
            <pc:sldMk cId="1426629886" sldId="268"/>
            <ac:spMk id="2" creationId="{5479E7DD-0E9D-4D20-8AEA-17734DF2FEB2}"/>
          </ac:spMkLst>
        </pc:spChg>
        <pc:spChg chg="add mod">
          <ac:chgData name="Anamthathmakula, Prashanth" userId="acd106aa-3bb0-4d16-b474-a7fd34266ac2" providerId="ADAL" clId="{24AA5EA0-019C-4F21-85E1-DABB8C92714C}" dt="2022-01-31T20:01:47.004" v="3814" actId="20577"/>
          <ac:spMkLst>
            <pc:docMk/>
            <pc:sldMk cId="1426629886" sldId="268"/>
            <ac:spMk id="4" creationId="{2F42A8B4-4C5B-4220-A9BB-12F31D965ED7}"/>
          </ac:spMkLst>
        </pc:spChg>
        <pc:spChg chg="add mod">
          <ac:chgData name="Anamthathmakula, Prashanth" userId="acd106aa-3bb0-4d16-b474-a7fd34266ac2" providerId="ADAL" clId="{24AA5EA0-019C-4F21-85E1-DABB8C92714C}" dt="2022-02-01T18:16:04.738" v="4736" actId="14100"/>
          <ac:spMkLst>
            <pc:docMk/>
            <pc:sldMk cId="1426629886" sldId="268"/>
            <ac:spMk id="5" creationId="{07324E6B-6032-4C22-9E25-EE8FFABE6E06}"/>
          </ac:spMkLst>
        </pc:spChg>
        <pc:spChg chg="add mod">
          <ac:chgData name="Anamthathmakula, Prashanth" userId="acd106aa-3bb0-4d16-b474-a7fd34266ac2" providerId="ADAL" clId="{24AA5EA0-019C-4F21-85E1-DABB8C92714C}" dt="2022-01-31T20:05:24.041" v="3857" actId="1076"/>
          <ac:spMkLst>
            <pc:docMk/>
            <pc:sldMk cId="1426629886" sldId="268"/>
            <ac:spMk id="9" creationId="{D6B15013-1F66-448D-8079-F3395D1F118A}"/>
          </ac:spMkLst>
        </pc:spChg>
        <pc:picChg chg="add mod">
          <ac:chgData name="Anamthathmakula, Prashanth" userId="acd106aa-3bb0-4d16-b474-a7fd34266ac2" providerId="ADAL" clId="{24AA5EA0-019C-4F21-85E1-DABB8C92714C}" dt="2022-01-31T16:11:50.976" v="2466" actId="1076"/>
          <ac:picMkLst>
            <pc:docMk/>
            <pc:sldMk cId="1426629886" sldId="268"/>
            <ac:picMk id="3" creationId="{CA8ECEA1-0E2F-428F-A292-536D4F9E38D7}"/>
          </ac:picMkLst>
        </pc:picChg>
        <pc:picChg chg="add mod modCrop">
          <ac:chgData name="Anamthathmakula, Prashanth" userId="acd106aa-3bb0-4d16-b474-a7fd34266ac2" providerId="ADAL" clId="{24AA5EA0-019C-4F21-85E1-DABB8C92714C}" dt="2022-01-31T20:00:48.728" v="3810" actId="1036"/>
          <ac:picMkLst>
            <pc:docMk/>
            <pc:sldMk cId="1426629886" sldId="268"/>
            <ac:picMk id="7" creationId="{87D20D64-1FD1-4004-8497-53EE6F91A5D3}"/>
          </ac:picMkLst>
        </pc:picChg>
      </pc:sldChg>
      <pc:sldChg chg="addSp delSp modSp new del mod">
        <pc:chgData name="Anamthathmakula, Prashanth" userId="acd106aa-3bb0-4d16-b474-a7fd34266ac2" providerId="ADAL" clId="{24AA5EA0-019C-4F21-85E1-DABB8C92714C}" dt="2022-01-31T18:08:46.106" v="3094" actId="47"/>
        <pc:sldMkLst>
          <pc:docMk/>
          <pc:sldMk cId="343662210" sldId="269"/>
        </pc:sldMkLst>
        <pc:spChg chg="del">
          <ac:chgData name="Anamthathmakula, Prashanth" userId="acd106aa-3bb0-4d16-b474-a7fd34266ac2" providerId="ADAL" clId="{24AA5EA0-019C-4F21-85E1-DABB8C92714C}" dt="2022-01-30T21:46:54.392" v="1343" actId="478"/>
          <ac:spMkLst>
            <pc:docMk/>
            <pc:sldMk cId="343662210" sldId="269"/>
            <ac:spMk id="2" creationId="{AFC64785-D20B-4171-94CF-5C415ECAE727}"/>
          </ac:spMkLst>
        </pc:spChg>
        <pc:spChg chg="del">
          <ac:chgData name="Anamthathmakula, Prashanth" userId="acd106aa-3bb0-4d16-b474-a7fd34266ac2" providerId="ADAL" clId="{24AA5EA0-019C-4F21-85E1-DABB8C92714C}" dt="2022-01-30T21:46:54.392" v="1343" actId="478"/>
          <ac:spMkLst>
            <pc:docMk/>
            <pc:sldMk cId="343662210" sldId="269"/>
            <ac:spMk id="3" creationId="{D69F943F-127E-49FD-8737-6596330A73E9}"/>
          </ac:spMkLst>
        </pc:spChg>
        <pc:picChg chg="add mod modCrop">
          <ac:chgData name="Anamthathmakula, Prashanth" userId="acd106aa-3bb0-4d16-b474-a7fd34266ac2" providerId="ADAL" clId="{24AA5EA0-019C-4F21-85E1-DABB8C92714C}" dt="2022-01-31T17:35:10.157" v="2863" actId="14100"/>
          <ac:picMkLst>
            <pc:docMk/>
            <pc:sldMk cId="343662210" sldId="269"/>
            <ac:picMk id="5" creationId="{8BD4B396-A6F3-4429-97CA-79071DCFC54C}"/>
          </ac:picMkLst>
        </pc:picChg>
      </pc:sldChg>
      <pc:sldChg chg="addSp delSp modSp new del mod">
        <pc:chgData name="Anamthathmakula, Prashanth" userId="acd106aa-3bb0-4d16-b474-a7fd34266ac2" providerId="ADAL" clId="{24AA5EA0-019C-4F21-85E1-DABB8C92714C}" dt="2022-01-31T19:07:44.983" v="3580" actId="47"/>
        <pc:sldMkLst>
          <pc:docMk/>
          <pc:sldMk cId="1330887460" sldId="270"/>
        </pc:sldMkLst>
        <pc:spChg chg="del">
          <ac:chgData name="Anamthathmakula, Prashanth" userId="acd106aa-3bb0-4d16-b474-a7fd34266ac2" providerId="ADAL" clId="{24AA5EA0-019C-4F21-85E1-DABB8C92714C}" dt="2022-01-31T15:07:48.190" v="2279" actId="478"/>
          <ac:spMkLst>
            <pc:docMk/>
            <pc:sldMk cId="1330887460" sldId="270"/>
            <ac:spMk id="2" creationId="{C96170F8-2EB8-4686-B8A8-0BE8B8FC36FD}"/>
          </ac:spMkLst>
        </pc:spChg>
        <pc:spChg chg="del">
          <ac:chgData name="Anamthathmakula, Prashanth" userId="acd106aa-3bb0-4d16-b474-a7fd34266ac2" providerId="ADAL" clId="{24AA5EA0-019C-4F21-85E1-DABB8C92714C}" dt="2022-01-31T15:07:48.190" v="2279" actId="478"/>
          <ac:spMkLst>
            <pc:docMk/>
            <pc:sldMk cId="1330887460" sldId="270"/>
            <ac:spMk id="3" creationId="{0E8236D3-3CF3-48DE-B81A-2D3DC1A7FD64}"/>
          </ac:spMkLst>
        </pc:spChg>
        <pc:spChg chg="add mod">
          <ac:chgData name="Anamthathmakula, Prashanth" userId="acd106aa-3bb0-4d16-b474-a7fd34266ac2" providerId="ADAL" clId="{24AA5EA0-019C-4F21-85E1-DABB8C92714C}" dt="2022-01-31T15:08:26.049" v="2290" actId="20577"/>
          <ac:spMkLst>
            <pc:docMk/>
            <pc:sldMk cId="1330887460" sldId="270"/>
            <ac:spMk id="4" creationId="{575673F1-2525-458C-9AE8-42C1A09DC529}"/>
          </ac:spMkLst>
        </pc:spChg>
        <pc:spChg chg="add mod">
          <ac:chgData name="Anamthathmakula, Prashanth" userId="acd106aa-3bb0-4d16-b474-a7fd34266ac2" providerId="ADAL" clId="{24AA5EA0-019C-4F21-85E1-DABB8C92714C}" dt="2022-01-31T18:47:07.525" v="3289"/>
          <ac:spMkLst>
            <pc:docMk/>
            <pc:sldMk cId="1330887460" sldId="270"/>
            <ac:spMk id="5" creationId="{304250A3-D897-4185-ACF5-7DF680928813}"/>
          </ac:spMkLst>
        </pc:spChg>
        <pc:spChg chg="add mod">
          <ac:chgData name="Anamthathmakula, Prashanth" userId="acd106aa-3bb0-4d16-b474-a7fd34266ac2" providerId="ADAL" clId="{24AA5EA0-019C-4F21-85E1-DABB8C92714C}" dt="2022-01-31T18:47:14.517" v="3291" actId="1076"/>
          <ac:spMkLst>
            <pc:docMk/>
            <pc:sldMk cId="1330887460" sldId="270"/>
            <ac:spMk id="6" creationId="{7ED855BF-53DB-4CF0-AAAA-2FC4B04AA7AD}"/>
          </ac:spMkLst>
        </pc:spChg>
      </pc:sldChg>
      <pc:sldChg chg="addSp delSp modSp new mod">
        <pc:chgData name="Anamthathmakula, Prashanth" userId="acd106aa-3bb0-4d16-b474-a7fd34266ac2" providerId="ADAL" clId="{24AA5EA0-019C-4F21-85E1-DABB8C92714C}" dt="2022-01-31T18:16:04.630" v="3177" actId="2710"/>
        <pc:sldMkLst>
          <pc:docMk/>
          <pc:sldMk cId="3577520813" sldId="271"/>
        </pc:sldMkLst>
        <pc:spChg chg="del">
          <ac:chgData name="Anamthathmakula, Prashanth" userId="acd106aa-3bb0-4d16-b474-a7fd34266ac2" providerId="ADAL" clId="{24AA5EA0-019C-4F21-85E1-DABB8C92714C}" dt="2022-01-31T18:12:34.638" v="3097" actId="478"/>
          <ac:spMkLst>
            <pc:docMk/>
            <pc:sldMk cId="3577520813" sldId="271"/>
            <ac:spMk id="2" creationId="{17E0FC19-6602-43BC-8A53-E83F772131B1}"/>
          </ac:spMkLst>
        </pc:spChg>
        <pc:spChg chg="del">
          <ac:chgData name="Anamthathmakula, Prashanth" userId="acd106aa-3bb0-4d16-b474-a7fd34266ac2" providerId="ADAL" clId="{24AA5EA0-019C-4F21-85E1-DABB8C92714C}" dt="2022-01-31T18:12:36.233" v="3098" actId="478"/>
          <ac:spMkLst>
            <pc:docMk/>
            <pc:sldMk cId="3577520813" sldId="271"/>
            <ac:spMk id="3" creationId="{8468B9BC-7699-4554-B799-61F4489F759C}"/>
          </ac:spMkLst>
        </pc:spChg>
        <pc:spChg chg="add mod">
          <ac:chgData name="Anamthathmakula, Prashanth" userId="acd106aa-3bb0-4d16-b474-a7fd34266ac2" providerId="ADAL" clId="{24AA5EA0-019C-4F21-85E1-DABB8C92714C}" dt="2022-01-31T18:13:38.936" v="3121" actId="1076"/>
          <ac:spMkLst>
            <pc:docMk/>
            <pc:sldMk cId="3577520813" sldId="271"/>
            <ac:spMk id="4" creationId="{AD866396-20DB-44FD-BA9F-CCB3B9685C37}"/>
          </ac:spMkLst>
        </pc:spChg>
        <pc:spChg chg="add mod">
          <ac:chgData name="Anamthathmakula, Prashanth" userId="acd106aa-3bb0-4d16-b474-a7fd34266ac2" providerId="ADAL" clId="{24AA5EA0-019C-4F21-85E1-DABB8C92714C}" dt="2022-01-31T18:16:04.630" v="3177" actId="2710"/>
          <ac:spMkLst>
            <pc:docMk/>
            <pc:sldMk cId="3577520813" sldId="271"/>
            <ac:spMk id="5" creationId="{1F700A86-D5CF-436D-91CC-CA8CC2478A25}"/>
          </ac:spMkLst>
        </pc:spChg>
      </pc:sldChg>
      <pc:sldChg chg="add del">
        <pc:chgData name="Anamthathmakula, Prashanth" userId="acd106aa-3bb0-4d16-b474-a7fd34266ac2" providerId="ADAL" clId="{24AA5EA0-019C-4F21-85E1-DABB8C92714C}" dt="2022-01-31T19:19:20.263" v="3658" actId="47"/>
        <pc:sldMkLst>
          <pc:docMk/>
          <pc:sldMk cId="242206119" sldId="272"/>
        </pc:sldMkLst>
      </pc:sldChg>
      <pc:sldChg chg="delSp modSp add mod modAnim">
        <pc:chgData name="Anamthathmakula, Prashanth" userId="acd106aa-3bb0-4d16-b474-a7fd34266ac2" providerId="ADAL" clId="{24AA5EA0-019C-4F21-85E1-DABB8C92714C}" dt="2022-01-31T19:39:35.038" v="3684"/>
        <pc:sldMkLst>
          <pc:docMk/>
          <pc:sldMk cId="2128048327" sldId="272"/>
        </pc:sldMkLst>
        <pc:spChg chg="mod">
          <ac:chgData name="Anamthathmakula, Prashanth" userId="acd106aa-3bb0-4d16-b474-a7fd34266ac2" providerId="ADAL" clId="{24AA5EA0-019C-4F21-85E1-DABB8C92714C}" dt="2022-01-31T19:37:12.904" v="3676" actId="20577"/>
          <ac:spMkLst>
            <pc:docMk/>
            <pc:sldMk cId="2128048327" sldId="272"/>
            <ac:spMk id="3" creationId="{9D4B022A-486F-42AE-99FC-4D33EF04DF6A}"/>
          </ac:spMkLst>
        </pc:spChg>
        <pc:spChg chg="del">
          <ac:chgData name="Anamthathmakula, Prashanth" userId="acd106aa-3bb0-4d16-b474-a7fd34266ac2" providerId="ADAL" clId="{24AA5EA0-019C-4F21-85E1-DABB8C92714C}" dt="2022-01-31T19:36:58.467" v="3672" actId="478"/>
          <ac:spMkLst>
            <pc:docMk/>
            <pc:sldMk cId="2128048327" sldId="272"/>
            <ac:spMk id="4" creationId="{03D2601F-D199-42E8-92CF-537F09F6DDF2}"/>
          </ac:spMkLst>
        </pc:spChg>
        <pc:picChg chg="del">
          <ac:chgData name="Anamthathmakula, Prashanth" userId="acd106aa-3bb0-4d16-b474-a7fd34266ac2" providerId="ADAL" clId="{24AA5EA0-019C-4F21-85E1-DABB8C92714C}" dt="2022-01-31T19:36:55.093" v="3671" actId="478"/>
          <ac:picMkLst>
            <pc:docMk/>
            <pc:sldMk cId="2128048327" sldId="272"/>
            <ac:picMk id="2" creationId="{9842D826-EDDA-4F91-9AF0-F35066D13617}"/>
          </ac:picMkLst>
        </pc:picChg>
      </pc:sldChg>
      <pc:sldChg chg="add del">
        <pc:chgData name="Anamthathmakula, Prashanth" userId="acd106aa-3bb0-4d16-b474-a7fd34266ac2" providerId="ADAL" clId="{24AA5EA0-019C-4F21-85E1-DABB8C92714C}" dt="2022-01-31T18:46:59.293" v="3288" actId="47"/>
        <pc:sldMkLst>
          <pc:docMk/>
          <pc:sldMk cId="3699166756" sldId="272"/>
        </pc:sldMkLst>
      </pc:sldChg>
      <pc:sldChg chg="addSp delSp modSp new mod">
        <pc:chgData name="Anamthathmakula, Prashanth" userId="acd106aa-3bb0-4d16-b474-a7fd34266ac2" providerId="ADAL" clId="{24AA5EA0-019C-4F21-85E1-DABB8C92714C}" dt="2022-02-01T00:41:53.869" v="4609" actId="1076"/>
        <pc:sldMkLst>
          <pc:docMk/>
          <pc:sldMk cId="3868605658" sldId="273"/>
        </pc:sldMkLst>
        <pc:spChg chg="del">
          <ac:chgData name="Anamthathmakula, Prashanth" userId="acd106aa-3bb0-4d16-b474-a7fd34266ac2" providerId="ADAL" clId="{24AA5EA0-019C-4F21-85E1-DABB8C92714C}" dt="2022-01-31T23:40:38.263" v="4280" actId="478"/>
          <ac:spMkLst>
            <pc:docMk/>
            <pc:sldMk cId="3868605658" sldId="273"/>
            <ac:spMk id="2" creationId="{37D40EBB-3AF5-4911-A67F-99E7EA98747C}"/>
          </ac:spMkLst>
        </pc:spChg>
        <pc:spChg chg="del">
          <ac:chgData name="Anamthathmakula, Prashanth" userId="acd106aa-3bb0-4d16-b474-a7fd34266ac2" providerId="ADAL" clId="{24AA5EA0-019C-4F21-85E1-DABB8C92714C}" dt="2022-01-31T23:40:38.263" v="4280" actId="478"/>
          <ac:spMkLst>
            <pc:docMk/>
            <pc:sldMk cId="3868605658" sldId="273"/>
            <ac:spMk id="3" creationId="{CED67BBC-75EB-45EC-9585-A024FC96E842}"/>
          </ac:spMkLst>
        </pc:spChg>
        <pc:spChg chg="add mod">
          <ac:chgData name="Anamthathmakula, Prashanth" userId="acd106aa-3bb0-4d16-b474-a7fd34266ac2" providerId="ADAL" clId="{24AA5EA0-019C-4F21-85E1-DABB8C92714C}" dt="2022-01-31T23:56:07.540" v="4391" actId="1036"/>
          <ac:spMkLst>
            <pc:docMk/>
            <pc:sldMk cId="3868605658" sldId="273"/>
            <ac:spMk id="7" creationId="{0CBAA372-82DD-4031-9959-0F093E2945F5}"/>
          </ac:spMkLst>
        </pc:spChg>
        <pc:spChg chg="add mod">
          <ac:chgData name="Anamthathmakula, Prashanth" userId="acd106aa-3bb0-4d16-b474-a7fd34266ac2" providerId="ADAL" clId="{24AA5EA0-019C-4F21-85E1-DABB8C92714C}" dt="2022-01-31T23:56:12.758" v="4397" actId="1035"/>
          <ac:spMkLst>
            <pc:docMk/>
            <pc:sldMk cId="3868605658" sldId="273"/>
            <ac:spMk id="13" creationId="{57E35768-BA57-4424-A5B7-868680D99F91}"/>
          </ac:spMkLst>
        </pc:spChg>
        <pc:spChg chg="add mod">
          <ac:chgData name="Anamthathmakula, Prashanth" userId="acd106aa-3bb0-4d16-b474-a7fd34266ac2" providerId="ADAL" clId="{24AA5EA0-019C-4F21-85E1-DABB8C92714C}" dt="2022-01-31T23:56:40.157" v="4421" actId="1076"/>
          <ac:spMkLst>
            <pc:docMk/>
            <pc:sldMk cId="3868605658" sldId="273"/>
            <ac:spMk id="19" creationId="{304776F1-6873-46C3-BC75-5F6CA36113D9}"/>
          </ac:spMkLst>
        </pc:spChg>
        <pc:spChg chg="add mod">
          <ac:chgData name="Anamthathmakula, Prashanth" userId="acd106aa-3bb0-4d16-b474-a7fd34266ac2" providerId="ADAL" clId="{24AA5EA0-019C-4F21-85E1-DABB8C92714C}" dt="2022-02-01T00:41:53.869" v="4609" actId="1076"/>
          <ac:spMkLst>
            <pc:docMk/>
            <pc:sldMk cId="3868605658" sldId="273"/>
            <ac:spMk id="27" creationId="{BACB0878-F5FF-4FF9-8ECF-3390402B65C4}"/>
          </ac:spMkLst>
        </pc:spChg>
        <pc:picChg chg="add mod">
          <ac:chgData name="Anamthathmakula, Prashanth" userId="acd106aa-3bb0-4d16-b474-a7fd34266ac2" providerId="ADAL" clId="{24AA5EA0-019C-4F21-85E1-DABB8C92714C}" dt="2022-01-31T23:49:06.078" v="4316" actId="1037"/>
          <ac:picMkLst>
            <pc:docMk/>
            <pc:sldMk cId="3868605658" sldId="273"/>
            <ac:picMk id="5" creationId="{5550ACBC-4565-4BE0-A08F-BD5FB17B8A74}"/>
          </ac:picMkLst>
        </pc:picChg>
        <pc:picChg chg="add mod">
          <ac:chgData name="Anamthathmakula, Prashanth" userId="acd106aa-3bb0-4d16-b474-a7fd34266ac2" providerId="ADAL" clId="{24AA5EA0-019C-4F21-85E1-DABB8C92714C}" dt="2022-01-31T23:49:29.527" v="4327" actId="1038"/>
          <ac:picMkLst>
            <pc:docMk/>
            <pc:sldMk cId="3868605658" sldId="273"/>
            <ac:picMk id="9" creationId="{CA34B927-AF88-4684-B1C1-0B327B632D7E}"/>
          </ac:picMkLst>
        </pc:picChg>
        <pc:picChg chg="add mod">
          <ac:chgData name="Anamthathmakula, Prashanth" userId="acd106aa-3bb0-4d16-b474-a7fd34266ac2" providerId="ADAL" clId="{24AA5EA0-019C-4F21-85E1-DABB8C92714C}" dt="2022-01-31T23:51:44.922" v="4351" actId="1035"/>
          <ac:picMkLst>
            <pc:docMk/>
            <pc:sldMk cId="3868605658" sldId="273"/>
            <ac:picMk id="11" creationId="{67CD484F-8392-4385-8224-B977BF1A848F}"/>
          </ac:picMkLst>
        </pc:picChg>
        <pc:picChg chg="add mod">
          <ac:chgData name="Anamthathmakula, Prashanth" userId="acd106aa-3bb0-4d16-b474-a7fd34266ac2" providerId="ADAL" clId="{24AA5EA0-019C-4F21-85E1-DABB8C92714C}" dt="2022-01-31T23:55:17.842" v="4382" actId="1076"/>
          <ac:picMkLst>
            <pc:docMk/>
            <pc:sldMk cId="3868605658" sldId="273"/>
            <ac:picMk id="15" creationId="{17EF96AF-B629-4424-A3BE-4F8EF8C57B7D}"/>
          </ac:picMkLst>
        </pc:picChg>
        <pc:picChg chg="add mod">
          <ac:chgData name="Anamthathmakula, Prashanth" userId="acd106aa-3bb0-4d16-b474-a7fd34266ac2" providerId="ADAL" clId="{24AA5EA0-019C-4F21-85E1-DABB8C92714C}" dt="2022-01-31T23:56:44.223" v="4424" actId="1038"/>
          <ac:picMkLst>
            <pc:docMk/>
            <pc:sldMk cId="3868605658" sldId="273"/>
            <ac:picMk id="17" creationId="{868076C2-BF05-4A56-B31E-8C6474CEDBAE}"/>
          </ac:picMkLst>
        </pc:picChg>
        <pc:picChg chg="add mod">
          <ac:chgData name="Anamthathmakula, Prashanth" userId="acd106aa-3bb0-4d16-b474-a7fd34266ac2" providerId="ADAL" clId="{24AA5EA0-019C-4F21-85E1-DABB8C92714C}" dt="2022-02-01T00:40:47.716" v="4603" actId="1036"/>
          <ac:picMkLst>
            <pc:docMk/>
            <pc:sldMk cId="3868605658" sldId="273"/>
            <ac:picMk id="21" creationId="{2C6DC40D-7502-4F5F-886F-1591A3A41873}"/>
          </ac:picMkLst>
        </pc:picChg>
        <pc:picChg chg="add mod">
          <ac:chgData name="Anamthathmakula, Prashanth" userId="acd106aa-3bb0-4d16-b474-a7fd34266ac2" providerId="ADAL" clId="{24AA5EA0-019C-4F21-85E1-DABB8C92714C}" dt="2022-02-01T00:40:47.716" v="4603" actId="1036"/>
          <ac:picMkLst>
            <pc:docMk/>
            <pc:sldMk cId="3868605658" sldId="273"/>
            <ac:picMk id="23" creationId="{027944A8-64DE-41C0-A94C-DAB6F718654E}"/>
          </ac:picMkLst>
        </pc:picChg>
        <pc:picChg chg="add mod">
          <ac:chgData name="Anamthathmakula, Prashanth" userId="acd106aa-3bb0-4d16-b474-a7fd34266ac2" providerId="ADAL" clId="{24AA5EA0-019C-4F21-85E1-DABB8C92714C}" dt="2022-02-01T00:40:47.716" v="4603" actId="1036"/>
          <ac:picMkLst>
            <pc:docMk/>
            <pc:sldMk cId="3868605658" sldId="273"/>
            <ac:picMk id="25" creationId="{2C60253D-0BE5-499B-8CDD-40BF930A4FA8}"/>
          </ac:picMkLst>
        </pc:picChg>
      </pc:sldChg>
      <pc:sldChg chg="addSp delSp modSp new mod ord">
        <pc:chgData name="Anamthathmakula, Prashanth" userId="acd106aa-3bb0-4d16-b474-a7fd34266ac2" providerId="ADAL" clId="{24AA5EA0-019C-4F21-85E1-DABB8C92714C}" dt="2022-02-01T00:47:42.715" v="4674" actId="1038"/>
        <pc:sldMkLst>
          <pc:docMk/>
          <pc:sldMk cId="3514584103" sldId="274"/>
        </pc:sldMkLst>
        <pc:spChg chg="del">
          <ac:chgData name="Anamthathmakula, Prashanth" userId="acd106aa-3bb0-4d16-b474-a7fd34266ac2" providerId="ADAL" clId="{24AA5EA0-019C-4F21-85E1-DABB8C92714C}" dt="2022-02-01T00:42:25.144" v="4611" actId="478"/>
          <ac:spMkLst>
            <pc:docMk/>
            <pc:sldMk cId="3514584103" sldId="274"/>
            <ac:spMk id="2" creationId="{A8A34FDB-78BE-4162-A56A-A36A8EC657B0}"/>
          </ac:spMkLst>
        </pc:spChg>
        <pc:spChg chg="del">
          <ac:chgData name="Anamthathmakula, Prashanth" userId="acd106aa-3bb0-4d16-b474-a7fd34266ac2" providerId="ADAL" clId="{24AA5EA0-019C-4F21-85E1-DABB8C92714C}" dt="2022-02-01T00:42:25.144" v="4611" actId="478"/>
          <ac:spMkLst>
            <pc:docMk/>
            <pc:sldMk cId="3514584103" sldId="274"/>
            <ac:spMk id="3" creationId="{414B002E-8AD4-4C94-A8C3-A93DA4C048D9}"/>
          </ac:spMkLst>
        </pc:spChg>
        <pc:spChg chg="add mod">
          <ac:chgData name="Anamthathmakula, Prashanth" userId="acd106aa-3bb0-4d16-b474-a7fd34266ac2" providerId="ADAL" clId="{24AA5EA0-019C-4F21-85E1-DABB8C92714C}" dt="2022-02-01T00:47:42.715" v="4674" actId="1038"/>
          <ac:spMkLst>
            <pc:docMk/>
            <pc:sldMk cId="3514584103" sldId="274"/>
            <ac:spMk id="4" creationId="{0C2487AC-9353-48E2-B13B-C8691606BA03}"/>
          </ac:spMkLst>
        </pc:spChg>
        <pc:picChg chg="add mod">
          <ac:chgData name="Anamthathmakula, Prashanth" userId="acd106aa-3bb0-4d16-b474-a7fd34266ac2" providerId="ADAL" clId="{24AA5EA0-019C-4F21-85E1-DABB8C92714C}" dt="2022-02-01T00:47:42.715" v="4674" actId="1038"/>
          <ac:picMkLst>
            <pc:docMk/>
            <pc:sldMk cId="3514584103" sldId="274"/>
            <ac:picMk id="1026" creationId="{F9C01AF5-8DB4-4BAE-8E88-A4F2E7DF80C7}"/>
          </ac:picMkLst>
        </pc:picChg>
      </pc:sldChg>
      <pc:sldChg chg="addSp delSp modSp new mod modAnim">
        <pc:chgData name="Anamthathmakula, Prashanth" userId="acd106aa-3bb0-4d16-b474-a7fd34266ac2" providerId="ADAL" clId="{24AA5EA0-019C-4F21-85E1-DABB8C92714C}" dt="2022-02-01T18:10:13.556" v="4691"/>
        <pc:sldMkLst>
          <pc:docMk/>
          <pc:sldMk cId="3822711728" sldId="275"/>
        </pc:sldMkLst>
        <pc:spChg chg="del">
          <ac:chgData name="Anamthathmakula, Prashanth" userId="acd106aa-3bb0-4d16-b474-a7fd34266ac2" providerId="ADAL" clId="{24AA5EA0-019C-4F21-85E1-DABB8C92714C}" dt="2022-02-01T18:07:58.477" v="4678" actId="478"/>
          <ac:spMkLst>
            <pc:docMk/>
            <pc:sldMk cId="3822711728" sldId="275"/>
            <ac:spMk id="2" creationId="{0F758159-C5F1-43CF-A076-EB99D4AB0FDA}"/>
          </ac:spMkLst>
        </pc:spChg>
        <pc:spChg chg="del">
          <ac:chgData name="Anamthathmakula, Prashanth" userId="acd106aa-3bb0-4d16-b474-a7fd34266ac2" providerId="ADAL" clId="{24AA5EA0-019C-4F21-85E1-DABB8C92714C}" dt="2022-02-01T18:07:58.477" v="4678" actId="478"/>
          <ac:spMkLst>
            <pc:docMk/>
            <pc:sldMk cId="3822711728" sldId="275"/>
            <ac:spMk id="3" creationId="{8B3AADEE-6A31-4081-9A13-E761B486E67D}"/>
          </ac:spMkLst>
        </pc:spChg>
        <pc:spChg chg="add mod">
          <ac:chgData name="Anamthathmakula, Prashanth" userId="acd106aa-3bb0-4d16-b474-a7fd34266ac2" providerId="ADAL" clId="{24AA5EA0-019C-4F21-85E1-DABB8C92714C}" dt="2022-02-01T18:09:58.389" v="4690" actId="1076"/>
          <ac:spMkLst>
            <pc:docMk/>
            <pc:sldMk cId="3822711728" sldId="275"/>
            <ac:spMk id="7" creationId="{8DFE8D4C-83B2-42BF-98BA-5C7F07093938}"/>
          </ac:spMkLst>
        </pc:spChg>
        <pc:spChg chg="add mod">
          <ac:chgData name="Anamthathmakula, Prashanth" userId="acd106aa-3bb0-4d16-b474-a7fd34266ac2" providerId="ADAL" clId="{24AA5EA0-019C-4F21-85E1-DABB8C92714C}" dt="2022-02-01T18:10:13.556" v="4691"/>
          <ac:spMkLst>
            <pc:docMk/>
            <pc:sldMk cId="3822711728" sldId="275"/>
            <ac:spMk id="8" creationId="{BB51ED29-8C20-4D4C-9FA8-FF01780EB06F}"/>
          </ac:spMkLst>
        </pc:spChg>
        <pc:picChg chg="add mod">
          <ac:chgData name="Anamthathmakula, Prashanth" userId="acd106aa-3bb0-4d16-b474-a7fd34266ac2" providerId="ADAL" clId="{24AA5EA0-019C-4F21-85E1-DABB8C92714C}" dt="2022-02-01T18:09:05.981" v="4683" actId="1076"/>
          <ac:picMkLst>
            <pc:docMk/>
            <pc:sldMk cId="3822711728" sldId="275"/>
            <ac:picMk id="5" creationId="{895E79C4-3933-40DF-A88B-FCAD267231E6}"/>
          </ac:picMkLst>
        </pc:picChg>
      </pc:sldChg>
      <pc:sldChg chg="addSp delSp modSp new mod delAnim modAnim">
        <pc:chgData name="Anamthathmakula, Prashanth" userId="acd106aa-3bb0-4d16-b474-a7fd34266ac2" providerId="ADAL" clId="{24AA5EA0-019C-4F21-85E1-DABB8C92714C}" dt="2022-02-01T18:15:41.365" v="4730" actId="478"/>
        <pc:sldMkLst>
          <pc:docMk/>
          <pc:sldMk cId="1877281509" sldId="276"/>
        </pc:sldMkLst>
        <pc:spChg chg="del">
          <ac:chgData name="Anamthathmakula, Prashanth" userId="acd106aa-3bb0-4d16-b474-a7fd34266ac2" providerId="ADAL" clId="{24AA5EA0-019C-4F21-85E1-DABB8C92714C}" dt="2022-02-01T18:08:24.652" v="4681" actId="478"/>
          <ac:spMkLst>
            <pc:docMk/>
            <pc:sldMk cId="1877281509" sldId="276"/>
            <ac:spMk id="2" creationId="{285B29D5-DEB4-454B-BA02-CE2FF30E588E}"/>
          </ac:spMkLst>
        </pc:spChg>
        <pc:spChg chg="del">
          <ac:chgData name="Anamthathmakula, Prashanth" userId="acd106aa-3bb0-4d16-b474-a7fd34266ac2" providerId="ADAL" clId="{24AA5EA0-019C-4F21-85E1-DABB8C92714C}" dt="2022-02-01T18:08:24.652" v="4681" actId="478"/>
          <ac:spMkLst>
            <pc:docMk/>
            <pc:sldMk cId="1877281509" sldId="276"/>
            <ac:spMk id="3" creationId="{B6F023B2-F0D4-4B51-BC9D-3887824A2CCD}"/>
          </ac:spMkLst>
        </pc:spChg>
        <pc:spChg chg="add mod">
          <ac:chgData name="Anamthathmakula, Prashanth" userId="acd106aa-3bb0-4d16-b474-a7fd34266ac2" providerId="ADAL" clId="{24AA5EA0-019C-4F21-85E1-DABB8C92714C}" dt="2022-02-01T18:12:17.944" v="4698" actId="123"/>
          <ac:spMkLst>
            <pc:docMk/>
            <pc:sldMk cId="1877281509" sldId="276"/>
            <ac:spMk id="7" creationId="{E7F2E73D-7DAA-4A12-9F07-C73CEB86921F}"/>
          </ac:spMkLst>
        </pc:spChg>
        <pc:spChg chg="add mod">
          <ac:chgData name="Anamthathmakula, Prashanth" userId="acd106aa-3bb0-4d16-b474-a7fd34266ac2" providerId="ADAL" clId="{24AA5EA0-019C-4F21-85E1-DABB8C92714C}" dt="2022-02-01T18:15:37.544" v="4729" actId="255"/>
          <ac:spMkLst>
            <pc:docMk/>
            <pc:sldMk cId="1877281509" sldId="276"/>
            <ac:spMk id="9" creationId="{62D0DB88-C02F-4176-AC4F-F3AA64CFFFC9}"/>
          </ac:spMkLst>
        </pc:spChg>
        <pc:spChg chg="add del mod">
          <ac:chgData name="Anamthathmakula, Prashanth" userId="acd106aa-3bb0-4d16-b474-a7fd34266ac2" providerId="ADAL" clId="{24AA5EA0-019C-4F21-85E1-DABB8C92714C}" dt="2022-02-01T18:15:41.365" v="4730" actId="478"/>
          <ac:spMkLst>
            <pc:docMk/>
            <pc:sldMk cId="1877281509" sldId="276"/>
            <ac:spMk id="10" creationId="{B32DB0ED-E458-4874-B680-3B322409A4EB}"/>
          </ac:spMkLst>
        </pc:spChg>
        <pc:picChg chg="add mod modCrop">
          <ac:chgData name="Anamthathmakula, Prashanth" userId="acd106aa-3bb0-4d16-b474-a7fd34266ac2" providerId="ADAL" clId="{24AA5EA0-019C-4F21-85E1-DABB8C92714C}" dt="2022-02-01T18:11:21.558" v="4694" actId="1076"/>
          <ac:picMkLst>
            <pc:docMk/>
            <pc:sldMk cId="1877281509" sldId="276"/>
            <ac:picMk id="5" creationId="{61846E92-EE80-43FC-82B2-2D2AA70932E2}"/>
          </ac:picMkLst>
        </pc:picChg>
      </pc:sldChg>
      <pc:sldChg chg="add">
        <pc:chgData name="Anamthathmakula, Prashanth" userId="acd106aa-3bb0-4d16-b474-a7fd34266ac2" providerId="ADAL" clId="{24AA5EA0-019C-4F21-85E1-DABB8C92714C}" dt="2022-02-01T18:09:01.285" v="4682"/>
        <pc:sldMkLst>
          <pc:docMk/>
          <pc:sldMk cId="1873993773" sldId="277"/>
        </pc:sldMkLst>
      </pc:sldChg>
    </pc:docChg>
  </pc:docChgLst>
  <pc:docChgLst>
    <pc:chgData name="Anamthathmakula, Prashanth" userId="acd106aa-3bb0-4d16-b474-a7fd34266ac2" providerId="ADAL" clId="{95C3F151-376E-440C-B40F-1797108992C7}"/>
    <pc:docChg chg="undo custSel addSld modSld">
      <pc:chgData name="Anamthathmakula, Prashanth" userId="acd106aa-3bb0-4d16-b474-a7fd34266ac2" providerId="ADAL" clId="{95C3F151-376E-440C-B40F-1797108992C7}" dt="2023-06-12T20:48:42.412" v="481" actId="1037"/>
      <pc:docMkLst>
        <pc:docMk/>
      </pc:docMkLst>
      <pc:sldChg chg="addSp delSp modSp new mod">
        <pc:chgData name="Anamthathmakula, Prashanth" userId="acd106aa-3bb0-4d16-b474-a7fd34266ac2" providerId="ADAL" clId="{95C3F151-376E-440C-B40F-1797108992C7}" dt="2023-06-12T20:48:42.412" v="481" actId="1037"/>
        <pc:sldMkLst>
          <pc:docMk/>
          <pc:sldMk cId="3468106434" sldId="269"/>
        </pc:sldMkLst>
        <pc:spChg chg="del">
          <ac:chgData name="Anamthathmakula, Prashanth" userId="acd106aa-3bb0-4d16-b474-a7fd34266ac2" providerId="ADAL" clId="{95C3F151-376E-440C-B40F-1797108992C7}" dt="2023-06-12T20:24:44.268" v="1" actId="478"/>
          <ac:spMkLst>
            <pc:docMk/>
            <pc:sldMk cId="3468106434" sldId="269"/>
            <ac:spMk id="2" creationId="{8CAB780B-9B28-E2F7-A044-BF4CB9458E95}"/>
          </ac:spMkLst>
        </pc:spChg>
        <pc:spChg chg="del">
          <ac:chgData name="Anamthathmakula, Prashanth" userId="acd106aa-3bb0-4d16-b474-a7fd34266ac2" providerId="ADAL" clId="{95C3F151-376E-440C-B40F-1797108992C7}" dt="2023-06-12T20:24:44.268" v="1" actId="478"/>
          <ac:spMkLst>
            <pc:docMk/>
            <pc:sldMk cId="3468106434" sldId="269"/>
            <ac:spMk id="3" creationId="{9A8C93E9-A41B-333F-E4B1-85192F25C336}"/>
          </ac:spMkLst>
        </pc:spChg>
        <pc:spChg chg="add mod">
          <ac:chgData name="Anamthathmakula, Prashanth" userId="acd106aa-3bb0-4d16-b474-a7fd34266ac2" providerId="ADAL" clId="{95C3F151-376E-440C-B40F-1797108992C7}" dt="2023-06-12T20:47:33.900" v="290" actId="1076"/>
          <ac:spMkLst>
            <pc:docMk/>
            <pc:sldMk cId="3468106434" sldId="269"/>
            <ac:spMk id="4" creationId="{4B7DC867-4AED-B961-D243-808571E3D0A2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9" creationId="{3F269B5F-C585-68F1-4DA7-9CD232788BE4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10" creationId="{A38DE466-03F6-C024-B063-17258D27A3F8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11" creationId="{D9C160CF-AB73-F964-9EA7-EF240EB8FA30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12" creationId="{915FAD08-B46E-0BFF-A10C-9BC065F5AB90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13" creationId="{4F3BC1EA-1035-6786-3AC6-830DF99FCF72}"/>
          </ac:spMkLst>
        </pc:spChg>
        <pc:spChg chg="add mod">
          <ac:chgData name="Anamthathmakula, Prashanth" userId="acd106aa-3bb0-4d16-b474-a7fd34266ac2" providerId="ADAL" clId="{95C3F151-376E-440C-B40F-1797108992C7}" dt="2023-06-12T20:47:52.384" v="329" actId="1036"/>
          <ac:spMkLst>
            <pc:docMk/>
            <pc:sldMk cId="3468106434" sldId="269"/>
            <ac:spMk id="14" creationId="{19B4A816-862B-262A-1E12-0D7BBF1158F9}"/>
          </ac:spMkLst>
        </pc:spChg>
        <pc:spChg chg="add del mod">
          <ac:chgData name="Anamthathmakula, Prashanth" userId="acd106aa-3bb0-4d16-b474-a7fd34266ac2" providerId="ADAL" clId="{95C3F151-376E-440C-B40F-1797108992C7}" dt="2023-06-12T20:47:09.676" v="234" actId="478"/>
          <ac:spMkLst>
            <pc:docMk/>
            <pc:sldMk cId="3468106434" sldId="269"/>
            <ac:spMk id="15" creationId="{062C5699-E8C3-D747-DD7A-22CFE6DD8541}"/>
          </ac:spMkLst>
        </pc:spChg>
        <pc:spChg chg="add del mod">
          <ac:chgData name="Anamthathmakula, Prashanth" userId="acd106aa-3bb0-4d16-b474-a7fd34266ac2" providerId="ADAL" clId="{95C3F151-376E-440C-B40F-1797108992C7}" dt="2023-06-12T20:47:11.034" v="235" actId="478"/>
          <ac:spMkLst>
            <pc:docMk/>
            <pc:sldMk cId="3468106434" sldId="269"/>
            <ac:spMk id="16" creationId="{5E23AA01-D9A0-96BC-19CC-BF7B256E5834}"/>
          </ac:spMkLst>
        </pc:spChg>
        <pc:spChg chg="add mod">
          <ac:chgData name="Anamthathmakula, Prashanth" userId="acd106aa-3bb0-4d16-b474-a7fd34266ac2" providerId="ADAL" clId="{95C3F151-376E-440C-B40F-1797108992C7}" dt="2023-06-12T20:48:25.403" v="435" actId="1038"/>
          <ac:spMkLst>
            <pc:docMk/>
            <pc:sldMk cId="3468106434" sldId="269"/>
            <ac:spMk id="17" creationId="{8726A9C5-3B60-E86F-D876-F36805179BA2}"/>
          </ac:spMkLst>
        </pc:spChg>
        <pc:spChg chg="add mod">
          <ac:chgData name="Anamthathmakula, Prashanth" userId="acd106aa-3bb0-4d16-b474-a7fd34266ac2" providerId="ADAL" clId="{95C3F151-376E-440C-B40F-1797108992C7}" dt="2023-06-12T20:48:35.124" v="459" actId="1037"/>
          <ac:spMkLst>
            <pc:docMk/>
            <pc:sldMk cId="3468106434" sldId="269"/>
            <ac:spMk id="18" creationId="{308EA9E2-544C-B5AA-8C0F-B87AD48B3204}"/>
          </ac:spMkLst>
        </pc:spChg>
        <pc:spChg chg="add mod">
          <ac:chgData name="Anamthathmakula, Prashanth" userId="acd106aa-3bb0-4d16-b474-a7fd34266ac2" providerId="ADAL" clId="{95C3F151-376E-440C-B40F-1797108992C7}" dt="2023-06-12T20:48:42.412" v="481" actId="1037"/>
          <ac:spMkLst>
            <pc:docMk/>
            <pc:sldMk cId="3468106434" sldId="269"/>
            <ac:spMk id="19" creationId="{89A1E381-E72D-DA1C-DB02-CC245893D8CB}"/>
          </ac:spMkLst>
        </pc:spChg>
        <pc:grpChg chg="add del mod">
          <ac:chgData name="Anamthathmakula, Prashanth" userId="acd106aa-3bb0-4d16-b474-a7fd34266ac2" providerId="ADAL" clId="{95C3F151-376E-440C-B40F-1797108992C7}" dt="2023-06-12T20:40:04.910" v="49" actId="165"/>
          <ac:grpSpMkLst>
            <pc:docMk/>
            <pc:sldMk cId="3468106434" sldId="269"/>
            <ac:grpSpMk id="5" creationId="{FC85F0D5-886B-464F-FDCF-68A2CC8DA05A}"/>
          </ac:grpSpMkLst>
        </pc:grpChg>
        <pc:picChg chg="mod topLvl">
          <ac:chgData name="Anamthathmakula, Prashanth" userId="acd106aa-3bb0-4d16-b474-a7fd34266ac2" providerId="ADAL" clId="{95C3F151-376E-440C-B40F-1797108992C7}" dt="2023-06-12T20:47:52.384" v="329" actId="1036"/>
          <ac:picMkLst>
            <pc:docMk/>
            <pc:sldMk cId="3468106434" sldId="269"/>
            <ac:picMk id="6" creationId="{669FEE05-68C1-A1B8-2FE1-134F09895C7F}"/>
          </ac:picMkLst>
        </pc:picChg>
        <pc:picChg chg="mod topLvl">
          <ac:chgData name="Anamthathmakula, Prashanth" userId="acd106aa-3bb0-4d16-b474-a7fd34266ac2" providerId="ADAL" clId="{95C3F151-376E-440C-B40F-1797108992C7}" dt="2023-06-12T20:47:52.384" v="329" actId="1036"/>
          <ac:picMkLst>
            <pc:docMk/>
            <pc:sldMk cId="3468106434" sldId="269"/>
            <ac:picMk id="7" creationId="{85879661-866B-6C5C-8233-60C61427F28F}"/>
          </ac:picMkLst>
        </pc:picChg>
        <pc:picChg chg="mod topLvl">
          <ac:chgData name="Anamthathmakula, Prashanth" userId="acd106aa-3bb0-4d16-b474-a7fd34266ac2" providerId="ADAL" clId="{95C3F151-376E-440C-B40F-1797108992C7}" dt="2023-06-12T20:47:52.384" v="329" actId="1036"/>
          <ac:picMkLst>
            <pc:docMk/>
            <pc:sldMk cId="3468106434" sldId="269"/>
            <ac:picMk id="8" creationId="{50A636FF-7D31-04E7-AC62-F3D74E395C88}"/>
          </ac:picMkLst>
        </pc:picChg>
      </pc:sldChg>
    </pc:docChg>
  </pc:docChgLst>
  <pc:docChgLst>
    <pc:chgData name="Anamthathmakula, Prashanth" userId="acd106aa-3bb0-4d16-b474-a7fd34266ac2" providerId="ADAL" clId="{12B80BBE-B90A-494C-B224-CDBD078AEA23}"/>
    <pc:docChg chg="addSld modSld">
      <pc:chgData name="Anamthathmakula, Prashanth" userId="acd106aa-3bb0-4d16-b474-a7fd34266ac2" providerId="ADAL" clId="{12B80BBE-B90A-494C-B224-CDBD078AEA23}" dt="2023-08-06T01:55:06.246" v="4"/>
      <pc:docMkLst>
        <pc:docMk/>
      </pc:docMkLst>
      <pc:sldChg chg="add">
        <pc:chgData name="Anamthathmakula, Prashanth" userId="acd106aa-3bb0-4d16-b474-a7fd34266ac2" providerId="ADAL" clId="{12B80BBE-B90A-494C-B224-CDBD078AEA23}" dt="2023-08-06T01:55:06.246" v="4"/>
        <pc:sldMkLst>
          <pc:docMk/>
          <pc:sldMk cId="3826982628" sldId="258"/>
        </pc:sldMkLst>
      </pc:sldChg>
      <pc:sldChg chg="modSp mod">
        <pc:chgData name="Anamthathmakula, Prashanth" userId="acd106aa-3bb0-4d16-b474-a7fd34266ac2" providerId="ADAL" clId="{12B80BBE-B90A-494C-B224-CDBD078AEA23}" dt="2023-08-06T01:36:00.749" v="3" actId="255"/>
        <pc:sldMkLst>
          <pc:docMk/>
          <pc:sldMk cId="3357358326" sldId="270"/>
        </pc:sldMkLst>
        <pc:spChg chg="mod">
          <ac:chgData name="Anamthathmakula, Prashanth" userId="acd106aa-3bb0-4d16-b474-a7fd34266ac2" providerId="ADAL" clId="{12B80BBE-B90A-494C-B224-CDBD078AEA23}" dt="2023-08-06T01:36:00.749" v="3" actId="255"/>
          <ac:spMkLst>
            <pc:docMk/>
            <pc:sldMk cId="3357358326" sldId="270"/>
            <ac:spMk id="3" creationId="{FF66B33E-FFD9-B10B-B198-E013648FAFE6}"/>
          </ac:spMkLst>
        </pc:spChg>
      </pc:sldChg>
    </pc:docChg>
  </pc:docChgLst>
  <pc:docChgLst>
    <pc:chgData name="Anamthathmakula, Prashanth" userId="acd106aa-3bb0-4d16-b474-a7fd34266ac2" providerId="ADAL" clId="{E6A4295F-501E-4DED-9082-44AB60C94851}"/>
    <pc:docChg chg="custSel modSld">
      <pc:chgData name="Anamthathmakula, Prashanth" userId="acd106aa-3bb0-4d16-b474-a7fd34266ac2" providerId="ADAL" clId="{E6A4295F-501E-4DED-9082-44AB60C94851}" dt="2023-06-27T21:55:21.576" v="0" actId="478"/>
      <pc:docMkLst>
        <pc:docMk/>
      </pc:docMkLst>
      <pc:sldChg chg="delSp mod">
        <pc:chgData name="Anamthathmakula, Prashanth" userId="acd106aa-3bb0-4d16-b474-a7fd34266ac2" providerId="ADAL" clId="{E6A4295F-501E-4DED-9082-44AB60C94851}" dt="2023-06-27T21:55:21.576" v="0" actId="478"/>
        <pc:sldMkLst>
          <pc:docMk/>
          <pc:sldMk cId="3468106434" sldId="269"/>
        </pc:sldMkLst>
        <pc:spChg chg="del">
          <ac:chgData name="Anamthathmakula, Prashanth" userId="acd106aa-3bb0-4d16-b474-a7fd34266ac2" providerId="ADAL" clId="{E6A4295F-501E-4DED-9082-44AB60C94851}" dt="2023-06-27T21:55:21.576" v="0" actId="478"/>
          <ac:spMkLst>
            <pc:docMk/>
            <pc:sldMk cId="3468106434" sldId="269"/>
            <ac:spMk id="4" creationId="{4B7DC867-4AED-B961-D243-808571E3D0A2}"/>
          </ac:spMkLst>
        </pc:spChg>
      </pc:sldChg>
    </pc:docChg>
  </pc:docChgLst>
  <pc:docChgLst>
    <pc:chgData name="Anamthathmakula, Prashanth" userId="acd106aa-3bb0-4d16-b474-a7fd34266ac2" providerId="ADAL" clId="{94076336-329C-41E7-AD2C-59396ADF07CC}"/>
    <pc:docChg chg="delSld">
      <pc:chgData name="Anamthathmakula, Prashanth" userId="acd106aa-3bb0-4d16-b474-a7fd34266ac2" providerId="ADAL" clId="{94076336-329C-41E7-AD2C-59396ADF07CC}" dt="2023-06-27T17:24:37.998" v="3" actId="47"/>
      <pc:docMkLst>
        <pc:docMk/>
      </pc:docMkLst>
      <pc:sldChg chg="del">
        <pc:chgData name="Anamthathmakula, Prashanth" userId="acd106aa-3bb0-4d16-b474-a7fd34266ac2" providerId="ADAL" clId="{94076336-329C-41E7-AD2C-59396ADF07CC}" dt="2023-06-27T17:24:35.735" v="0" actId="47"/>
        <pc:sldMkLst>
          <pc:docMk/>
          <pc:sldMk cId="2111742621" sldId="258"/>
        </pc:sldMkLst>
      </pc:sldChg>
      <pc:sldChg chg="del">
        <pc:chgData name="Anamthathmakula, Prashanth" userId="acd106aa-3bb0-4d16-b474-a7fd34266ac2" providerId="ADAL" clId="{94076336-329C-41E7-AD2C-59396ADF07CC}" dt="2023-06-27T17:24:37.998" v="3" actId="47"/>
        <pc:sldMkLst>
          <pc:docMk/>
          <pc:sldMk cId="884979180" sldId="261"/>
        </pc:sldMkLst>
      </pc:sldChg>
      <pc:sldChg chg="del">
        <pc:chgData name="Anamthathmakula, Prashanth" userId="acd106aa-3bb0-4d16-b474-a7fd34266ac2" providerId="ADAL" clId="{94076336-329C-41E7-AD2C-59396ADF07CC}" dt="2023-06-27T17:24:36.805" v="1" actId="47"/>
        <pc:sldMkLst>
          <pc:docMk/>
          <pc:sldMk cId="114451985" sldId="267"/>
        </pc:sldMkLst>
      </pc:sldChg>
      <pc:sldChg chg="del">
        <pc:chgData name="Anamthathmakula, Prashanth" userId="acd106aa-3bb0-4d16-b474-a7fd34266ac2" providerId="ADAL" clId="{94076336-329C-41E7-AD2C-59396ADF07CC}" dt="2023-06-27T17:24:37.394" v="2" actId="47"/>
        <pc:sldMkLst>
          <pc:docMk/>
          <pc:sldMk cId="3929210527" sldId="268"/>
        </pc:sldMkLst>
      </pc:sldChg>
    </pc:docChg>
  </pc:docChgLst>
  <pc:docChgLst>
    <pc:chgData name="Anamthathmakula, Prashanth" userId="acd106aa-3bb0-4d16-b474-a7fd34266ac2" providerId="ADAL" clId="{99203C56-3DDF-457E-8813-20F16E9A1A2E}"/>
    <pc:docChg chg="custSel delSld modSld">
      <pc:chgData name="Anamthathmakula, Prashanth" userId="acd106aa-3bb0-4d16-b474-a7fd34266ac2" providerId="ADAL" clId="{99203C56-3DDF-457E-8813-20F16E9A1A2E}" dt="2022-03-28T23:23:25.876" v="245" actId="1038"/>
      <pc:docMkLst>
        <pc:docMk/>
      </pc:docMkLst>
      <pc:sldChg chg="del">
        <pc:chgData name="Anamthathmakula, Prashanth" userId="acd106aa-3bb0-4d16-b474-a7fd34266ac2" providerId="ADAL" clId="{99203C56-3DDF-457E-8813-20F16E9A1A2E}" dt="2022-03-22T22:44:24.131" v="0" actId="47"/>
        <pc:sldMkLst>
          <pc:docMk/>
          <pc:sldMk cId="4198977331" sldId="256"/>
        </pc:sldMkLst>
      </pc:sldChg>
      <pc:sldChg chg="modSp modAnim">
        <pc:chgData name="Anamthathmakula, Prashanth" userId="acd106aa-3bb0-4d16-b474-a7fd34266ac2" providerId="ADAL" clId="{99203C56-3DDF-457E-8813-20F16E9A1A2E}" dt="2022-03-22T22:45:29.163" v="9" actId="20577"/>
        <pc:sldMkLst>
          <pc:docMk/>
          <pc:sldMk cId="2111742621" sldId="258"/>
        </pc:sldMkLst>
        <pc:spChg chg="mod">
          <ac:chgData name="Anamthathmakula, Prashanth" userId="acd106aa-3bb0-4d16-b474-a7fd34266ac2" providerId="ADAL" clId="{99203C56-3DDF-457E-8813-20F16E9A1A2E}" dt="2022-03-22T22:45:29.163" v="9" actId="20577"/>
          <ac:spMkLst>
            <pc:docMk/>
            <pc:sldMk cId="2111742621" sldId="258"/>
            <ac:spMk id="38" creationId="{AA7EE9CC-07E5-4101-A39A-F419AE92038A}"/>
          </ac:spMkLst>
        </pc:spChg>
      </pc:sldChg>
      <pc:sldChg chg="addSp delSp modSp mod">
        <pc:chgData name="Anamthathmakula, Prashanth" userId="acd106aa-3bb0-4d16-b474-a7fd34266ac2" providerId="ADAL" clId="{99203C56-3DDF-457E-8813-20F16E9A1A2E}" dt="2022-03-28T23:23:25.876" v="245" actId="1038"/>
        <pc:sldMkLst>
          <pc:docMk/>
          <pc:sldMk cId="884979180" sldId="261"/>
        </pc:sldMkLst>
        <pc:spChg chg="mod">
          <ac:chgData name="Anamthathmakula, Prashanth" userId="acd106aa-3bb0-4d16-b474-a7fd34266ac2" providerId="ADAL" clId="{99203C56-3DDF-457E-8813-20F16E9A1A2E}" dt="2022-03-28T21:54:17.927" v="46" actId="20577"/>
          <ac:spMkLst>
            <pc:docMk/>
            <pc:sldMk cId="884979180" sldId="261"/>
            <ac:spMk id="5" creationId="{81A1EAC8-C9E3-4E56-B597-ED357EA10843}"/>
          </ac:spMkLst>
        </pc:spChg>
        <pc:spChg chg="add mod">
          <ac:chgData name="Anamthathmakula, Prashanth" userId="acd106aa-3bb0-4d16-b474-a7fd34266ac2" providerId="ADAL" clId="{99203C56-3DDF-457E-8813-20F16E9A1A2E}" dt="2022-03-28T23:16:32.243" v="187" actId="1036"/>
          <ac:spMkLst>
            <pc:docMk/>
            <pc:sldMk cId="884979180" sldId="261"/>
            <ac:spMk id="7" creationId="{13CA6BA4-6009-49AB-9BBB-BA1D86478B9E}"/>
          </ac:spMkLst>
        </pc:spChg>
        <pc:spChg chg="add mod">
          <ac:chgData name="Anamthathmakula, Prashanth" userId="acd106aa-3bb0-4d16-b474-a7fd34266ac2" providerId="ADAL" clId="{99203C56-3DDF-457E-8813-20F16E9A1A2E}" dt="2022-03-28T23:23:07.518" v="231" actId="1037"/>
          <ac:spMkLst>
            <pc:docMk/>
            <pc:sldMk cId="884979180" sldId="261"/>
            <ac:spMk id="8" creationId="{4332E976-BB8D-4969-852A-41FFD205C448}"/>
          </ac:spMkLst>
        </pc:spChg>
        <pc:spChg chg="add mod">
          <ac:chgData name="Anamthathmakula, Prashanth" userId="acd106aa-3bb0-4d16-b474-a7fd34266ac2" providerId="ADAL" clId="{99203C56-3DDF-457E-8813-20F16E9A1A2E}" dt="2022-03-28T21:56:09.024" v="151" actId="1037"/>
          <ac:spMkLst>
            <pc:docMk/>
            <pc:sldMk cId="884979180" sldId="261"/>
            <ac:spMk id="9" creationId="{5EE0B266-2382-44E6-83A1-E7AC28BE4368}"/>
          </ac:spMkLst>
        </pc:spChg>
        <pc:graphicFrameChg chg="add mod">
          <ac:chgData name="Anamthathmakula, Prashanth" userId="acd106aa-3bb0-4d16-b474-a7fd34266ac2" providerId="ADAL" clId="{99203C56-3DDF-457E-8813-20F16E9A1A2E}" dt="2022-03-28T23:23:25.876" v="245" actId="1038"/>
          <ac:graphicFrameMkLst>
            <pc:docMk/>
            <pc:sldMk cId="884979180" sldId="261"/>
            <ac:graphicFrameMk id="4" creationId="{9672BCCF-DFCA-45B1-B138-E088386AE658}"/>
          </ac:graphicFrameMkLst>
        </pc:graphicFrameChg>
        <pc:graphicFrameChg chg="del mod">
          <ac:chgData name="Anamthathmakula, Prashanth" userId="acd106aa-3bb0-4d16-b474-a7fd34266ac2" providerId="ADAL" clId="{99203C56-3DDF-457E-8813-20F16E9A1A2E}" dt="2022-03-28T23:15:48.331" v="155" actId="478"/>
          <ac:graphicFrameMkLst>
            <pc:docMk/>
            <pc:sldMk cId="884979180" sldId="261"/>
            <ac:graphicFrameMk id="6" creationId="{99A9DD07-344A-445E-828A-AF45B28C6876}"/>
          </ac:graphicFrameMkLst>
        </pc:graphicFrameChg>
        <pc:graphicFrameChg chg="add del mod">
          <ac:chgData name="Anamthathmakula, Prashanth" userId="acd106aa-3bb0-4d16-b474-a7fd34266ac2" providerId="ADAL" clId="{99203C56-3DDF-457E-8813-20F16E9A1A2E}" dt="2022-03-28T23:22:55.301" v="205" actId="478"/>
          <ac:graphicFrameMkLst>
            <pc:docMk/>
            <pc:sldMk cId="884979180" sldId="261"/>
            <ac:graphicFrameMk id="10" creationId="{C27615DD-A300-46E4-9A66-5E4F1805AFFF}"/>
          </ac:graphicFrameMkLst>
        </pc:graphicFrameChg>
        <pc:graphicFrameChg chg="add del mod">
          <ac:chgData name="Anamthathmakula, Prashanth" userId="acd106aa-3bb0-4d16-b474-a7fd34266ac2" providerId="ADAL" clId="{99203C56-3DDF-457E-8813-20F16E9A1A2E}" dt="2022-03-28T23:22:55.301" v="205" actId="478"/>
          <ac:graphicFrameMkLst>
            <pc:docMk/>
            <pc:sldMk cId="884979180" sldId="261"/>
            <ac:graphicFrameMk id="11" creationId="{7F7DF3A8-B180-4D32-9FCD-6707D3933DBE}"/>
          </ac:graphicFrameMkLst>
        </pc:graphicFrameChg>
        <pc:graphicFrameChg chg="add mod">
          <ac:chgData name="Anamthathmakula, Prashanth" userId="acd106aa-3bb0-4d16-b474-a7fd34266ac2" providerId="ADAL" clId="{99203C56-3DDF-457E-8813-20F16E9A1A2E}" dt="2022-03-28T23:22:20.379" v="200" actId="14100"/>
          <ac:graphicFrameMkLst>
            <pc:docMk/>
            <pc:sldMk cId="884979180" sldId="261"/>
            <ac:graphicFrameMk id="12" creationId="{6170E14C-D895-4D6B-B862-D0551EAA4C89}"/>
          </ac:graphicFrameMkLst>
        </pc:graphicFrameChg>
        <pc:graphicFrameChg chg="add mod">
          <ac:chgData name="Anamthathmakula, Prashanth" userId="acd106aa-3bb0-4d16-b474-a7fd34266ac2" providerId="ADAL" clId="{99203C56-3DDF-457E-8813-20F16E9A1A2E}" dt="2022-03-28T23:23:13.150" v="241" actId="1037"/>
          <ac:graphicFrameMkLst>
            <pc:docMk/>
            <pc:sldMk cId="884979180" sldId="261"/>
            <ac:graphicFrameMk id="13" creationId="{C240872B-0DA7-49D3-BF01-CEA0E73000D3}"/>
          </ac:graphicFrameMkLst>
        </pc:graphicFrameChg>
      </pc:sldChg>
      <pc:sldChg chg="del">
        <pc:chgData name="Anamthathmakula, Prashanth" userId="acd106aa-3bb0-4d16-b474-a7fd34266ac2" providerId="ADAL" clId="{99203C56-3DDF-457E-8813-20F16E9A1A2E}" dt="2022-03-28T21:55:34.979" v="61" actId="47"/>
        <pc:sldMkLst>
          <pc:docMk/>
          <pc:sldMk cId="440835545" sldId="262"/>
        </pc:sldMkLst>
      </pc:sldChg>
      <pc:sldChg chg="del">
        <pc:chgData name="Anamthathmakula, Prashanth" userId="acd106aa-3bb0-4d16-b474-a7fd34266ac2" providerId="ADAL" clId="{99203C56-3DDF-457E-8813-20F16E9A1A2E}" dt="2022-03-22T22:48:18.070" v="18" actId="47"/>
        <pc:sldMkLst>
          <pc:docMk/>
          <pc:sldMk cId="1412564780" sldId="263"/>
        </pc:sldMkLst>
      </pc:sldChg>
      <pc:sldChg chg="del">
        <pc:chgData name="Anamthathmakula, Prashanth" userId="acd106aa-3bb0-4d16-b474-a7fd34266ac2" providerId="ADAL" clId="{99203C56-3DDF-457E-8813-20F16E9A1A2E}" dt="2022-03-22T22:45:20.908" v="5" actId="47"/>
        <pc:sldMkLst>
          <pc:docMk/>
          <pc:sldMk cId="2130732338" sldId="264"/>
        </pc:sldMkLst>
      </pc:sldChg>
      <pc:sldChg chg="addSp delSp modSp mod modAnim">
        <pc:chgData name="Anamthathmakula, Prashanth" userId="acd106aa-3bb0-4d16-b474-a7fd34266ac2" providerId="ADAL" clId="{99203C56-3DDF-457E-8813-20F16E9A1A2E}" dt="2022-03-28T23:21:16.854" v="191" actId="1076"/>
        <pc:sldMkLst>
          <pc:docMk/>
          <pc:sldMk cId="3051900559" sldId="265"/>
        </pc:sldMkLst>
        <pc:graphicFrameChg chg="add del mod">
          <ac:chgData name="Anamthathmakula, Prashanth" userId="acd106aa-3bb0-4d16-b474-a7fd34266ac2" providerId="ADAL" clId="{99203C56-3DDF-457E-8813-20F16E9A1A2E}" dt="2022-03-28T23:21:07.702" v="189" actId="478"/>
          <ac:graphicFrameMkLst>
            <pc:docMk/>
            <pc:sldMk cId="3051900559" sldId="265"/>
            <ac:graphicFrameMk id="52" creationId="{C9767EE0-1F88-49E2-ACD6-541D4D4E5316}"/>
          </ac:graphicFrameMkLst>
        </pc:graphicFrameChg>
        <pc:graphicFrameChg chg="del">
          <ac:chgData name="Anamthathmakula, Prashanth" userId="acd106aa-3bb0-4d16-b474-a7fd34266ac2" providerId="ADAL" clId="{99203C56-3DDF-457E-8813-20F16E9A1A2E}" dt="2022-03-28T23:15:23.001" v="152" actId="478"/>
          <ac:graphicFrameMkLst>
            <pc:docMk/>
            <pc:sldMk cId="3051900559" sldId="265"/>
            <ac:graphicFrameMk id="53" creationId="{B57265BB-C8C4-48AA-82E3-60439F1838FE}"/>
          </ac:graphicFrameMkLst>
        </pc:graphicFrameChg>
        <pc:graphicFrameChg chg="add mod">
          <ac:chgData name="Anamthathmakula, Prashanth" userId="acd106aa-3bb0-4d16-b474-a7fd34266ac2" providerId="ADAL" clId="{99203C56-3DDF-457E-8813-20F16E9A1A2E}" dt="2022-03-28T23:21:16.854" v="191" actId="1076"/>
          <ac:graphicFrameMkLst>
            <pc:docMk/>
            <pc:sldMk cId="3051900559" sldId="265"/>
            <ac:graphicFrameMk id="53" creationId="{EE8F3FFE-935E-43DA-AFCF-3FFB149C3307}"/>
          </ac:graphicFrameMkLst>
        </pc:graphicFrameChg>
      </pc:sldChg>
      <pc:sldChg chg="del">
        <pc:chgData name="Anamthathmakula, Prashanth" userId="acd106aa-3bb0-4d16-b474-a7fd34266ac2" providerId="ADAL" clId="{99203C56-3DDF-457E-8813-20F16E9A1A2E}" dt="2022-03-22T22:44:28.902" v="3" actId="47"/>
        <pc:sldMkLst>
          <pc:docMk/>
          <pc:sldMk cId="1376286918" sldId="266"/>
        </pc:sldMkLst>
      </pc:sldChg>
      <pc:sldChg chg="modSp mod modAnim">
        <pc:chgData name="Anamthathmakula, Prashanth" userId="acd106aa-3bb0-4d16-b474-a7fd34266ac2" providerId="ADAL" clId="{99203C56-3DDF-457E-8813-20F16E9A1A2E}" dt="2022-03-22T22:47:36.987" v="11"/>
        <pc:sldMkLst>
          <pc:docMk/>
          <pc:sldMk cId="114451985" sldId="267"/>
        </pc:sldMkLst>
        <pc:spChg chg="mod">
          <ac:chgData name="Anamthathmakula, Prashanth" userId="acd106aa-3bb0-4d16-b474-a7fd34266ac2" providerId="ADAL" clId="{99203C56-3DDF-457E-8813-20F16E9A1A2E}" dt="2022-03-22T22:47:36.987" v="11"/>
          <ac:spMkLst>
            <pc:docMk/>
            <pc:sldMk cId="114451985" sldId="267"/>
            <ac:spMk id="24" creationId="{AEC4B2D0-4978-4154-A8B9-C67D61C533EB}"/>
          </ac:spMkLst>
        </pc:spChg>
      </pc:sldChg>
      <pc:sldChg chg="del">
        <pc:chgData name="Anamthathmakula, Prashanth" userId="acd106aa-3bb0-4d16-b474-a7fd34266ac2" providerId="ADAL" clId="{99203C56-3DDF-457E-8813-20F16E9A1A2E}" dt="2022-03-22T22:44:25.737" v="1" actId="47"/>
        <pc:sldMkLst>
          <pc:docMk/>
          <pc:sldMk cId="1426629886" sldId="268"/>
        </pc:sldMkLst>
      </pc:sldChg>
      <pc:sldChg chg="del">
        <pc:chgData name="Anamthathmakula, Prashanth" userId="acd106aa-3bb0-4d16-b474-a7fd34266ac2" providerId="ADAL" clId="{99203C56-3DDF-457E-8813-20F16E9A1A2E}" dt="2022-03-22T22:47:57.436" v="15" actId="47"/>
        <pc:sldMkLst>
          <pc:docMk/>
          <pc:sldMk cId="3577520813" sldId="271"/>
        </pc:sldMkLst>
      </pc:sldChg>
      <pc:sldChg chg="del">
        <pc:chgData name="Anamthathmakula, Prashanth" userId="acd106aa-3bb0-4d16-b474-a7fd34266ac2" providerId="ADAL" clId="{99203C56-3DDF-457E-8813-20F16E9A1A2E}" dt="2022-03-22T22:44:27.708" v="2" actId="47"/>
        <pc:sldMkLst>
          <pc:docMk/>
          <pc:sldMk cId="2128048327" sldId="272"/>
        </pc:sldMkLst>
      </pc:sldChg>
      <pc:sldChg chg="del">
        <pc:chgData name="Anamthathmakula, Prashanth" userId="acd106aa-3bb0-4d16-b474-a7fd34266ac2" providerId="ADAL" clId="{99203C56-3DDF-457E-8813-20F16E9A1A2E}" dt="2022-03-22T22:47:59.271" v="17" actId="47"/>
        <pc:sldMkLst>
          <pc:docMk/>
          <pc:sldMk cId="3868605658" sldId="273"/>
        </pc:sldMkLst>
      </pc:sldChg>
      <pc:sldChg chg="del">
        <pc:chgData name="Anamthathmakula, Prashanth" userId="acd106aa-3bb0-4d16-b474-a7fd34266ac2" providerId="ADAL" clId="{99203C56-3DDF-457E-8813-20F16E9A1A2E}" dt="2022-03-22T22:47:58.325" v="16" actId="47"/>
        <pc:sldMkLst>
          <pc:docMk/>
          <pc:sldMk cId="3514584103" sldId="274"/>
        </pc:sldMkLst>
      </pc:sldChg>
      <pc:sldChg chg="del">
        <pc:chgData name="Anamthathmakula, Prashanth" userId="acd106aa-3bb0-4d16-b474-a7fd34266ac2" providerId="ADAL" clId="{99203C56-3DDF-457E-8813-20F16E9A1A2E}" dt="2022-03-22T22:47:56.100" v="14" actId="47"/>
        <pc:sldMkLst>
          <pc:docMk/>
          <pc:sldMk cId="3822711728" sldId="275"/>
        </pc:sldMkLst>
      </pc:sldChg>
      <pc:sldChg chg="del">
        <pc:chgData name="Anamthathmakula, Prashanth" userId="acd106aa-3bb0-4d16-b474-a7fd34266ac2" providerId="ADAL" clId="{99203C56-3DDF-457E-8813-20F16E9A1A2E}" dt="2022-03-22T22:47:55.344" v="13" actId="47"/>
        <pc:sldMkLst>
          <pc:docMk/>
          <pc:sldMk cId="1877281509" sldId="276"/>
        </pc:sldMkLst>
      </pc:sldChg>
      <pc:sldChg chg="del">
        <pc:chgData name="Anamthathmakula, Prashanth" userId="acd106aa-3bb0-4d16-b474-a7fd34266ac2" providerId="ADAL" clId="{99203C56-3DDF-457E-8813-20F16E9A1A2E}" dt="2022-03-22T22:47:54.535" v="12" actId="47"/>
        <pc:sldMkLst>
          <pc:docMk/>
          <pc:sldMk cId="1873993773" sldId="277"/>
        </pc:sldMkLst>
      </pc:sldChg>
    </pc:docChg>
  </pc:docChgLst>
  <pc:docChgLst>
    <pc:chgData name="Anamthathmakula, Prashanth" userId="acd106aa-3bb0-4d16-b474-a7fd34266ac2" providerId="ADAL" clId="{5801C40E-8439-4510-B435-36B0A81F23F4}"/>
    <pc:docChg chg="custSel delSld modSld sldOrd">
      <pc:chgData name="Anamthathmakula, Prashanth" userId="acd106aa-3bb0-4d16-b474-a7fd34266ac2" providerId="ADAL" clId="{5801C40E-8439-4510-B435-36B0A81F23F4}" dt="2022-10-15T21:19:13.253" v="409" actId="6549"/>
      <pc:docMkLst>
        <pc:docMk/>
      </pc:docMkLst>
      <pc:sldChg chg="addSp delSp modSp mod">
        <pc:chgData name="Anamthathmakula, Prashanth" userId="acd106aa-3bb0-4d16-b474-a7fd34266ac2" providerId="ADAL" clId="{5801C40E-8439-4510-B435-36B0A81F23F4}" dt="2022-10-15T21:13:27.643" v="406" actId="1038"/>
        <pc:sldMkLst>
          <pc:docMk/>
          <pc:sldMk cId="884979180" sldId="261"/>
        </pc:sldMkLst>
        <pc:graphicFrameChg chg="add mod">
          <ac:chgData name="Anamthathmakula, Prashanth" userId="acd106aa-3bb0-4d16-b474-a7fd34266ac2" providerId="ADAL" clId="{5801C40E-8439-4510-B435-36B0A81F23F4}" dt="2022-10-15T21:13:27.643" v="406" actId="1038"/>
          <ac:graphicFrameMkLst>
            <pc:docMk/>
            <pc:sldMk cId="884979180" sldId="261"/>
            <ac:graphicFrameMk id="2" creationId="{B4B77297-6323-095F-EF08-8B34E8D91597}"/>
          </ac:graphicFrameMkLst>
        </pc:graphicFrameChg>
        <pc:graphicFrameChg chg="add mod">
          <ac:chgData name="Anamthathmakula, Prashanth" userId="acd106aa-3bb0-4d16-b474-a7fd34266ac2" providerId="ADAL" clId="{5801C40E-8439-4510-B435-36B0A81F23F4}" dt="2022-10-15T21:13:01.219" v="184" actId="1038"/>
          <ac:graphicFrameMkLst>
            <pc:docMk/>
            <pc:sldMk cId="884979180" sldId="261"/>
            <ac:graphicFrameMk id="3" creationId="{F0A8237D-9E9A-35B8-0D13-0E36D015E00A}"/>
          </ac:graphicFrameMkLst>
        </pc:graphicFrameChg>
        <pc:graphicFrameChg chg="del">
          <ac:chgData name="Anamthathmakula, Prashanth" userId="acd106aa-3bb0-4d16-b474-a7fd34266ac2" providerId="ADAL" clId="{5801C40E-8439-4510-B435-36B0A81F23F4}" dt="2022-10-15T21:12:53.043" v="131" actId="478"/>
          <ac:graphicFrameMkLst>
            <pc:docMk/>
            <pc:sldMk cId="884979180" sldId="261"/>
            <ac:graphicFrameMk id="12" creationId="{6170E14C-D895-4D6B-B862-D0551EAA4C89}"/>
          </ac:graphicFrameMkLst>
        </pc:graphicFrameChg>
        <pc:graphicFrameChg chg="del">
          <ac:chgData name="Anamthathmakula, Prashanth" userId="acd106aa-3bb0-4d16-b474-a7fd34266ac2" providerId="ADAL" clId="{5801C40E-8439-4510-B435-36B0A81F23F4}" dt="2022-10-15T21:13:04.379" v="185" actId="478"/>
          <ac:graphicFrameMkLst>
            <pc:docMk/>
            <pc:sldMk cId="884979180" sldId="261"/>
            <ac:graphicFrameMk id="13" creationId="{C240872B-0DA7-49D3-BF01-CEA0E73000D3}"/>
          </ac:graphicFrameMkLst>
        </pc:graphicFrameChg>
      </pc:sldChg>
      <pc:sldChg chg="addSp delSp modSp mod modNotesTx">
        <pc:chgData name="Anamthathmakula, Prashanth" userId="acd106aa-3bb0-4d16-b474-a7fd34266ac2" providerId="ADAL" clId="{5801C40E-8439-4510-B435-36B0A81F23F4}" dt="2022-10-15T21:19:13.253" v="409" actId="6549"/>
        <pc:sldMkLst>
          <pc:docMk/>
          <pc:sldMk cId="3929210527" sldId="268"/>
        </pc:sldMkLst>
        <pc:graphicFrameChg chg="add mod">
          <ac:chgData name="Anamthathmakula, Prashanth" userId="acd106aa-3bb0-4d16-b474-a7fd34266ac2" providerId="ADAL" clId="{5801C40E-8439-4510-B435-36B0A81F23F4}" dt="2022-10-15T21:11:03.886" v="67" actId="1036"/>
          <ac:graphicFrameMkLst>
            <pc:docMk/>
            <pc:sldMk cId="3929210527" sldId="268"/>
            <ac:graphicFrameMk id="6" creationId="{1EEE51AA-C095-B108-6342-55DE875D26F3}"/>
          </ac:graphicFrameMkLst>
        </pc:graphicFrameChg>
        <pc:graphicFrameChg chg="add mod">
          <ac:chgData name="Anamthathmakula, Prashanth" userId="acd106aa-3bb0-4d16-b474-a7fd34266ac2" providerId="ADAL" clId="{5801C40E-8439-4510-B435-36B0A81F23F4}" dt="2022-10-15T21:11:44.628" v="126" actId="1038"/>
          <ac:graphicFrameMkLst>
            <pc:docMk/>
            <pc:sldMk cId="3929210527" sldId="268"/>
            <ac:graphicFrameMk id="20" creationId="{3B1C13D8-2F10-2EA5-FBA6-B6F772272BA4}"/>
          </ac:graphicFrameMkLst>
        </pc:graphicFrameChg>
        <pc:graphicFrameChg chg="del">
          <ac:chgData name="Anamthathmakula, Prashanth" userId="acd106aa-3bb0-4d16-b474-a7fd34266ac2" providerId="ADAL" clId="{5801C40E-8439-4510-B435-36B0A81F23F4}" dt="2022-10-15T21:10:52.601" v="42" actId="478"/>
          <ac:graphicFrameMkLst>
            <pc:docMk/>
            <pc:sldMk cId="3929210527" sldId="268"/>
            <ac:graphicFrameMk id="49" creationId="{7C730DE7-339B-AB6D-3279-47FDF972C902}"/>
          </ac:graphicFrameMkLst>
        </pc:graphicFrameChg>
        <pc:graphicFrameChg chg="del">
          <ac:chgData name="Anamthathmakula, Prashanth" userId="acd106aa-3bb0-4d16-b474-a7fd34266ac2" providerId="ADAL" clId="{5801C40E-8439-4510-B435-36B0A81F23F4}" dt="2022-10-15T21:11:27.434" v="105" actId="478"/>
          <ac:graphicFrameMkLst>
            <pc:docMk/>
            <pc:sldMk cId="3929210527" sldId="268"/>
            <ac:graphicFrameMk id="52" creationId="{52F13857-57B4-2839-8ED9-288D23F2F202}"/>
          </ac:graphicFrameMkLst>
        </pc:graphicFrameChg>
      </pc:sldChg>
      <pc:sldChg chg="del">
        <pc:chgData name="Anamthathmakula, Prashanth" userId="acd106aa-3bb0-4d16-b474-a7fd34266ac2" providerId="ADAL" clId="{5801C40E-8439-4510-B435-36B0A81F23F4}" dt="2022-10-15T21:13:38.984" v="407" actId="47"/>
        <pc:sldMkLst>
          <pc:docMk/>
          <pc:sldMk cId="2091280263" sldId="269"/>
        </pc:sldMkLst>
      </pc:sldChg>
      <pc:sldChg chg="del ord">
        <pc:chgData name="Anamthathmakula, Prashanth" userId="acd106aa-3bb0-4d16-b474-a7fd34266ac2" providerId="ADAL" clId="{5801C40E-8439-4510-B435-36B0A81F23F4}" dt="2022-10-15T21:13:40.055" v="408" actId="47"/>
        <pc:sldMkLst>
          <pc:docMk/>
          <pc:sldMk cId="2457040634" sldId="270"/>
        </pc:sldMkLst>
      </pc:sldChg>
    </pc:docChg>
  </pc:docChgLst>
  <pc:docChgLst>
    <pc:chgData name="Prashanth Anamthathmakula" userId="acd106aa-3bb0-4d16-b474-a7fd34266ac2" providerId="ADAL" clId="{99203C56-3DDF-457E-8813-20F16E9A1A2E}"/>
    <pc:docChg chg="undo redo custSel modSld">
      <pc:chgData name="Prashanth Anamthathmakula" userId="acd106aa-3bb0-4d16-b474-a7fd34266ac2" providerId="ADAL" clId="{99203C56-3DDF-457E-8813-20F16E9A1A2E}" dt="2022-03-27T23:30:18.101" v="167" actId="1076"/>
      <pc:docMkLst>
        <pc:docMk/>
      </pc:docMkLst>
      <pc:sldChg chg="addSp delSp modSp mod">
        <pc:chgData name="Prashanth Anamthathmakula" userId="acd106aa-3bb0-4d16-b474-a7fd34266ac2" providerId="ADAL" clId="{99203C56-3DDF-457E-8813-20F16E9A1A2E}" dt="2022-03-27T23:29:30.096" v="155" actId="20577"/>
        <pc:sldMkLst>
          <pc:docMk/>
          <pc:sldMk cId="2111742621" sldId="258"/>
        </pc:sldMkLst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2" creationId="{A7B14A54-065E-457F-9B34-0D9E91528766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4" creationId="{D138B3FA-9200-4F9F-A1CF-BFEEA3FA7E87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5" creationId="{D56F740E-59EE-4F20-9588-161102EE92C5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6" creationId="{023F3340-538C-4A09-BBC0-C01D61C404BE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7" creationId="{A390A641-BA7C-4CE0-94EF-5729069DEB9D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8" creationId="{3F093D78-836F-4C60-A980-A985A5F24636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29" creationId="{5C1AFF33-A827-4DB6-A274-DCF3E2E50F0F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0" creationId="{42E5163D-FF34-4123-88FF-FDC9016A9CD4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1" creationId="{09101D47-BD16-4E0B-8F30-97B1B99ACA1B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2" creationId="{3636C643-94B8-4C34-99CF-253441208569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3" creationId="{662591CC-8952-4BD9-B100-FE06EFDCAFE3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4" creationId="{26CBD004-0186-41D6-9EBF-E7E94A479F53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5" creationId="{D8EB419E-C2F1-490F-9BCB-53AF73E68B22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6" creationId="{8848C951-7C2C-47D4-9240-B64E7506D2C1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37" creationId="{3BB6EBE6-2CBA-44B5-A25C-175AEA1989C0}"/>
          </ac:spMkLst>
        </pc:spChg>
        <pc:spChg chg="mod">
          <ac:chgData name="Prashanth Anamthathmakula" userId="acd106aa-3bb0-4d16-b474-a7fd34266ac2" providerId="ADAL" clId="{99203C56-3DDF-457E-8813-20F16E9A1A2E}" dt="2022-03-27T23:29:30.096" v="155" actId="20577"/>
          <ac:spMkLst>
            <pc:docMk/>
            <pc:sldMk cId="2111742621" sldId="258"/>
            <ac:spMk id="38" creationId="{AA7EE9CC-07E5-4101-A39A-F419AE92038A}"/>
          </ac:spMkLst>
        </pc:spChg>
        <pc:spChg chg="add mod">
          <ac:chgData name="Prashanth Anamthathmakula" userId="acd106aa-3bb0-4d16-b474-a7fd34266ac2" providerId="ADAL" clId="{99203C56-3DDF-457E-8813-20F16E9A1A2E}" dt="2022-03-27T21:41:26.875" v="43" actId="113"/>
          <ac:spMkLst>
            <pc:docMk/>
            <pc:sldMk cId="2111742621" sldId="258"/>
            <ac:spMk id="40" creationId="{3200CD8B-175E-4E0D-BD70-C65F69A43D09}"/>
          </ac:spMkLst>
        </pc:spChg>
        <pc:spChg chg="add mod">
          <ac:chgData name="Prashanth Anamthathmakula" userId="acd106aa-3bb0-4d16-b474-a7fd34266ac2" providerId="ADAL" clId="{99203C56-3DDF-457E-8813-20F16E9A1A2E}" dt="2022-03-27T21:41:26.875" v="43" actId="113"/>
          <ac:spMkLst>
            <pc:docMk/>
            <pc:sldMk cId="2111742621" sldId="258"/>
            <ac:spMk id="42" creationId="{50CD9043-87A5-49BE-8DA5-7ED53DF6919A}"/>
          </ac:spMkLst>
        </pc:spChg>
        <pc:spChg chg="add mod">
          <ac:chgData name="Prashanth Anamthathmakula" userId="acd106aa-3bb0-4d16-b474-a7fd34266ac2" providerId="ADAL" clId="{99203C56-3DDF-457E-8813-20F16E9A1A2E}" dt="2022-03-27T21:41:26.875" v="43" actId="113"/>
          <ac:spMkLst>
            <pc:docMk/>
            <pc:sldMk cId="2111742621" sldId="258"/>
            <ac:spMk id="43" creationId="{6096B0FB-3C6C-4A16-B869-667DDC9610FF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56" creationId="{838EB74D-E25E-4CA8-9B8D-6EF9787AB8DA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57" creationId="{1E471A2E-23E3-4455-B5EF-22AAE892CFCF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58" creationId="{BCC30D43-8AE5-498E-AFC2-E9366A118530}"/>
          </ac:spMkLst>
        </pc:spChg>
        <pc:spChg chg="mod">
          <ac:chgData name="Prashanth Anamthathmakula" userId="acd106aa-3bb0-4d16-b474-a7fd34266ac2" providerId="ADAL" clId="{99203C56-3DDF-457E-8813-20F16E9A1A2E}" dt="2022-03-27T21:39:25.830" v="30" actId="255"/>
          <ac:spMkLst>
            <pc:docMk/>
            <pc:sldMk cId="2111742621" sldId="258"/>
            <ac:spMk id="59" creationId="{92523712-B816-457A-84A4-9DC0687168D0}"/>
          </ac:spMkLst>
        </pc:spChg>
        <pc:spChg chg="del">
          <ac:chgData name="Prashanth Anamthathmakula" userId="acd106aa-3bb0-4d16-b474-a7fd34266ac2" providerId="ADAL" clId="{99203C56-3DDF-457E-8813-20F16E9A1A2E}" dt="2022-03-27T21:35:51.716" v="11" actId="478"/>
          <ac:spMkLst>
            <pc:docMk/>
            <pc:sldMk cId="2111742621" sldId="258"/>
            <ac:spMk id="60" creationId="{183318D6-4AD4-41CC-B02E-4BDD6B1C5D1B}"/>
          </ac:spMkLst>
        </pc:sp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3" creationId="{9D4CB597-BC42-4E7C-91D7-863ED537450A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5" creationId="{833403CE-45E6-4BD0-ABD2-43B4E8768435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11" creationId="{07DD7EAF-80BA-4F92-A29B-B5F265F1025F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13" creationId="{14F49E18-610C-4096-BAC1-1416B7924DB1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39" creationId="{2C85C7EA-EA70-4155-9162-9DDC8A797700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41" creationId="{2583A1B2-41DE-492F-94A7-3AB69F3FB24D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45" creationId="{11DA4DE0-B12D-430E-88EA-B945E256B51C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47" creationId="{EE6FA3E5-5FB1-400E-89C2-FF00B6CF38B9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49" creationId="{BB74BA34-C502-4240-82B7-1BAEA0A6CEBE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51" creationId="{87AE3CF1-9B8B-4780-93DC-028FE81F87CF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53" creationId="{964D2C5D-26D9-4D8B-A1A1-785F9397C29F}"/>
          </ac:picMkLst>
        </pc:picChg>
        <pc:picChg chg="mod">
          <ac:chgData name="Prashanth Anamthathmakula" userId="acd106aa-3bb0-4d16-b474-a7fd34266ac2" providerId="ADAL" clId="{99203C56-3DDF-457E-8813-20F16E9A1A2E}" dt="2022-03-27T21:36:38.797" v="21" actId="1076"/>
          <ac:picMkLst>
            <pc:docMk/>
            <pc:sldMk cId="2111742621" sldId="258"/>
            <ac:picMk id="55" creationId="{28B05218-DE2E-4C5D-AADC-D24E948CBEC7}"/>
          </ac:picMkLst>
        </pc:picChg>
      </pc:sldChg>
      <pc:sldChg chg="delSp modSp mod">
        <pc:chgData name="Prashanth Anamthathmakula" userId="acd106aa-3bb0-4d16-b474-a7fd34266ac2" providerId="ADAL" clId="{99203C56-3DDF-457E-8813-20F16E9A1A2E}" dt="2022-03-27T23:29:47.439" v="162" actId="20577"/>
        <pc:sldMkLst>
          <pc:docMk/>
          <pc:sldMk cId="884979180" sldId="261"/>
        </pc:sldMkLst>
        <pc:spChg chg="del">
          <ac:chgData name="Prashanth Anamthathmakula" userId="acd106aa-3bb0-4d16-b474-a7fd34266ac2" providerId="ADAL" clId="{99203C56-3DDF-457E-8813-20F16E9A1A2E}" dt="2022-03-27T23:19:30.493" v="96" actId="478"/>
          <ac:spMkLst>
            <pc:docMk/>
            <pc:sldMk cId="884979180" sldId="261"/>
            <ac:spMk id="2" creationId="{B9A2F2E7-595C-486C-8934-B29ABA7B418E}"/>
          </ac:spMkLst>
        </pc:spChg>
        <pc:spChg chg="mod">
          <ac:chgData name="Prashanth Anamthathmakula" userId="acd106aa-3bb0-4d16-b474-a7fd34266ac2" providerId="ADAL" clId="{99203C56-3DDF-457E-8813-20F16E9A1A2E}" dt="2022-03-27T23:29:47.439" v="162" actId="20577"/>
          <ac:spMkLst>
            <pc:docMk/>
            <pc:sldMk cId="884979180" sldId="261"/>
            <ac:spMk id="5" creationId="{81A1EAC8-C9E3-4E56-B597-ED357EA10843}"/>
          </ac:spMkLst>
        </pc:spChg>
      </pc:sldChg>
      <pc:sldChg chg="delSp modSp mod">
        <pc:chgData name="Prashanth Anamthathmakula" userId="acd106aa-3bb0-4d16-b474-a7fd34266ac2" providerId="ADAL" clId="{99203C56-3DDF-457E-8813-20F16E9A1A2E}" dt="2022-03-27T23:30:18.101" v="167" actId="1076"/>
        <pc:sldMkLst>
          <pc:docMk/>
          <pc:sldMk cId="440835545" sldId="262"/>
        </pc:sldMkLst>
        <pc:spChg chg="del">
          <ac:chgData name="Prashanth Anamthathmakula" userId="acd106aa-3bb0-4d16-b474-a7fd34266ac2" providerId="ADAL" clId="{99203C56-3DDF-457E-8813-20F16E9A1A2E}" dt="2022-03-27T23:19:08.740" v="95" actId="478"/>
          <ac:spMkLst>
            <pc:docMk/>
            <pc:sldMk cId="440835545" sldId="262"/>
            <ac:spMk id="3" creationId="{27D501D6-590D-458C-9F77-0FAE0DEF729C}"/>
          </ac:spMkLst>
        </pc:spChg>
        <pc:spChg chg="mod">
          <ac:chgData name="Prashanth Anamthathmakula" userId="acd106aa-3bb0-4d16-b474-a7fd34266ac2" providerId="ADAL" clId="{99203C56-3DDF-457E-8813-20F16E9A1A2E}" dt="2022-03-27T23:30:18.101" v="167" actId="1076"/>
          <ac:spMkLst>
            <pc:docMk/>
            <pc:sldMk cId="440835545" sldId="262"/>
            <ac:spMk id="4" creationId="{51A371A4-F992-401D-99DC-23D34979F155}"/>
          </ac:spMkLst>
        </pc:spChg>
      </pc:sldChg>
      <pc:sldChg chg="delSp modSp mod modNotesTx">
        <pc:chgData name="Prashanth Anamthathmakula" userId="acd106aa-3bb0-4d16-b474-a7fd34266ac2" providerId="ADAL" clId="{99203C56-3DDF-457E-8813-20F16E9A1A2E}" dt="2022-03-27T23:27:49.910" v="145" actId="20577"/>
        <pc:sldMkLst>
          <pc:docMk/>
          <pc:sldMk cId="3051900559" sldId="265"/>
        </pc:sldMkLst>
        <pc:spChg chg="mod">
          <ac:chgData name="Prashanth Anamthathmakula" userId="acd106aa-3bb0-4d16-b474-a7fd34266ac2" providerId="ADAL" clId="{99203C56-3DDF-457E-8813-20F16E9A1A2E}" dt="2022-03-27T23:27:49.910" v="145" actId="20577"/>
          <ac:spMkLst>
            <pc:docMk/>
            <pc:sldMk cId="3051900559" sldId="265"/>
            <ac:spMk id="44" creationId="{338D29B4-02E2-4D20-A731-4A2684B40490}"/>
          </ac:spMkLst>
        </pc:spChg>
        <pc:spChg chg="mod">
          <ac:chgData name="Prashanth Anamthathmakula" userId="acd106aa-3bb0-4d16-b474-a7fd34266ac2" providerId="ADAL" clId="{99203C56-3DDF-457E-8813-20F16E9A1A2E}" dt="2022-03-27T21:46:09.994" v="75" actId="113"/>
          <ac:spMkLst>
            <pc:docMk/>
            <pc:sldMk cId="3051900559" sldId="265"/>
            <ac:spMk id="45" creationId="{A455588E-6894-402B-95FB-0A33A6356546}"/>
          </ac:spMkLst>
        </pc:spChg>
        <pc:spChg chg="mod">
          <ac:chgData name="Prashanth Anamthathmakula" userId="acd106aa-3bb0-4d16-b474-a7fd34266ac2" providerId="ADAL" clId="{99203C56-3DDF-457E-8813-20F16E9A1A2E}" dt="2022-03-27T21:46:09.994" v="75" actId="113"/>
          <ac:spMkLst>
            <pc:docMk/>
            <pc:sldMk cId="3051900559" sldId="265"/>
            <ac:spMk id="46" creationId="{C78A37DB-D90C-45F2-A79A-9DB335D7E916}"/>
          </ac:spMkLst>
        </pc:spChg>
        <pc:spChg chg="del">
          <ac:chgData name="Prashanth Anamthathmakula" userId="acd106aa-3bb0-4d16-b474-a7fd34266ac2" providerId="ADAL" clId="{99203C56-3DDF-457E-8813-20F16E9A1A2E}" dt="2022-03-27T22:05:08.733" v="77" actId="478"/>
          <ac:spMkLst>
            <pc:docMk/>
            <pc:sldMk cId="3051900559" sldId="265"/>
            <ac:spMk id="47" creationId="{50110AAF-A2E3-46E6-96D5-F56E87616AB5}"/>
          </ac:spMkLst>
        </pc:spChg>
        <pc:spChg chg="del">
          <ac:chgData name="Prashanth Anamthathmakula" userId="acd106aa-3bb0-4d16-b474-a7fd34266ac2" providerId="ADAL" clId="{99203C56-3DDF-457E-8813-20F16E9A1A2E}" dt="2022-03-27T22:05:26.419" v="78" actId="478"/>
          <ac:spMkLst>
            <pc:docMk/>
            <pc:sldMk cId="3051900559" sldId="265"/>
            <ac:spMk id="48" creationId="{0FF19B30-5548-450C-AAD1-03DFFA26AA3C}"/>
          </ac:spMkLst>
        </pc:spChg>
        <pc:spChg chg="del">
          <ac:chgData name="Prashanth Anamthathmakula" userId="acd106aa-3bb0-4d16-b474-a7fd34266ac2" providerId="ADAL" clId="{99203C56-3DDF-457E-8813-20F16E9A1A2E}" dt="2022-03-27T23:20:01.372" v="97" actId="478"/>
          <ac:spMkLst>
            <pc:docMk/>
            <pc:sldMk cId="3051900559" sldId="265"/>
            <ac:spMk id="49" creationId="{1C945CAF-B123-4390-992A-869CA876B7FC}"/>
          </ac:spMkLst>
        </pc:spChg>
        <pc:spChg chg="mod">
          <ac:chgData name="Prashanth Anamthathmakula" userId="acd106aa-3bb0-4d16-b474-a7fd34266ac2" providerId="ADAL" clId="{99203C56-3DDF-457E-8813-20F16E9A1A2E}" dt="2022-03-27T23:20:08.455" v="109" actId="1036"/>
          <ac:spMkLst>
            <pc:docMk/>
            <pc:sldMk cId="3051900559" sldId="265"/>
            <ac:spMk id="50" creationId="{84469AD4-9C55-4B5E-9176-749D1FD8EFD0}"/>
          </ac:spMkLst>
        </pc:spChg>
        <pc:graphicFrameChg chg="mod">
          <ac:chgData name="Prashanth Anamthathmakula" userId="acd106aa-3bb0-4d16-b474-a7fd34266ac2" providerId="ADAL" clId="{99203C56-3DDF-457E-8813-20F16E9A1A2E}" dt="2022-03-27T23:20:08.455" v="109" actId="1036"/>
          <ac:graphicFrameMkLst>
            <pc:docMk/>
            <pc:sldMk cId="3051900559" sldId="265"/>
            <ac:graphicFrameMk id="53" creationId="{B57265BB-C8C4-48AA-82E3-60439F1838FE}"/>
          </ac:graphicFrameMkLst>
        </pc:graphicFrameChg>
        <pc:picChg chg="mod">
          <ac:chgData name="Prashanth Anamthathmakula" userId="acd106aa-3bb0-4d16-b474-a7fd34266ac2" providerId="ADAL" clId="{99203C56-3DDF-457E-8813-20F16E9A1A2E}" dt="2022-03-27T23:20:24.683" v="125" actId="1035"/>
          <ac:picMkLst>
            <pc:docMk/>
            <pc:sldMk cId="3051900559" sldId="265"/>
            <ac:picMk id="5" creationId="{7F2D0A9E-0B82-45BC-B98C-5883A1EE926C}"/>
          </ac:picMkLst>
        </pc:picChg>
        <pc:picChg chg="mod">
          <ac:chgData name="Prashanth Anamthathmakula" userId="acd106aa-3bb0-4d16-b474-a7fd34266ac2" providerId="ADAL" clId="{99203C56-3DDF-457E-8813-20F16E9A1A2E}" dt="2022-03-27T23:20:24.683" v="125" actId="1035"/>
          <ac:picMkLst>
            <pc:docMk/>
            <pc:sldMk cId="3051900559" sldId="265"/>
            <ac:picMk id="51" creationId="{FC5E5DE5-23A0-4CD0-A24D-29C1E8EF1EEA}"/>
          </ac:picMkLst>
        </pc:picChg>
        <pc:cxnChg chg="mod">
          <ac:chgData name="Prashanth Anamthathmakula" userId="acd106aa-3bb0-4d16-b474-a7fd34266ac2" providerId="ADAL" clId="{99203C56-3DDF-457E-8813-20F16E9A1A2E}" dt="2022-03-27T23:20:39.118" v="126" actId="14100"/>
          <ac:cxnSpMkLst>
            <pc:docMk/>
            <pc:sldMk cId="3051900559" sldId="265"/>
            <ac:cxnSpMk id="54" creationId="{F3B923A3-20FD-4803-B354-95499013A562}"/>
          </ac:cxnSpMkLst>
        </pc:cxnChg>
        <pc:cxnChg chg="mod">
          <ac:chgData name="Prashanth Anamthathmakula" userId="acd106aa-3bb0-4d16-b474-a7fd34266ac2" providerId="ADAL" clId="{99203C56-3DDF-457E-8813-20F16E9A1A2E}" dt="2022-03-27T23:20:43.965" v="127" actId="14100"/>
          <ac:cxnSpMkLst>
            <pc:docMk/>
            <pc:sldMk cId="3051900559" sldId="265"/>
            <ac:cxnSpMk id="55" creationId="{EC5B6035-9C91-4567-8E2E-384F15FB2E80}"/>
          </ac:cxnSpMkLst>
        </pc:cxnChg>
        <pc:cxnChg chg="mod">
          <ac:chgData name="Prashanth Anamthathmakula" userId="acd106aa-3bb0-4d16-b474-a7fd34266ac2" providerId="ADAL" clId="{99203C56-3DDF-457E-8813-20F16E9A1A2E}" dt="2022-03-27T23:20:48.797" v="128" actId="14100"/>
          <ac:cxnSpMkLst>
            <pc:docMk/>
            <pc:sldMk cId="3051900559" sldId="265"/>
            <ac:cxnSpMk id="63" creationId="{C1D0D351-3A7F-46FB-A68E-016D3C142EBC}"/>
          </ac:cxnSpMkLst>
        </pc:cxnChg>
        <pc:cxnChg chg="mod">
          <ac:chgData name="Prashanth Anamthathmakula" userId="acd106aa-3bb0-4d16-b474-a7fd34266ac2" providerId="ADAL" clId="{99203C56-3DDF-457E-8813-20F16E9A1A2E}" dt="2022-03-27T23:20:53.340" v="129" actId="14100"/>
          <ac:cxnSpMkLst>
            <pc:docMk/>
            <pc:sldMk cId="3051900559" sldId="265"/>
            <ac:cxnSpMk id="64" creationId="{530D4952-86C0-44B9-9780-9802D3E210C0}"/>
          </ac:cxnSpMkLst>
        </pc:cxnChg>
      </pc:sldChg>
      <pc:sldChg chg="addSp modSp mod">
        <pc:chgData name="Prashanth Anamthathmakula" userId="acd106aa-3bb0-4d16-b474-a7fd34266ac2" providerId="ADAL" clId="{99203C56-3DDF-457E-8813-20F16E9A1A2E}" dt="2022-03-27T23:29:36.392" v="161" actId="20577"/>
        <pc:sldMkLst>
          <pc:docMk/>
          <pc:sldMk cId="114451985" sldId="267"/>
        </pc:sldMkLst>
        <pc:spChg chg="mod">
          <ac:chgData name="Prashanth Anamthathmakula" userId="acd106aa-3bb0-4d16-b474-a7fd34266ac2" providerId="ADAL" clId="{99203C56-3DDF-457E-8813-20F16E9A1A2E}" dt="2022-03-27T23:29:36.392" v="161" actId="20577"/>
          <ac:spMkLst>
            <pc:docMk/>
            <pc:sldMk cId="114451985" sldId="267"/>
            <ac:spMk id="24" creationId="{AEC4B2D0-4978-4154-A8B9-C67D61C533EB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26" creationId="{5AEE5CD8-5FC9-4143-8694-DB3FFC7B8C4B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27" creationId="{C33245C5-0809-4D8F-9EE0-F1A95C0D9A7C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28" creationId="{A46743DD-38E5-414D-94DB-1B578F971729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29" creationId="{C4EF1A79-043B-4C0C-9388-8D0642C699CE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0" creationId="{E8EF5CEB-8B8E-4D6A-ABF8-72C8AE0E1A1E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1" creationId="{DC71F2D1-272E-441E-B81F-66D2E3D0D2CA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2" creationId="{AE89A4DF-BFDC-4E4F-B693-95CF1708C81B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3" creationId="{9B9BCDF8-B233-42F1-B046-ED3767AE9B5A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4" creationId="{C34AC070-0793-438A-99B6-EE4A4018CD48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5" creationId="{88C3A7F2-3C06-4D17-8495-0F6EBD6B9358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6" creationId="{AB41577C-5DD1-4A5F-BFCE-65F560EA18E3}"/>
          </ac:spMkLst>
        </pc:spChg>
        <pc:spChg chg="mod">
          <ac:chgData name="Prashanth Anamthathmakula" userId="acd106aa-3bb0-4d16-b474-a7fd34266ac2" providerId="ADAL" clId="{99203C56-3DDF-457E-8813-20F16E9A1A2E}" dt="2022-03-27T21:39:59.553" v="32" actId="255"/>
          <ac:spMkLst>
            <pc:docMk/>
            <pc:sldMk cId="114451985" sldId="267"/>
            <ac:spMk id="37" creationId="{CAE727A9-FB24-460A-89AF-80A18A316929}"/>
          </ac:spMkLst>
        </pc:spChg>
        <pc:spChg chg="add mod">
          <ac:chgData name="Prashanth Anamthathmakula" userId="acd106aa-3bb0-4d16-b474-a7fd34266ac2" providerId="ADAL" clId="{99203C56-3DDF-457E-8813-20F16E9A1A2E}" dt="2022-03-27T21:41:33.248" v="44" actId="113"/>
          <ac:spMkLst>
            <pc:docMk/>
            <pc:sldMk cId="114451985" sldId="267"/>
            <ac:spMk id="38" creationId="{C6427920-02F9-4DDB-BCBD-B432A84670AC}"/>
          </ac:spMkLst>
        </pc:spChg>
        <pc:spChg chg="add mod">
          <ac:chgData name="Prashanth Anamthathmakula" userId="acd106aa-3bb0-4d16-b474-a7fd34266ac2" providerId="ADAL" clId="{99203C56-3DDF-457E-8813-20F16E9A1A2E}" dt="2022-03-27T21:41:33.248" v="44" actId="113"/>
          <ac:spMkLst>
            <pc:docMk/>
            <pc:sldMk cId="114451985" sldId="267"/>
            <ac:spMk id="39" creationId="{799C086E-9B4B-4D8B-A1EE-6400EC56386A}"/>
          </ac:spMkLst>
        </pc:spChg>
        <pc:spChg chg="add mod">
          <ac:chgData name="Prashanth Anamthathmakula" userId="acd106aa-3bb0-4d16-b474-a7fd34266ac2" providerId="ADAL" clId="{99203C56-3DDF-457E-8813-20F16E9A1A2E}" dt="2022-03-27T21:41:33.248" v="44" actId="113"/>
          <ac:spMkLst>
            <pc:docMk/>
            <pc:sldMk cId="114451985" sldId="267"/>
            <ac:spMk id="40" creationId="{E6E8CF41-09F6-42D3-84EA-E355CF83494C}"/>
          </ac:spMkLst>
        </pc:spChg>
        <pc:spChg chg="add mod">
          <ac:chgData name="Prashanth Anamthathmakula" userId="acd106aa-3bb0-4d16-b474-a7fd34266ac2" providerId="ADAL" clId="{99203C56-3DDF-457E-8813-20F16E9A1A2E}" dt="2022-03-27T21:41:33.248" v="44" actId="113"/>
          <ac:spMkLst>
            <pc:docMk/>
            <pc:sldMk cId="114451985" sldId="267"/>
            <ac:spMk id="41" creationId="{748DBB01-030B-4032-8F76-4CCF8B3626DC}"/>
          </ac:spMkLst>
        </pc:spChg>
        <pc:spChg chg="add mod">
          <ac:chgData name="Prashanth Anamthathmakula" userId="acd106aa-3bb0-4d16-b474-a7fd34266ac2" providerId="ADAL" clId="{99203C56-3DDF-457E-8813-20F16E9A1A2E}" dt="2022-03-27T21:41:33.248" v="44" actId="113"/>
          <ac:spMkLst>
            <pc:docMk/>
            <pc:sldMk cId="114451985" sldId="267"/>
            <ac:spMk id="42" creationId="{6DE8C23B-2A3C-4CEE-A17C-3D058591308C}"/>
          </ac:spMkLst>
        </pc:spChg>
      </pc:sldChg>
    </pc:docChg>
  </pc:docChgLst>
  <pc:docChgLst>
    <pc:chgData name="Anamthathmakula, Prashanth" userId="acd106aa-3bb0-4d16-b474-a7fd34266ac2" providerId="ADAL" clId="{10DA3185-4380-47B5-9023-1D6E59B6E928}"/>
    <pc:docChg chg="custSel modSld">
      <pc:chgData name="Anamthathmakula, Prashanth" userId="acd106aa-3bb0-4d16-b474-a7fd34266ac2" providerId="ADAL" clId="{10DA3185-4380-47B5-9023-1D6E59B6E928}" dt="2023-07-19T19:07:43.042" v="17" actId="478"/>
      <pc:docMkLst>
        <pc:docMk/>
      </pc:docMkLst>
      <pc:sldChg chg="addSp delSp modSp mod">
        <pc:chgData name="Anamthathmakula, Prashanth" userId="acd106aa-3bb0-4d16-b474-a7fd34266ac2" providerId="ADAL" clId="{10DA3185-4380-47B5-9023-1D6E59B6E928}" dt="2023-07-19T19:07:43.042" v="17" actId="478"/>
        <pc:sldMkLst>
          <pc:docMk/>
          <pc:sldMk cId="3468106434" sldId="269"/>
        </pc:sldMkLst>
        <pc:picChg chg="add del mod">
          <ac:chgData name="Anamthathmakula, Prashanth" userId="acd106aa-3bb0-4d16-b474-a7fd34266ac2" providerId="ADAL" clId="{10DA3185-4380-47B5-9023-1D6E59B6E928}" dt="2023-07-19T19:07:43.042" v="17" actId="478"/>
          <ac:picMkLst>
            <pc:docMk/>
            <pc:sldMk cId="3468106434" sldId="269"/>
            <ac:picMk id="2" creationId="{575D6781-C8A3-8589-96FE-749943D24984}"/>
          </ac:picMkLst>
        </pc:picChg>
        <pc:picChg chg="add del mod">
          <ac:chgData name="Anamthathmakula, Prashanth" userId="acd106aa-3bb0-4d16-b474-a7fd34266ac2" providerId="ADAL" clId="{10DA3185-4380-47B5-9023-1D6E59B6E928}" dt="2023-07-19T19:07:41.899" v="16" actId="478"/>
          <ac:picMkLst>
            <pc:docMk/>
            <pc:sldMk cId="3468106434" sldId="269"/>
            <ac:picMk id="3" creationId="{575D6781-C8A3-8589-96FE-749943D24984}"/>
          </ac:picMkLst>
        </pc:picChg>
      </pc:sldChg>
    </pc:docChg>
  </pc:docChgLst>
  <pc:docChgLst>
    <pc:chgData name="Anamthathmakula, Prashanth" userId="acd106aa-3bb0-4d16-b474-a7fd34266ac2" providerId="ADAL" clId="{346B8B87-B430-4586-A5C3-723A960978A6}"/>
    <pc:docChg chg="undo redo custSel addSld delSld modSld">
      <pc:chgData name="Anamthathmakula, Prashanth" userId="acd106aa-3bb0-4d16-b474-a7fd34266ac2" providerId="ADAL" clId="{346B8B87-B430-4586-A5C3-723A960978A6}" dt="2023-07-24T00:28:26.516" v="184" actId="164"/>
      <pc:docMkLst>
        <pc:docMk/>
      </pc:docMkLst>
      <pc:sldChg chg="del">
        <pc:chgData name="Anamthathmakula, Prashanth" userId="acd106aa-3bb0-4d16-b474-a7fd34266ac2" providerId="ADAL" clId="{346B8B87-B430-4586-A5C3-723A960978A6}" dt="2023-07-24T00:27:25.721" v="180" actId="47"/>
        <pc:sldMkLst>
          <pc:docMk/>
          <pc:sldMk cId="3468106434" sldId="269"/>
        </pc:sldMkLst>
      </pc:sldChg>
      <pc:sldChg chg="addSp delSp modSp add mod">
        <pc:chgData name="Anamthathmakula, Prashanth" userId="acd106aa-3bb0-4d16-b474-a7fd34266ac2" providerId="ADAL" clId="{346B8B87-B430-4586-A5C3-723A960978A6}" dt="2023-07-24T00:28:26.516" v="184" actId="164"/>
        <pc:sldMkLst>
          <pc:docMk/>
          <pc:sldMk cId="3357358326" sldId="270"/>
        </pc:sldMkLst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3" creationId="{FF66B33E-FFD9-B10B-B198-E013648FAFE6}"/>
          </ac:spMkLst>
        </pc:spChg>
        <pc:spChg chg="del mod">
          <ac:chgData name="Anamthathmakula, Prashanth" userId="acd106aa-3bb0-4d16-b474-a7fd34266ac2" providerId="ADAL" clId="{346B8B87-B430-4586-A5C3-723A960978A6}" dt="2023-07-24T00:25:43" v="149" actId="478"/>
          <ac:spMkLst>
            <pc:docMk/>
            <pc:sldMk cId="3357358326" sldId="270"/>
            <ac:spMk id="9" creationId="{3F269B5F-C585-68F1-4DA7-9CD232788BE4}"/>
          </ac:spMkLst>
        </pc:spChg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0" creationId="{A38DE466-03F6-C024-B063-17258D27A3F8}"/>
          </ac:spMkLst>
        </pc:spChg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1" creationId="{D9C160CF-AB73-F964-9EA7-EF240EB8FA30}"/>
          </ac:spMkLst>
        </pc:spChg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2" creationId="{915FAD08-B46E-0BFF-A10C-9BC065F5AB90}"/>
          </ac:spMkLst>
        </pc:spChg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3" creationId="{4F3BC1EA-1035-6786-3AC6-830DF99FCF72}"/>
          </ac:spMkLst>
        </pc:spChg>
        <pc:spChg chg="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4" creationId="{19B4A816-862B-262A-1E12-0D7BBF1158F9}"/>
          </ac:spMkLst>
        </pc:spChg>
        <pc:spChg chg="add mod">
          <ac:chgData name="Anamthathmakula, Prashanth" userId="acd106aa-3bb0-4d16-b474-a7fd34266ac2" providerId="ADAL" clId="{346B8B87-B430-4586-A5C3-723A960978A6}" dt="2023-07-24T00:28:26.516" v="184" actId="164"/>
          <ac:spMkLst>
            <pc:docMk/>
            <pc:sldMk cId="3357358326" sldId="270"/>
            <ac:spMk id="16" creationId="{4E229A47-EB7C-5D02-69D3-B68E7B14E7E0}"/>
          </ac:spMkLst>
        </pc:spChg>
        <pc:grpChg chg="add mod">
          <ac:chgData name="Anamthathmakula, Prashanth" userId="acd106aa-3bb0-4d16-b474-a7fd34266ac2" providerId="ADAL" clId="{346B8B87-B430-4586-A5C3-723A960978A6}" dt="2023-07-24T00:28:26.516" v="184" actId="164"/>
          <ac:grpSpMkLst>
            <pc:docMk/>
            <pc:sldMk cId="3357358326" sldId="270"/>
            <ac:grpSpMk id="2" creationId="{5545DA55-2DFF-3B3C-32BD-759B576EDF37}"/>
          </ac:grpSpMkLst>
        </pc:grpChg>
        <pc:picChg chg="add mod">
          <ac:chgData name="Anamthathmakula, Prashanth" userId="acd106aa-3bb0-4d16-b474-a7fd34266ac2" providerId="ADAL" clId="{346B8B87-B430-4586-A5C3-723A960978A6}" dt="2023-07-24T00:18:23.114" v="61"/>
          <ac:picMkLst>
            <pc:docMk/>
            <pc:sldMk cId="3357358326" sldId="270"/>
            <ac:picMk id="2" creationId="{7D0DA706-A863-09B7-12BD-FEAD6AC081FB}"/>
          </ac:picMkLst>
        </pc:picChg>
        <pc:picChg chg="add del mod">
          <ac:chgData name="Anamthathmakula, Prashanth" userId="acd106aa-3bb0-4d16-b474-a7fd34266ac2" providerId="ADAL" clId="{346B8B87-B430-4586-A5C3-723A960978A6}" dt="2023-07-24T00:24:15.784" v="119" actId="478"/>
          <ac:picMkLst>
            <pc:docMk/>
            <pc:sldMk cId="3357358326" sldId="270"/>
            <ac:picMk id="4" creationId="{E249463C-3FE4-55C2-AA78-34FB6B3D9B03}"/>
          </ac:picMkLst>
        </pc:picChg>
        <pc:picChg chg="add del mod">
          <ac:chgData name="Anamthathmakula, Prashanth" userId="acd106aa-3bb0-4d16-b474-a7fd34266ac2" providerId="ADAL" clId="{346B8B87-B430-4586-A5C3-723A960978A6}" dt="2023-07-24T00:24:48.876" v="124" actId="21"/>
          <ac:picMkLst>
            <pc:docMk/>
            <pc:sldMk cId="3357358326" sldId="270"/>
            <ac:picMk id="5" creationId="{5E33039D-EA3E-A43B-C432-17E22F2DD3EE}"/>
          </ac:picMkLst>
        </pc:picChg>
        <pc:picChg chg="add del mod">
          <ac:chgData name="Anamthathmakula, Prashanth" userId="acd106aa-3bb0-4d16-b474-a7fd34266ac2" providerId="ADAL" clId="{346B8B87-B430-4586-A5C3-723A960978A6}" dt="2023-07-24T00:24:52.759" v="125" actId="478"/>
          <ac:picMkLst>
            <pc:docMk/>
            <pc:sldMk cId="3357358326" sldId="270"/>
            <ac:picMk id="6" creationId="{669FEE05-68C1-A1B8-2FE1-134F09895C7F}"/>
          </ac:picMkLst>
        </pc:picChg>
        <pc:picChg chg="add del mod">
          <ac:chgData name="Anamthathmakula, Prashanth" userId="acd106aa-3bb0-4d16-b474-a7fd34266ac2" providerId="ADAL" clId="{346B8B87-B430-4586-A5C3-723A960978A6}" dt="2023-07-24T00:24:53.903" v="126" actId="478"/>
          <ac:picMkLst>
            <pc:docMk/>
            <pc:sldMk cId="3357358326" sldId="270"/>
            <ac:picMk id="7" creationId="{85879661-866B-6C5C-8233-60C61427F28F}"/>
          </ac:picMkLst>
        </pc:picChg>
        <pc:picChg chg="add del mod">
          <ac:chgData name="Anamthathmakula, Prashanth" userId="acd106aa-3bb0-4d16-b474-a7fd34266ac2" providerId="ADAL" clId="{346B8B87-B430-4586-A5C3-723A960978A6}" dt="2023-07-24T00:24:54.703" v="127" actId="478"/>
          <ac:picMkLst>
            <pc:docMk/>
            <pc:sldMk cId="3357358326" sldId="270"/>
            <ac:picMk id="8" creationId="{50A636FF-7D31-04E7-AC62-F3D74E395C88}"/>
          </ac:picMkLst>
        </pc:picChg>
        <pc:picChg chg="add mod">
          <ac:chgData name="Anamthathmakula, Prashanth" userId="acd106aa-3bb0-4d16-b474-a7fd34266ac2" providerId="ADAL" clId="{346B8B87-B430-4586-A5C3-723A960978A6}" dt="2023-07-24T00:28:26.516" v="184" actId="164"/>
          <ac:picMkLst>
            <pc:docMk/>
            <pc:sldMk cId="3357358326" sldId="270"/>
            <ac:picMk id="15" creationId="{969DFF7A-33A4-0AEB-DD43-EF502A457B6C}"/>
          </ac:picMkLst>
        </pc:picChg>
      </pc:sldChg>
      <pc:sldChg chg="addSp delSp modSp new del mod">
        <pc:chgData name="Anamthathmakula, Prashanth" userId="acd106aa-3bb0-4d16-b474-a7fd34266ac2" providerId="ADAL" clId="{346B8B87-B430-4586-A5C3-723A960978A6}" dt="2023-07-24T00:27:26.942" v="181" actId="47"/>
        <pc:sldMkLst>
          <pc:docMk/>
          <pc:sldMk cId="4224793522" sldId="271"/>
        </pc:sldMkLst>
        <pc:spChg chg="del">
          <ac:chgData name="Anamthathmakula, Prashanth" userId="acd106aa-3bb0-4d16-b474-a7fd34266ac2" providerId="ADAL" clId="{346B8B87-B430-4586-A5C3-723A960978A6}" dt="2023-07-24T00:18:37.272" v="66" actId="478"/>
          <ac:spMkLst>
            <pc:docMk/>
            <pc:sldMk cId="4224793522" sldId="271"/>
            <ac:spMk id="2" creationId="{E33DFACB-B60E-8785-0260-3C2A5DBF92F5}"/>
          </ac:spMkLst>
        </pc:spChg>
        <pc:spChg chg="del">
          <ac:chgData name="Anamthathmakula, Prashanth" userId="acd106aa-3bb0-4d16-b474-a7fd34266ac2" providerId="ADAL" clId="{346B8B87-B430-4586-A5C3-723A960978A6}" dt="2023-07-24T00:18:37.272" v="66" actId="478"/>
          <ac:spMkLst>
            <pc:docMk/>
            <pc:sldMk cId="4224793522" sldId="271"/>
            <ac:spMk id="3" creationId="{99FECE6B-0659-F7A0-302D-65DEEBE74D61}"/>
          </ac:spMkLst>
        </pc:spChg>
        <pc:grpChg chg="add del mod">
          <ac:chgData name="Anamthathmakula, Prashanth" userId="acd106aa-3bb0-4d16-b474-a7fd34266ac2" providerId="ADAL" clId="{346B8B87-B430-4586-A5C3-723A960978A6}" dt="2023-07-24T00:20:45.713" v="74" actId="165"/>
          <ac:grpSpMkLst>
            <pc:docMk/>
            <pc:sldMk cId="4224793522" sldId="271"/>
            <ac:grpSpMk id="5" creationId="{7B3C1CE1-B36B-F522-76E5-DD4A5B9F96A2}"/>
          </ac:grpSpMkLst>
        </pc:grpChg>
        <pc:grpChg chg="del mod topLvl">
          <ac:chgData name="Anamthathmakula, Prashanth" userId="acd106aa-3bb0-4d16-b474-a7fd34266ac2" providerId="ADAL" clId="{346B8B87-B430-4586-A5C3-723A960978A6}" dt="2023-07-24T00:20:52.583" v="75" actId="165"/>
          <ac:grpSpMkLst>
            <pc:docMk/>
            <pc:sldMk cId="4224793522" sldId="271"/>
            <ac:grpSpMk id="6" creationId="{9892B815-BE26-EACC-C957-BEE072D26505}"/>
          </ac:grpSpMkLst>
        </pc:grpChg>
        <pc:picChg chg="add del mod">
          <ac:chgData name="Anamthathmakula, Prashanth" userId="acd106aa-3bb0-4d16-b474-a7fd34266ac2" providerId="ADAL" clId="{346B8B87-B430-4586-A5C3-723A960978A6}" dt="2023-07-24T00:18:42.202" v="68" actId="478"/>
          <ac:picMkLst>
            <pc:docMk/>
            <pc:sldMk cId="4224793522" sldId="271"/>
            <ac:picMk id="4" creationId="{7D0DA706-A863-09B7-12BD-FEAD6AC081FB}"/>
          </ac:picMkLst>
        </pc:picChg>
        <pc:picChg chg="mod topLvl">
          <ac:chgData name="Anamthathmakula, Prashanth" userId="acd106aa-3bb0-4d16-b474-a7fd34266ac2" providerId="ADAL" clId="{346B8B87-B430-4586-A5C3-723A960978A6}" dt="2023-07-24T00:20:52.583" v="75" actId="165"/>
          <ac:picMkLst>
            <pc:docMk/>
            <pc:sldMk cId="4224793522" sldId="271"/>
            <ac:picMk id="10" creationId="{A3356784-D9F0-A7E8-E998-F41AF9EAEC95}"/>
          </ac:picMkLst>
        </pc:picChg>
        <pc:picChg chg="mod topLvl">
          <ac:chgData name="Anamthathmakula, Prashanth" userId="acd106aa-3bb0-4d16-b474-a7fd34266ac2" providerId="ADAL" clId="{346B8B87-B430-4586-A5C3-723A960978A6}" dt="2023-07-24T00:21:50.920" v="106" actId="1038"/>
          <ac:picMkLst>
            <pc:docMk/>
            <pc:sldMk cId="4224793522" sldId="271"/>
            <ac:picMk id="11" creationId="{5B94F384-D025-8E7B-EA11-6BB7A3A432AC}"/>
          </ac:picMkLst>
        </pc:picChg>
        <pc:picChg chg="mod topLvl">
          <ac:chgData name="Anamthathmakula, Prashanth" userId="acd106aa-3bb0-4d16-b474-a7fd34266ac2" providerId="ADAL" clId="{346B8B87-B430-4586-A5C3-723A960978A6}" dt="2023-07-24T00:21:44.882" v="100" actId="1037"/>
          <ac:picMkLst>
            <pc:docMk/>
            <pc:sldMk cId="4224793522" sldId="271"/>
            <ac:picMk id="12" creationId="{3CACFD7F-9287-1FAC-656A-7625BD65C136}"/>
          </ac:picMkLst>
        </pc:picChg>
        <pc:cxnChg chg="mod topLvl">
          <ac:chgData name="Anamthathmakula, Prashanth" userId="acd106aa-3bb0-4d16-b474-a7fd34266ac2" providerId="ADAL" clId="{346B8B87-B430-4586-A5C3-723A960978A6}" dt="2023-07-24T00:21:44.882" v="100" actId="1037"/>
          <ac:cxnSpMkLst>
            <pc:docMk/>
            <pc:sldMk cId="4224793522" sldId="271"/>
            <ac:cxnSpMk id="7" creationId="{53824C79-D0CC-B285-4A17-EB0503A356D0}"/>
          </ac:cxnSpMkLst>
        </pc:cxnChg>
        <pc:cxnChg chg="mod topLvl">
          <ac:chgData name="Anamthathmakula, Prashanth" userId="acd106aa-3bb0-4d16-b474-a7fd34266ac2" providerId="ADAL" clId="{346B8B87-B430-4586-A5C3-723A960978A6}" dt="2023-07-24T00:20:45.713" v="74" actId="165"/>
          <ac:cxnSpMkLst>
            <pc:docMk/>
            <pc:sldMk cId="4224793522" sldId="271"/>
            <ac:cxnSpMk id="8" creationId="{448D1488-A995-8141-D1CD-F859C154486A}"/>
          </ac:cxnSpMkLst>
        </pc:cxnChg>
        <pc:cxnChg chg="mod topLvl">
          <ac:chgData name="Anamthathmakula, Prashanth" userId="acd106aa-3bb0-4d16-b474-a7fd34266ac2" providerId="ADAL" clId="{346B8B87-B430-4586-A5C3-723A960978A6}" dt="2023-07-24T00:21:50.920" v="106" actId="1038"/>
          <ac:cxnSpMkLst>
            <pc:docMk/>
            <pc:sldMk cId="4224793522" sldId="271"/>
            <ac:cxnSpMk id="9" creationId="{461C62F8-19BD-47D2-28AB-2D8EA0378560}"/>
          </ac:cxnSpMkLst>
        </pc:cxnChg>
      </pc:sldChg>
      <pc:sldChg chg="addSp delSp modSp add del mod">
        <pc:chgData name="Anamthathmakula, Prashanth" userId="acd106aa-3bb0-4d16-b474-a7fd34266ac2" providerId="ADAL" clId="{346B8B87-B430-4586-A5C3-723A960978A6}" dt="2023-07-24T00:27:30.278" v="183" actId="47"/>
        <pc:sldMkLst>
          <pc:docMk/>
          <pc:sldMk cId="2416007455" sldId="272"/>
        </pc:sldMkLst>
        <pc:grpChg chg="del">
          <ac:chgData name="Anamthathmakula, Prashanth" userId="acd106aa-3bb0-4d16-b474-a7fd34266ac2" providerId="ADAL" clId="{346B8B87-B430-4586-A5C3-723A960978A6}" dt="2023-07-24T00:22:10.580" v="107" actId="478"/>
          <ac:grpSpMkLst>
            <pc:docMk/>
            <pc:sldMk cId="2416007455" sldId="272"/>
            <ac:grpSpMk id="5" creationId="{7B3C1CE1-B36B-F522-76E5-DD4A5B9F96A2}"/>
          </ac:grpSpMkLst>
        </pc:grpChg>
        <pc:picChg chg="add mod">
          <ac:chgData name="Anamthathmakula, Prashanth" userId="acd106aa-3bb0-4d16-b474-a7fd34266ac2" providerId="ADAL" clId="{346B8B87-B430-4586-A5C3-723A960978A6}" dt="2023-07-24T00:24:09.159" v="118" actId="1076"/>
          <ac:picMkLst>
            <pc:docMk/>
            <pc:sldMk cId="2416007455" sldId="272"/>
            <ac:picMk id="2" creationId="{F25E83E2-F754-C09A-2E59-327672821CEF}"/>
          </ac:picMkLst>
        </pc:picChg>
      </pc:sldChg>
      <pc:sldChg chg="add del">
        <pc:chgData name="Anamthathmakula, Prashanth" userId="acd106aa-3bb0-4d16-b474-a7fd34266ac2" providerId="ADAL" clId="{346B8B87-B430-4586-A5C3-723A960978A6}" dt="2023-07-24T00:27:29.257" v="182" actId="47"/>
        <pc:sldMkLst>
          <pc:docMk/>
          <pc:sldMk cId="4250231883" sldId="273"/>
        </pc:sldMkLst>
      </pc:sldChg>
    </pc:docChg>
  </pc:docChgLst>
  <pc:docChgLst>
    <pc:chgData name="Anamthathmakula, Prashanth" userId="acd106aa-3bb0-4d16-b474-a7fd34266ac2" providerId="ADAL" clId="{29ACA051-CDBB-48DB-810A-B4C4A2ACC89F}"/>
    <pc:docChg chg="custSel modSld">
      <pc:chgData name="Anamthathmakula, Prashanth" userId="acd106aa-3bb0-4d16-b474-a7fd34266ac2" providerId="ADAL" clId="{29ACA051-CDBB-48DB-810A-B4C4A2ACC89F}" dt="2023-07-20T15:29:33.084" v="74" actId="20577"/>
      <pc:docMkLst>
        <pc:docMk/>
      </pc:docMkLst>
      <pc:sldChg chg="addSp delSp modSp mod">
        <pc:chgData name="Anamthathmakula, Prashanth" userId="acd106aa-3bb0-4d16-b474-a7fd34266ac2" providerId="ADAL" clId="{29ACA051-CDBB-48DB-810A-B4C4A2ACC89F}" dt="2023-07-20T15:29:33.084" v="74" actId="20577"/>
        <pc:sldMkLst>
          <pc:docMk/>
          <pc:sldMk cId="3468106434" sldId="269"/>
        </pc:sldMkLst>
        <pc:spChg chg="add mod">
          <ac:chgData name="Anamthathmakula, Prashanth" userId="acd106aa-3bb0-4d16-b474-a7fd34266ac2" providerId="ADAL" clId="{29ACA051-CDBB-48DB-810A-B4C4A2ACC89F}" dt="2023-07-20T15:29:33.084" v="74" actId="20577"/>
          <ac:spMkLst>
            <pc:docMk/>
            <pc:sldMk cId="3468106434" sldId="269"/>
            <ac:spMk id="3" creationId="{FF66B33E-FFD9-B10B-B198-E013648FAFE6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9" creationId="{3F269B5F-C585-68F1-4DA7-9CD232788BE4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10" creationId="{A38DE466-03F6-C024-B063-17258D27A3F8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11" creationId="{D9C160CF-AB73-F964-9EA7-EF240EB8FA30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12" creationId="{915FAD08-B46E-0BFF-A10C-9BC065F5AB90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13" creationId="{4F3BC1EA-1035-6786-3AC6-830DF99FCF72}"/>
          </ac:spMkLst>
        </pc:spChg>
        <pc:spChg chg="mod">
          <ac:chgData name="Anamthathmakula, Prashanth" userId="acd106aa-3bb0-4d16-b474-a7fd34266ac2" providerId="ADAL" clId="{29ACA051-CDBB-48DB-810A-B4C4A2ACC89F}" dt="2023-07-20T15:28:43.114" v="45" actId="1037"/>
          <ac:spMkLst>
            <pc:docMk/>
            <pc:sldMk cId="3468106434" sldId="269"/>
            <ac:spMk id="14" creationId="{19B4A816-862B-262A-1E12-0D7BBF1158F9}"/>
          </ac:spMkLst>
        </pc:spChg>
        <pc:spChg chg="del">
          <ac:chgData name="Anamthathmakula, Prashanth" userId="acd106aa-3bb0-4d16-b474-a7fd34266ac2" providerId="ADAL" clId="{29ACA051-CDBB-48DB-810A-B4C4A2ACC89F}" dt="2023-07-19T23:40:32.936" v="0" actId="478"/>
          <ac:spMkLst>
            <pc:docMk/>
            <pc:sldMk cId="3468106434" sldId="269"/>
            <ac:spMk id="17" creationId="{8726A9C5-3B60-E86F-D876-F36805179BA2}"/>
          </ac:spMkLst>
        </pc:spChg>
        <pc:spChg chg="del">
          <ac:chgData name="Anamthathmakula, Prashanth" userId="acd106aa-3bb0-4d16-b474-a7fd34266ac2" providerId="ADAL" clId="{29ACA051-CDBB-48DB-810A-B4C4A2ACC89F}" dt="2023-07-19T23:40:32.936" v="0" actId="478"/>
          <ac:spMkLst>
            <pc:docMk/>
            <pc:sldMk cId="3468106434" sldId="269"/>
            <ac:spMk id="18" creationId="{308EA9E2-544C-B5AA-8C0F-B87AD48B3204}"/>
          </ac:spMkLst>
        </pc:spChg>
        <pc:spChg chg="del">
          <ac:chgData name="Anamthathmakula, Prashanth" userId="acd106aa-3bb0-4d16-b474-a7fd34266ac2" providerId="ADAL" clId="{29ACA051-CDBB-48DB-810A-B4C4A2ACC89F}" dt="2023-07-19T23:40:32.936" v="0" actId="478"/>
          <ac:spMkLst>
            <pc:docMk/>
            <pc:sldMk cId="3468106434" sldId="269"/>
            <ac:spMk id="19" creationId="{89A1E381-E72D-DA1C-DB02-CC245893D8CB}"/>
          </ac:spMkLst>
        </pc:spChg>
        <pc:picChg chg="mod">
          <ac:chgData name="Anamthathmakula, Prashanth" userId="acd106aa-3bb0-4d16-b474-a7fd34266ac2" providerId="ADAL" clId="{29ACA051-CDBB-48DB-810A-B4C4A2ACC89F}" dt="2023-07-20T15:28:43.114" v="45" actId="1037"/>
          <ac:picMkLst>
            <pc:docMk/>
            <pc:sldMk cId="3468106434" sldId="269"/>
            <ac:picMk id="6" creationId="{669FEE05-68C1-A1B8-2FE1-134F09895C7F}"/>
          </ac:picMkLst>
        </pc:picChg>
        <pc:picChg chg="mod">
          <ac:chgData name="Anamthathmakula, Prashanth" userId="acd106aa-3bb0-4d16-b474-a7fd34266ac2" providerId="ADAL" clId="{29ACA051-CDBB-48DB-810A-B4C4A2ACC89F}" dt="2023-07-20T15:28:43.114" v="45" actId="1037"/>
          <ac:picMkLst>
            <pc:docMk/>
            <pc:sldMk cId="3468106434" sldId="269"/>
            <ac:picMk id="7" creationId="{85879661-866B-6C5C-8233-60C61427F28F}"/>
          </ac:picMkLst>
        </pc:picChg>
        <pc:picChg chg="mod">
          <ac:chgData name="Anamthathmakula, Prashanth" userId="acd106aa-3bb0-4d16-b474-a7fd34266ac2" providerId="ADAL" clId="{29ACA051-CDBB-48DB-810A-B4C4A2ACC89F}" dt="2023-07-20T15:28:43.114" v="45" actId="1037"/>
          <ac:picMkLst>
            <pc:docMk/>
            <pc:sldMk cId="3468106434" sldId="269"/>
            <ac:picMk id="8" creationId="{50A636FF-7D31-04E7-AC62-F3D74E395C88}"/>
          </ac:picMkLst>
        </pc:picChg>
      </pc:sldChg>
    </pc:docChg>
  </pc:docChgLst>
  <pc:docChgLst>
    <pc:chgData name="Anamthathmakula, Prashanth" userId="acd106aa-3bb0-4d16-b474-a7fd34266ac2" providerId="ADAL" clId="{3867F18E-84A8-447A-A0C1-AF27F6A2387C}"/>
    <pc:docChg chg="undo custSel addSld delSld modSld">
      <pc:chgData name="Anamthathmakula, Prashanth" userId="acd106aa-3bb0-4d16-b474-a7fd34266ac2" providerId="ADAL" clId="{3867F18E-84A8-447A-A0C1-AF27F6A2387C}" dt="2022-10-09T22:16:53.431" v="462" actId="1038"/>
      <pc:docMkLst>
        <pc:docMk/>
      </pc:docMkLst>
      <pc:sldChg chg="delSp modSp mod">
        <pc:chgData name="Anamthathmakula, Prashanth" userId="acd106aa-3bb0-4d16-b474-a7fd34266ac2" providerId="ADAL" clId="{3867F18E-84A8-447A-A0C1-AF27F6A2387C}" dt="2022-10-09T22:16:53.431" v="462" actId="1038"/>
        <pc:sldMkLst>
          <pc:docMk/>
          <pc:sldMk cId="884979180" sldId="261"/>
        </pc:sldMkLst>
        <pc:spChg chg="mod">
          <ac:chgData name="Anamthathmakula, Prashanth" userId="acd106aa-3bb0-4d16-b474-a7fd34266ac2" providerId="ADAL" clId="{3867F18E-84A8-447A-A0C1-AF27F6A2387C}" dt="2022-10-09T22:16:53.431" v="462" actId="1038"/>
          <ac:spMkLst>
            <pc:docMk/>
            <pc:sldMk cId="884979180" sldId="261"/>
            <ac:spMk id="8" creationId="{4332E976-BB8D-4969-852A-41FFD205C448}"/>
          </ac:spMkLst>
        </pc:spChg>
        <pc:spChg chg="del">
          <ac:chgData name="Anamthathmakula, Prashanth" userId="acd106aa-3bb0-4d16-b474-a7fd34266ac2" providerId="ADAL" clId="{3867F18E-84A8-447A-A0C1-AF27F6A2387C}" dt="2022-10-09T22:16:42.011" v="396" actId="478"/>
          <ac:spMkLst>
            <pc:docMk/>
            <pc:sldMk cId="884979180" sldId="261"/>
            <ac:spMk id="9" creationId="{5EE0B266-2382-44E6-83A1-E7AC28BE4368}"/>
          </ac:spMkLst>
        </pc:spChg>
        <pc:graphicFrameChg chg="del">
          <ac:chgData name="Anamthathmakula, Prashanth" userId="acd106aa-3bb0-4d16-b474-a7fd34266ac2" providerId="ADAL" clId="{3867F18E-84A8-447A-A0C1-AF27F6A2387C}" dt="2022-10-09T22:16:38.811" v="395" actId="478"/>
          <ac:graphicFrameMkLst>
            <pc:docMk/>
            <pc:sldMk cId="884979180" sldId="261"/>
            <ac:graphicFrameMk id="4" creationId="{9672BCCF-DFCA-45B1-B138-E088386AE658}"/>
          </ac:graphicFrameMkLst>
        </pc:graphicFrameChg>
        <pc:graphicFrameChg chg="mod">
          <ac:chgData name="Anamthathmakula, Prashanth" userId="acd106aa-3bb0-4d16-b474-a7fd34266ac2" providerId="ADAL" clId="{3867F18E-84A8-447A-A0C1-AF27F6A2387C}" dt="2022-10-09T22:16:53.431" v="462" actId="1038"/>
          <ac:graphicFrameMkLst>
            <pc:docMk/>
            <pc:sldMk cId="884979180" sldId="261"/>
            <ac:graphicFrameMk id="13" creationId="{C240872B-0DA7-49D3-BF01-CEA0E73000D3}"/>
          </ac:graphicFrameMkLst>
        </pc:graphicFrameChg>
      </pc:sldChg>
      <pc:sldChg chg="del modNotesTx">
        <pc:chgData name="Anamthathmakula, Prashanth" userId="acd106aa-3bb0-4d16-b474-a7fd34266ac2" providerId="ADAL" clId="{3867F18E-84A8-447A-A0C1-AF27F6A2387C}" dt="2022-10-09T22:16:33.556" v="394" actId="47"/>
        <pc:sldMkLst>
          <pc:docMk/>
          <pc:sldMk cId="3051900559" sldId="265"/>
        </pc:sldMkLst>
      </pc:sldChg>
      <pc:sldChg chg="addSp delSp modSp add mod">
        <pc:chgData name="Anamthathmakula, Prashanth" userId="acd106aa-3bb0-4d16-b474-a7fd34266ac2" providerId="ADAL" clId="{3867F18E-84A8-447A-A0C1-AF27F6A2387C}" dt="2022-10-09T22:16:13.965" v="392" actId="20577"/>
        <pc:sldMkLst>
          <pc:docMk/>
          <pc:sldMk cId="3929210527" sldId="268"/>
        </pc:sldMkLst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7" creationId="{CFC4095F-154E-4A31-8C0A-06C6B2C345F1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8" creationId="{F88F143E-2EE9-4F88-8617-89A2FF291879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9" creationId="{76CDA92A-B237-4591-9F96-CCCEDDBFEBB6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13" creationId="{396301ED-A594-4467-8323-41AC71FF3DFD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14" creationId="{EE435A3B-49F3-4E6C-963F-8977F38A0380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16" creationId="{71890582-6B6F-48F3-A3BA-3C9DE85FC78D}"/>
          </ac:spMkLst>
        </pc:spChg>
        <pc:spChg chg="add del mod">
          <ac:chgData name="Anamthathmakula, Prashanth" userId="acd106aa-3bb0-4d16-b474-a7fd34266ac2" providerId="ADAL" clId="{3867F18E-84A8-447A-A0C1-AF27F6A2387C}" dt="2022-10-09T22:14:25.991" v="316" actId="164"/>
          <ac:spMkLst>
            <pc:docMk/>
            <pc:sldMk cId="3929210527" sldId="268"/>
            <ac:spMk id="19" creationId="{560CBCCC-AB50-4BB3-B649-9D2C6A5049C0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2" creationId="{E6EA9471-F0CA-4C21-8216-CEE742A81AE0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3" creationId="{65501241-8CC2-469E-AB04-6245B1A6467C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4" creationId="{131B05CD-D154-47C9-8D2C-1B85AE731DA7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5" creationId="{F3D3C6C9-F900-4120-A3FB-9888F0D07E47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6" creationId="{BBAEB2D3-A9EB-4DFC-AB50-99880E0EBA59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7" creationId="{82D7C655-6403-421F-933B-8AD954523ED3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8" creationId="{E6F58E0D-835D-4DF4-AA93-A54520E463C1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29" creationId="{3720C92C-706F-4F98-B45F-49CF33EC0228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2" creationId="{CAC5F763-F4B2-4C83-8BEC-D7AD903129F1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3" creationId="{9F4F1F89-32AC-4443-9511-A0223CCDF763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4" creationId="{19A72D14-0D74-4D87-9561-2A268F995FAF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5" creationId="{EA183168-91A1-4AA4-BA87-3F9B81B8DA67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6" creationId="{03FC4638-BF9F-4144-903F-B359B57B2FF6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7" creationId="{1D2523B1-E078-4535-8F70-44B3E30A9C1D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38" creationId="{5BED18E9-6969-48D6-B152-D7A0C65352BB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40" creationId="{DA9CB754-60B2-49BD-8969-E9B803DDAE5E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41" creationId="{81B136A2-0677-4BB7-A289-9B9EBF7E19BC}"/>
          </ac:spMkLst>
        </pc:spChg>
        <pc:spChg chg="mod topLvl">
          <ac:chgData name="Anamthathmakula, Prashanth" userId="acd106aa-3bb0-4d16-b474-a7fd34266ac2" providerId="ADAL" clId="{3867F18E-84A8-447A-A0C1-AF27F6A2387C}" dt="2022-10-09T22:11:53.396" v="234" actId="164"/>
          <ac:spMkLst>
            <pc:docMk/>
            <pc:sldMk cId="3929210527" sldId="268"/>
            <ac:spMk id="43" creationId="{CC585326-8179-4686-986A-2C66C0A20BF5}"/>
          </ac:spMkLst>
        </pc:spChg>
        <pc:spChg chg="mod">
          <ac:chgData name="Anamthathmakula, Prashanth" userId="acd106aa-3bb0-4d16-b474-a7fd34266ac2" providerId="ADAL" clId="{3867F18E-84A8-447A-A0C1-AF27F6A2387C}" dt="2022-10-09T22:07:03.201" v="21" actId="1076"/>
          <ac:spMkLst>
            <pc:docMk/>
            <pc:sldMk cId="3929210527" sldId="268"/>
            <ac:spMk id="44" creationId="{338D29B4-02E2-4D20-A731-4A2684B40490}"/>
          </ac:spMkLst>
        </pc:spChg>
        <pc:spChg chg="mod">
          <ac:chgData name="Anamthathmakula, Prashanth" userId="acd106aa-3bb0-4d16-b474-a7fd34266ac2" providerId="ADAL" clId="{3867F18E-84A8-447A-A0C1-AF27F6A2387C}" dt="2022-10-09T22:07:13.725" v="57" actId="1036"/>
          <ac:spMkLst>
            <pc:docMk/>
            <pc:sldMk cId="3929210527" sldId="268"/>
            <ac:spMk id="45" creationId="{A455588E-6894-402B-95FB-0A33A6356546}"/>
          </ac:spMkLst>
        </pc:spChg>
        <pc:spChg chg="mod">
          <ac:chgData name="Anamthathmakula, Prashanth" userId="acd106aa-3bb0-4d16-b474-a7fd34266ac2" providerId="ADAL" clId="{3867F18E-84A8-447A-A0C1-AF27F6A2387C}" dt="2022-10-09T22:12:27.286" v="257" actId="1036"/>
          <ac:spMkLst>
            <pc:docMk/>
            <pc:sldMk cId="3929210527" sldId="268"/>
            <ac:spMk id="46" creationId="{C78A37DB-D90C-45F2-A79A-9DB335D7E916}"/>
          </ac:spMkLst>
        </pc:spChg>
        <pc:spChg chg="add mod">
          <ac:chgData name="Anamthathmakula, Prashanth" userId="acd106aa-3bb0-4d16-b474-a7fd34266ac2" providerId="ADAL" clId="{3867F18E-84A8-447A-A0C1-AF27F6A2387C}" dt="2022-10-09T22:15:33.611" v="335" actId="1076"/>
          <ac:spMkLst>
            <pc:docMk/>
            <pc:sldMk cId="3929210527" sldId="268"/>
            <ac:spMk id="47" creationId="{179A083B-D490-F2EE-0E1C-2920830DD9C9}"/>
          </ac:spMkLst>
        </pc:spChg>
        <pc:spChg chg="del mod">
          <ac:chgData name="Anamthathmakula, Prashanth" userId="acd106aa-3bb0-4d16-b474-a7fd34266ac2" providerId="ADAL" clId="{3867F18E-84A8-447A-A0C1-AF27F6A2387C}" dt="2022-10-09T22:07:26.860" v="60" actId="21"/>
          <ac:spMkLst>
            <pc:docMk/>
            <pc:sldMk cId="3929210527" sldId="268"/>
            <ac:spMk id="50" creationId="{84469AD4-9C55-4B5E-9176-749D1FD8EFD0}"/>
          </ac:spMkLst>
        </pc:spChg>
        <pc:spChg chg="add mod">
          <ac:chgData name="Anamthathmakula, Prashanth" userId="acd106aa-3bb0-4d16-b474-a7fd34266ac2" providerId="ADAL" clId="{3867F18E-84A8-447A-A0C1-AF27F6A2387C}" dt="2022-10-09T22:16:13.965" v="392" actId="20577"/>
          <ac:spMkLst>
            <pc:docMk/>
            <pc:sldMk cId="3929210527" sldId="268"/>
            <ac:spMk id="56" creationId="{83B56505-EE6B-14B8-77C6-740E9EA32B71}"/>
          </ac:spMkLst>
        </pc:spChg>
        <pc:grpChg chg="add mod">
          <ac:chgData name="Anamthathmakula, Prashanth" userId="acd106aa-3bb0-4d16-b474-a7fd34266ac2" providerId="ADAL" clId="{3867F18E-84A8-447A-A0C1-AF27F6A2387C}" dt="2022-10-09T22:12:21.957" v="251" actId="1035"/>
          <ac:grpSpMkLst>
            <pc:docMk/>
            <pc:sldMk cId="3929210527" sldId="268"/>
            <ac:grpSpMk id="2" creationId="{25A88921-E47D-9A12-9D72-9073E1F86408}"/>
          </ac:grpSpMkLst>
        </pc:grpChg>
        <pc:grpChg chg="add mod">
          <ac:chgData name="Anamthathmakula, Prashanth" userId="acd106aa-3bb0-4d16-b474-a7fd34266ac2" providerId="ADAL" clId="{3867F18E-84A8-447A-A0C1-AF27F6A2387C}" dt="2022-10-09T22:14:31.045" v="329" actId="1035"/>
          <ac:grpSpMkLst>
            <pc:docMk/>
            <pc:sldMk cId="3929210527" sldId="268"/>
            <ac:grpSpMk id="4" creationId="{0E27A588-6F07-1F77-0E10-3EAF41606A05}"/>
          </ac:grpSpMkLst>
        </pc:grpChg>
        <pc:grpChg chg="del mod">
          <ac:chgData name="Anamthathmakula, Prashanth" userId="acd106aa-3bb0-4d16-b474-a7fd34266ac2" providerId="ADAL" clId="{3867F18E-84A8-447A-A0C1-AF27F6A2387C}" dt="2022-10-09T22:08:04.394" v="61" actId="165"/>
          <ac:grpSpMkLst>
            <pc:docMk/>
            <pc:sldMk cId="3929210527" sldId="268"/>
            <ac:grpSpMk id="20" creationId="{A1DEF820-A1B9-4511-815B-E5AC8710D3D9}"/>
          </ac:grpSpMkLst>
        </pc:grpChg>
        <pc:graphicFrameChg chg="add del mod">
          <ac:chgData name="Anamthathmakula, Prashanth" userId="acd106aa-3bb0-4d16-b474-a7fd34266ac2" providerId="ADAL" clId="{3867F18E-84A8-447A-A0C1-AF27F6A2387C}" dt="2022-10-09T22:15:24.098" v="334" actId="21"/>
          <ac:graphicFrameMkLst>
            <pc:docMk/>
            <pc:sldMk cId="3929210527" sldId="268"/>
            <ac:graphicFrameMk id="48" creationId="{57D7966F-5231-804E-E340-F6FE7963B2AE}"/>
          </ac:graphicFrameMkLst>
        </pc:graphicFrameChg>
        <pc:graphicFrameChg chg="add mod">
          <ac:chgData name="Anamthathmakula, Prashanth" userId="acd106aa-3bb0-4d16-b474-a7fd34266ac2" providerId="ADAL" clId="{3867F18E-84A8-447A-A0C1-AF27F6A2387C}" dt="2022-10-09T22:15:36.012" v="336"/>
          <ac:graphicFrameMkLst>
            <pc:docMk/>
            <pc:sldMk cId="3929210527" sldId="268"/>
            <ac:graphicFrameMk id="49" creationId="{7C730DE7-339B-AB6D-3279-47FDF972C902}"/>
          </ac:graphicFrameMkLst>
        </pc:graphicFrameChg>
        <pc:graphicFrameChg chg="add mod">
          <ac:chgData name="Anamthathmakula, Prashanth" userId="acd106aa-3bb0-4d16-b474-a7fd34266ac2" providerId="ADAL" clId="{3867F18E-84A8-447A-A0C1-AF27F6A2387C}" dt="2022-10-09T22:16:05.950" v="391" actId="1036"/>
          <ac:graphicFrameMkLst>
            <pc:docMk/>
            <pc:sldMk cId="3929210527" sldId="268"/>
            <ac:graphicFrameMk id="52" creationId="{52F13857-57B4-2839-8ED9-288D23F2F202}"/>
          </ac:graphicFrameMkLst>
        </pc:graphicFrameChg>
        <pc:graphicFrameChg chg="del mod">
          <ac:chgData name="Anamthathmakula, Prashanth" userId="acd106aa-3bb0-4d16-b474-a7fd34266ac2" providerId="ADAL" clId="{3867F18E-84A8-447A-A0C1-AF27F6A2387C}" dt="2022-10-09T22:07:26.860" v="60" actId="21"/>
          <ac:graphicFrameMkLst>
            <pc:docMk/>
            <pc:sldMk cId="3929210527" sldId="268"/>
            <ac:graphicFrameMk id="53" creationId="{EE8F3FFE-935E-43DA-AFCF-3FFB149C3307}"/>
          </ac:graphicFrameMkLst>
        </pc:graphicFrameChg>
        <pc:picChg chg="add del mod">
          <ac:chgData name="Anamthathmakula, Prashanth" userId="acd106aa-3bb0-4d16-b474-a7fd34266ac2" providerId="ADAL" clId="{3867F18E-84A8-447A-A0C1-AF27F6A2387C}" dt="2022-10-09T22:14:25.991" v="316" actId="164"/>
          <ac:picMkLst>
            <pc:docMk/>
            <pc:sldMk cId="3929210527" sldId="268"/>
            <ac:picMk id="5" creationId="{7F2D0A9E-0B82-45BC-B98C-5883A1EE926C}"/>
          </ac:picMkLst>
        </pc:picChg>
        <pc:picChg chg="add del mod">
          <ac:chgData name="Anamthathmakula, Prashanth" userId="acd106aa-3bb0-4d16-b474-a7fd34266ac2" providerId="ADAL" clId="{3867F18E-84A8-447A-A0C1-AF27F6A2387C}" dt="2022-10-09T22:14:25.991" v="316" actId="164"/>
          <ac:picMkLst>
            <pc:docMk/>
            <pc:sldMk cId="3929210527" sldId="268"/>
            <ac:picMk id="11" creationId="{BF45CA3C-7D47-4E60-BD24-DD472DAEF245}"/>
          </ac:picMkLst>
        </pc:picChg>
        <pc:picChg chg="add del mod">
          <ac:chgData name="Anamthathmakula, Prashanth" userId="acd106aa-3bb0-4d16-b474-a7fd34266ac2" providerId="ADAL" clId="{3867F18E-84A8-447A-A0C1-AF27F6A2387C}" dt="2022-10-09T22:14:25.991" v="316" actId="164"/>
          <ac:picMkLst>
            <pc:docMk/>
            <pc:sldMk cId="3929210527" sldId="268"/>
            <ac:picMk id="12" creationId="{F0C5DBB8-0B24-413F-BB78-1E02CFAA843C}"/>
          </ac:picMkLst>
        </pc:picChg>
        <pc:picChg chg="add del mod">
          <ac:chgData name="Anamthathmakula, Prashanth" userId="acd106aa-3bb0-4d16-b474-a7fd34266ac2" providerId="ADAL" clId="{3867F18E-84A8-447A-A0C1-AF27F6A2387C}" dt="2022-10-09T22:14:25.991" v="316" actId="164"/>
          <ac:picMkLst>
            <pc:docMk/>
            <pc:sldMk cId="3929210527" sldId="268"/>
            <ac:picMk id="15" creationId="{FB298194-7AF5-409C-9BBB-40CEA2DDC929}"/>
          </ac:picMkLst>
        </pc:picChg>
        <pc:picChg chg="add del mod">
          <ac:chgData name="Anamthathmakula, Prashanth" userId="acd106aa-3bb0-4d16-b474-a7fd34266ac2" providerId="ADAL" clId="{3867F18E-84A8-447A-A0C1-AF27F6A2387C}" dt="2022-10-09T22:14:25.991" v="316" actId="164"/>
          <ac:picMkLst>
            <pc:docMk/>
            <pc:sldMk cId="3929210527" sldId="268"/>
            <ac:picMk id="51" creationId="{FC5E5DE5-23A0-4CD0-A24D-29C1E8EF1EEA}"/>
          </ac:picMkLst>
        </pc:picChg>
        <pc:cxnChg chg="add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3" creationId="{F9D8128A-DCB5-9A45-4FD3-2A34DAF2ACF3}"/>
          </ac:cxnSpMkLst>
        </pc:cxnChg>
        <pc:cxnChg chg="add del mod">
          <ac:chgData name="Anamthathmakula, Prashanth" userId="acd106aa-3bb0-4d16-b474-a7fd34266ac2" providerId="ADAL" clId="{3867F18E-84A8-447A-A0C1-AF27F6A2387C}" dt="2022-10-09T22:14:51.845" v="331"/>
          <ac:cxnSpMkLst>
            <pc:docMk/>
            <pc:sldMk cId="3929210527" sldId="268"/>
            <ac:cxnSpMk id="6" creationId="{687A2BC3-58C8-1E58-5844-55FD6C6D28C5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10" creationId="{5982FAA1-6E5A-4335-92F3-B61CDF2F894D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17" creationId="{13F262DE-60CA-4A5E-851F-F7027F85F917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18" creationId="{21C66827-BB99-417A-B6A0-168D3ADC1C06}"/>
          </ac:cxnSpMkLst>
        </pc:cxnChg>
        <pc:cxnChg chg="mod topLvl">
          <ac:chgData name="Anamthathmakula, Prashanth" userId="acd106aa-3bb0-4d16-b474-a7fd34266ac2" providerId="ADAL" clId="{3867F18E-84A8-447A-A0C1-AF27F6A2387C}" dt="2022-10-09T22:11:53.396" v="234" actId="164"/>
          <ac:cxnSpMkLst>
            <pc:docMk/>
            <pc:sldMk cId="3929210527" sldId="268"/>
            <ac:cxnSpMk id="21" creationId="{C3660C5F-5C24-4C68-AF11-137AB5CF2347}"/>
          </ac:cxnSpMkLst>
        </pc:cxnChg>
        <pc:cxnChg chg="mod topLvl">
          <ac:chgData name="Anamthathmakula, Prashanth" userId="acd106aa-3bb0-4d16-b474-a7fd34266ac2" providerId="ADAL" clId="{3867F18E-84A8-447A-A0C1-AF27F6A2387C}" dt="2022-10-09T22:11:53.396" v="234" actId="164"/>
          <ac:cxnSpMkLst>
            <pc:docMk/>
            <pc:sldMk cId="3929210527" sldId="268"/>
            <ac:cxnSpMk id="30" creationId="{CBB3ECB2-4D84-4BF6-BAF4-2AD473B26005}"/>
          </ac:cxnSpMkLst>
        </pc:cxnChg>
        <pc:cxnChg chg="mod topLvl">
          <ac:chgData name="Anamthathmakula, Prashanth" userId="acd106aa-3bb0-4d16-b474-a7fd34266ac2" providerId="ADAL" clId="{3867F18E-84A8-447A-A0C1-AF27F6A2387C}" dt="2022-10-09T22:11:53.396" v="234" actId="164"/>
          <ac:cxnSpMkLst>
            <pc:docMk/>
            <pc:sldMk cId="3929210527" sldId="268"/>
            <ac:cxnSpMk id="31" creationId="{CA4DCCC5-5A8E-4004-8E5C-9AEA7A4B6014}"/>
          </ac:cxnSpMkLst>
        </pc:cxnChg>
        <pc:cxnChg chg="mod topLvl">
          <ac:chgData name="Anamthathmakula, Prashanth" userId="acd106aa-3bb0-4d16-b474-a7fd34266ac2" providerId="ADAL" clId="{3867F18E-84A8-447A-A0C1-AF27F6A2387C}" dt="2022-10-09T22:11:53.396" v="234" actId="164"/>
          <ac:cxnSpMkLst>
            <pc:docMk/>
            <pc:sldMk cId="3929210527" sldId="268"/>
            <ac:cxnSpMk id="39" creationId="{44AC762E-8348-4602-82F0-1C0FFF130483}"/>
          </ac:cxnSpMkLst>
        </pc:cxnChg>
        <pc:cxnChg chg="mod topLvl">
          <ac:chgData name="Anamthathmakula, Prashanth" userId="acd106aa-3bb0-4d16-b474-a7fd34266ac2" providerId="ADAL" clId="{3867F18E-84A8-447A-A0C1-AF27F6A2387C}" dt="2022-10-09T22:11:53.396" v="234" actId="164"/>
          <ac:cxnSpMkLst>
            <pc:docMk/>
            <pc:sldMk cId="3929210527" sldId="268"/>
            <ac:cxnSpMk id="42" creationId="{6E27CFFD-2EBA-4193-8B44-D1B5681AFC58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54" creationId="{F3B923A3-20FD-4803-B354-95499013A562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55" creationId="{EC5B6035-9C91-4567-8E2E-384F15FB2E80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63" creationId="{C1D0D351-3A7F-46FB-A68E-016D3C142EBC}"/>
          </ac:cxnSpMkLst>
        </pc:cxnChg>
        <pc:cxnChg chg="add del mod">
          <ac:chgData name="Anamthathmakula, Prashanth" userId="acd106aa-3bb0-4d16-b474-a7fd34266ac2" providerId="ADAL" clId="{3867F18E-84A8-447A-A0C1-AF27F6A2387C}" dt="2022-10-09T22:14:25.991" v="316" actId="164"/>
          <ac:cxnSpMkLst>
            <pc:docMk/>
            <pc:sldMk cId="3929210527" sldId="268"/>
            <ac:cxnSpMk id="64" creationId="{530D4952-86C0-44B9-9780-9802D3E210C0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126A336-65B4-4DFA-9248-B7E443053EC3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942AFB-D66A-4538-A804-6860802121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055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FA09C6-D98A-4304-BBB9-2618A06FA8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CA2688-8EF2-46B5-B58C-DA7DAC741EB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2A1CC7-A003-4DFC-8E1B-65F31591BF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77C691-DDE2-4B68-A066-C1254D2C90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D6AC61-BE90-40D1-81FF-BD640C87F4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666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CEECDA-DA00-4DE7-A280-6D4DD1273B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84A3FA-0A33-4071-851E-7A8F8FA2A2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BB44F1-FA60-419C-85ED-6B34295AF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F73C3-054D-4A9C-80CE-57A1947851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35D291-F1E6-4CA2-BAB6-919F2B5A0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602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1B22F98-159D-41AA-91FC-47E7E2F148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BB32-4A6D-401A-ADED-C2AD7FAE83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4FFC25-D379-4BF1-B213-918033C498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19AEF0-DB34-48B4-9DDC-00EFDCF3DF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145BF-D877-429E-A4F7-E95FAC5851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68993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8B875D-64E0-410D-9987-8F0209A5D3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E552AB-68A9-4F77-93D3-175198BDD94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99043E-054A-4763-AE42-516C36641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69C197-FC94-44DA-8FE3-27D2BB73C0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947088-3190-420F-900B-EFA239494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599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1640D7-4F76-4DE6-90FE-5FE98F0289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579FB71-3971-419E-B3B3-AC101FE402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5EF4CD-AE82-47CD-9B27-406358D125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90A180-53CD-46EC-A4F5-D2B6D9B354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E3E1DE-F95E-496C-A11B-9C538967F0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4220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272364-3744-43C4-BBF0-CFCA73F451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872533-2651-49A7-84F3-05E70A9534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FF3D38E-EF3F-47FF-97CF-C275AE01DB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28A1D4-7BB9-49CC-914C-D89EB7A8E2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AF93B2-47CE-4E86-AEE7-F0E99FD561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154EFF-37E1-464E-AD43-8A8C7102DB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232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3878CD-2AEC-493D-B873-6082FD8F4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678C16-72AF-4F00-AEEA-E78A1CA0F0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A57AA5-21A1-4223-ACDF-F97917E4AC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CDF6675-C5A9-4A43-84E7-A9410AC6DC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529AEC-96D9-4371-BEA6-B698EA772F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EDB747-9892-4671-971A-E96FF6342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B5E9BF-E836-4270-B79A-F056006E8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4A892ED-5AF5-4BDA-95EF-AB95E496D9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8352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A5DB05-80C1-43C0-BF23-3EB86CDFBF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7C03269-966D-4D65-972D-28783894E7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05FBDCE-899A-42E7-9017-0675451CC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878385-9254-4D32-9B90-CE2968440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7380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8C72DCC-346E-4B2E-B010-E50F2C7AE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9B3161B-A9B2-4575-A6E5-ACE63F7C25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7E736C-7A06-4B67-B4E4-31EC874FA6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01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14B85-BE05-4AC1-A096-CB66C7ED4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DB9BE2-867A-4C78-B408-AAAF9CA345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3DE7F7-DF8C-457F-B0F8-40F4FCB068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F2C3DC-0589-4210-9543-5B23D17C0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B15308-150C-44BA-AF05-63D0DE0C54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CEA65D-06F9-46CA-A039-21F7737123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249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B4D9C-E075-41AE-8A47-FA426AE8B6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475469A-FB0F-4B9A-9295-4A2E7CB1D0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4F0C28-3665-400A-B483-023C3FB4A7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282FD1A-71E4-43C0-B99B-505945CA98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78F98C-CF1F-4BD6-83C4-4335F65BC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342426-276B-45F5-900D-DE77DE012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4624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CC7CC18-8305-4160-B922-AF49C7759B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C3C7E1D-F786-4385-BFEE-3EC5FDE5DA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885DE3-6B02-41E9-88DF-862CF9331C3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1A0854-39AC-4A57-A2D1-EE15F52C08DB}" type="datetimeFigureOut">
              <a:rPr lang="en-US" smtClean="0"/>
              <a:t>8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C4E1C5-A359-421C-B5C0-8CC0F6F3F0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56FCE3-E2C3-4B84-8F23-ADED889E37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D379B5-9B9A-49AD-AC52-EFF351871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74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545DA55-2DFF-3B3C-32BD-759B576EDF37}"/>
              </a:ext>
            </a:extLst>
          </p:cNvPr>
          <p:cNvGrpSpPr/>
          <p:nvPr/>
        </p:nvGrpSpPr>
        <p:grpSpPr>
          <a:xfrm>
            <a:off x="226031" y="400769"/>
            <a:ext cx="10602931" cy="6000938"/>
            <a:chOff x="226031" y="400769"/>
            <a:chExt cx="10602931" cy="6000938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A38DE466-03F6-C024-B063-17258D27A3F8}"/>
                </a:ext>
              </a:extLst>
            </p:cNvPr>
            <p:cNvSpPr txBox="1"/>
            <p:nvPr/>
          </p:nvSpPr>
          <p:spPr>
            <a:xfrm>
              <a:off x="8287763" y="739627"/>
              <a:ext cx="9856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dTomato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9C160CF-AB73-F964-9EA7-EF240EB8FA30}"/>
                </a:ext>
              </a:extLst>
            </p:cNvPr>
            <p:cNvSpPr txBox="1"/>
            <p:nvPr/>
          </p:nvSpPr>
          <p:spPr>
            <a:xfrm>
              <a:off x="3212387" y="724385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API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15FAD08-B46E-0BFF-A10C-9BC065F5AB90}"/>
                </a:ext>
              </a:extLst>
            </p:cNvPr>
            <p:cNvSpPr txBox="1"/>
            <p:nvPr/>
          </p:nvSpPr>
          <p:spPr>
            <a:xfrm>
              <a:off x="2276648" y="400769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F3BC1EA-1035-6786-3AC6-830DF99FCF72}"/>
                </a:ext>
              </a:extLst>
            </p:cNvPr>
            <p:cNvSpPr txBox="1"/>
            <p:nvPr/>
          </p:nvSpPr>
          <p:spPr>
            <a:xfrm>
              <a:off x="4440339" y="400769"/>
              <a:ext cx="7360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       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9B4A816-862B-262A-1E12-0D7BBF1158F9}"/>
                </a:ext>
              </a:extLst>
            </p:cNvPr>
            <p:cNvSpPr txBox="1"/>
            <p:nvPr/>
          </p:nvSpPr>
          <p:spPr>
            <a:xfrm>
              <a:off x="7395375" y="407654"/>
              <a:ext cx="33214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FF66B33E-FFD9-B10B-B198-E013648FAFE6}"/>
                </a:ext>
              </a:extLst>
            </p:cNvPr>
            <p:cNvSpPr txBox="1"/>
            <p:nvPr/>
          </p:nvSpPr>
          <p:spPr>
            <a:xfrm>
              <a:off x="226031" y="5078268"/>
              <a:ext cx="10602931" cy="132343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1656080" marR="0" algn="just">
                <a:spcBef>
                  <a:spcPts val="600"/>
                </a:spcBef>
                <a:spcAft>
                  <a:spcPts val="1200"/>
                </a:spcAft>
              </a:pPr>
              <a:r>
                <a:rPr lang="en-US" sz="16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upplemental Figure 1. 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Expression of Cre activity in </a:t>
              </a:r>
              <a:r>
                <a:rPr lang="en-US" sz="16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LysMcre;ROSA</a:t>
              </a:r>
              <a:r>
                <a:rPr lang="en-US" sz="1600" baseline="300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T</a:t>
              </a:r>
              <a:r>
                <a:rPr lang="en-US" sz="1600" baseline="300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US" sz="1600" baseline="300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G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transgenic mice in E9.5 placenta.</a:t>
              </a:r>
              <a:r>
                <a:rPr lang="en-US" sz="1600" b="1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Representative magnification images of (A) DAPI, (B) EGFP and (C) </a:t>
              </a:r>
              <a:r>
                <a:rPr lang="en-US" sz="16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tdTomato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fluorescence in </a:t>
              </a:r>
              <a:r>
                <a:rPr lang="en-US" sz="16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LysMcre;ROSA</a:t>
              </a:r>
              <a:r>
                <a:rPr lang="en-US" sz="1600" baseline="300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T</a:t>
              </a:r>
              <a:r>
                <a:rPr lang="en-US" sz="1600" baseline="300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/</a:t>
              </a:r>
              <a:r>
                <a:rPr lang="en-US" sz="1600" baseline="30000" dirty="0" err="1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G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placenta. Cre recombinase activity was assessed via EGFP fluorescence of E9.5 placental cryosections. Highly consistent EGFP expression in the target macrophages at the maternal-fetal interface was observed. Scale bars in images are 100 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  <a:sym typeface="Symbol" panose="05050102010706020507" pitchFamily="18" charset="2"/>
                </a:rPr>
                <a:t></a:t>
              </a:r>
              <a:r>
                <a:rPr lang="en-US" sz="1600" dirty="0">
                  <a:solidFill>
                    <a:srgbClr val="000000"/>
                  </a:solidFill>
                  <a:effectLst/>
                  <a:latin typeface="Palatino Linotype" panose="0204050205050503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. 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69DFF7A-33A4-0AEB-DD43-EF502A457B6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411897" y="1089088"/>
              <a:ext cx="7625930" cy="3749040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E229A47-EB7C-5D02-69D3-B68E7B14E7E0}"/>
                </a:ext>
              </a:extLst>
            </p:cNvPr>
            <p:cNvSpPr txBox="1"/>
            <p:nvPr/>
          </p:nvSpPr>
          <p:spPr>
            <a:xfrm>
              <a:off x="5888071" y="724385"/>
              <a:ext cx="6735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573583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304E5408-EEA7-8848-639A-AC93FEFA629B}"/>
              </a:ext>
            </a:extLst>
          </p:cNvPr>
          <p:cNvGrpSpPr/>
          <p:nvPr/>
        </p:nvGrpSpPr>
        <p:grpSpPr>
          <a:xfrm>
            <a:off x="542488" y="266420"/>
            <a:ext cx="11059487" cy="6325160"/>
            <a:chOff x="542488" y="266420"/>
            <a:chExt cx="11059487" cy="6325160"/>
          </a:xfrm>
        </p:grpSpPr>
        <p:pic>
          <p:nvPicPr>
            <p:cNvPr id="5" name="Picture 4" descr="A collage of images of different types of cells&#10;&#10;Description automatically generated">
              <a:extLst>
                <a:ext uri="{FF2B5EF4-FFF2-40B4-BE49-F238E27FC236}">
                  <a16:creationId xmlns:a16="http://schemas.microsoft.com/office/drawing/2014/main" id="{6A95049A-6F81-55FD-9200-17BD284B79D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00649" y="266420"/>
              <a:ext cx="7641982" cy="3749040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2E255CA-A1A2-1255-C72C-2F5E18C7EF88}"/>
                </a:ext>
              </a:extLst>
            </p:cNvPr>
            <p:cNvSpPr txBox="1"/>
            <p:nvPr/>
          </p:nvSpPr>
          <p:spPr>
            <a:xfrm>
              <a:off x="542488" y="4283256"/>
              <a:ext cx="11059487" cy="230832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algn="just">
                <a:spcBef>
                  <a:spcPts val="0"/>
                </a:spcBef>
                <a:spcAft>
                  <a:spcPts val="800"/>
                </a:spcAft>
              </a:pPr>
              <a:r>
                <a:rPr lang="en-US" sz="1600" b="1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lemental Figure 2:</a:t>
              </a:r>
              <a:r>
                <a:rPr lang="en-US" sz="1600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Detection of Cyp19-Cre recombination activity (EGFP signal) in different cell types of Cyp19-Cre;ROSA</a:t>
              </a:r>
              <a:r>
                <a:rPr lang="en-US" sz="1600" kern="100" baseline="300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T/</a:t>
              </a:r>
              <a:r>
                <a:rPr lang="en-US" sz="1600" kern="100" baseline="30000" dirty="0" err="1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G</a:t>
              </a:r>
              <a:r>
                <a:rPr lang="en-US" sz="1600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placentas. A,</a:t>
              </a:r>
              <a:r>
                <a:rPr lang="en-US" sz="1600" b="1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US" sz="1600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ells expressing green fluorescence in the labyrinth (LB), junctional zone (JZ), and the upper decidual (DE) layers, indicating Cyp19-Cre recombination activity in these cells. B, identification of Cytokeratin-8 (CK8) expressing trophoblast cells in an adjacent section of section A from the same tissue block. C, high magnification microphotograph of the CK8-immunostained section in B showing CK8-positive invading trophoblast cells (arrowhead) in the upper decidual zone. Note the absence of CK8-positive trophoblast cells in the lower decidual zone in B and the lack of EGFP signals in the corresponding zone in A. SA, spiral artery; MYO, myometrium; Scale bars in A and B 200 µm, and in C 50 µm. A standard DAB </a:t>
              </a:r>
              <a:r>
                <a:rPr lang="en-US" sz="1600" kern="100" dirty="0">
                  <a:solidFill>
                    <a:srgbClr val="1E1E1E"/>
                  </a:solidFill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3,3′-Diaminobenzidine) immuno</a:t>
              </a:r>
              <a:r>
                <a:rPr lang="en-US" sz="1600" kern="100" dirty="0">
                  <a:effectLst/>
                  <a:latin typeface="Palatino Linotype" panose="0204050205050503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taining protocol was used for the detection of CK8-positive cells using a rat monoclonal antibody (TROMA-I, Developmental Studies Hybridoma Bank)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269826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</Template>
  <TotalTime>1459</TotalTime>
  <Words>281</Words>
  <Application>Microsoft Office PowerPoint</Application>
  <PresentationFormat>Widescreen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amthathmakula, Prashanth</dc:creator>
  <cp:lastModifiedBy>Anamthathmakula, Prashanth</cp:lastModifiedBy>
  <cp:revision>1</cp:revision>
  <dcterms:created xsi:type="dcterms:W3CDTF">2022-01-30T16:09:30Z</dcterms:created>
  <dcterms:modified xsi:type="dcterms:W3CDTF">2023-08-17T23:54:45Z</dcterms:modified>
</cp:coreProperties>
</file>